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1" r:id="rId3"/>
    <p:sldId id="259" r:id="rId4"/>
    <p:sldId id="26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51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3EDB6-D609-9387-F32F-2DCD8CCB0B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C6D33A-C684-0E7D-CDA9-9752747D53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6373E8-D1E8-0C21-9A12-BC0AF1F98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F8281-ECF7-D76D-A138-EF13A0236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87E969-8A64-7BFC-82EE-B8DC86761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143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0EB407-F549-D18A-341F-5146A2F91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792A1D-568B-7C3F-FA3E-D5C3AE11CA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49349D-1959-B4AB-2E46-98E1CA05A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8AC1F4-B4B1-D95F-A97D-A891EAB8C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A849F3-5230-BD31-2858-A483AB647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20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8E0A972-D895-5962-71AF-B471303C92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5F547B-BA06-D175-5DB6-AFC07FF045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D9779C-1DA2-5D59-FA38-C0D6793A0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C2789E-DDA5-3087-3A63-2B95BA17C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5A029-5624-06BB-6B1A-1E2A99657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608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A7F70-3934-7849-7B13-DD43F5CA9E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CF6AB6-69E6-C2F0-6943-B9DD563395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CE4A72-19B0-CFCB-7EE4-FB55E456E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C6FCBB-CE5B-AA0D-2B4B-C2FAEA02C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2C6F83-F017-4A03-3266-172A27DCC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285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8896CE-389C-D9E1-4BFD-BDDDA27B91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770973-8C6E-BB32-16A8-B73E0ED728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8E1750-19DD-6405-10B5-EF8D6172A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7EFD6C-E515-7487-198F-C07761422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F6C830-4A6A-258D-D74D-4ED51A223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363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8E1A89-1C12-2738-63E5-0DC375ADE0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AEA87D-8FEF-A472-6928-4E19D83512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A725AE-4D98-0B04-046C-4A3E476A3D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A54C2C-F3BC-22F3-E279-E0D490281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E9C31C-6FC6-2ACC-DD0B-E0A961447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6AF092-F743-BE56-42EB-2DCA6AED7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965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4EB472-3FB0-8016-06B7-CA890003D5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84B10D-2D55-5E4D-503B-657A978225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86F12C-02E8-795E-E11F-C3F6F8A5FF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5D3D13-8D92-1457-B8BB-FAC62AD983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39C068-F336-81B1-F6E0-59897B70A3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195D4B-90C9-7ED3-AECA-98EDAAD89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BC51263-CA73-314B-3150-DB2F46D8F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10258A-B94D-91E1-92E5-6238C96C2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182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3B492D-183E-B98B-A7B1-242BAD41AB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C19B84-A617-0D3C-4DE6-11EBC3F28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7CF9D8D-5BC0-F903-D5D0-F00EBAE0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EA4110C-45FA-0F11-3FA4-96D902B5C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64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CC90AE7-1885-B849-6A5A-0B34C2305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1AB6171-7EA3-6699-2A26-67C541B8D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55A173-8A38-4D1A-2ABD-E4830C651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40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8DD54-F8DB-8C38-16B3-B24897A0A6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7E26EF-41DA-A615-7E8F-AB403B9BE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C3240D-EA2A-DAE2-4C7C-5D06DDC1E8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403B42-DEBB-029E-769F-9E5C02116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D35679-5C4A-ADA3-66F2-AB77412F5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548937-CAF5-6D99-020B-43613786F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617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A2742C-4A29-9C7B-B94F-F06DF37B3B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7DA336-F107-2419-80FB-1510AE692F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C55698-BAA3-2F82-882C-62E09A5656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268EA1-F103-F8A7-7965-96EF07FA6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1E3A04-B6A1-A4B5-C11F-8FCEF467F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57DC84-F63D-2A89-7FBD-36ECF0649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59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DD4E68-EEBE-95D1-553B-7E09E0B4A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07484E-02E3-703B-4988-222F20A5ED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C25B18-21BF-239A-54BB-DBE47CCE51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5E883D-6F98-D69C-BCE5-F84D9DFC50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69968D-497D-7161-C37A-C2D3A2B34B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782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3734422D-F5A5-99A5-5AEC-7691E9F07C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242" y="0"/>
            <a:ext cx="11679515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801786A-5A7F-3F08-0AA5-0B4792486886}"/>
              </a:ext>
            </a:extLst>
          </p:cNvPr>
          <p:cNvSpPr txBox="1"/>
          <p:nvPr/>
        </p:nvSpPr>
        <p:spPr>
          <a:xfrm>
            <a:off x="7599294" y="84868"/>
            <a:ext cx="4289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min extracted ion chromatograms</a:t>
            </a:r>
          </a:p>
          <a:p>
            <a:r>
              <a:rPr lang="en-US" dirty="0"/>
              <a:t>- output from software</a:t>
            </a:r>
          </a:p>
        </p:txBody>
      </p:sp>
    </p:spTree>
    <p:extLst>
      <p:ext uri="{BB962C8B-B14F-4D97-AF65-F5344CB8AC3E}">
        <p14:creationId xmlns:p14="http://schemas.microsoft.com/office/powerpoint/2010/main" val="4301711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6" name="Group 335">
            <a:extLst>
              <a:ext uri="{FF2B5EF4-FFF2-40B4-BE49-F238E27FC236}">
                <a16:creationId xmlns:a16="http://schemas.microsoft.com/office/drawing/2014/main" id="{19756F34-E03C-CDEA-3DCF-CE1E915FE7E7}"/>
              </a:ext>
            </a:extLst>
          </p:cNvPr>
          <p:cNvGrpSpPr/>
          <p:nvPr/>
        </p:nvGrpSpPr>
        <p:grpSpPr>
          <a:xfrm>
            <a:off x="255587" y="0"/>
            <a:ext cx="11680825" cy="6858000"/>
            <a:chOff x="255587" y="0"/>
            <a:chExt cx="11680825" cy="685800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CCC192F-5E6E-01CE-7017-4B39B8E861F9}"/>
                </a:ext>
              </a:extLst>
            </p:cNvPr>
            <p:cNvSpPr txBox="1"/>
            <p:nvPr/>
          </p:nvSpPr>
          <p:spPr>
            <a:xfrm>
              <a:off x="909774" y="190735"/>
              <a:ext cx="36195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emin extracted ion chromatograms</a:t>
              </a:r>
            </a:p>
          </p:txBody>
        </p:sp>
        <p:sp>
          <p:nvSpPr>
            <p:cNvPr id="3" name="AutoShape 3">
              <a:extLst>
                <a:ext uri="{FF2B5EF4-FFF2-40B4-BE49-F238E27FC236}">
                  <a16:creationId xmlns:a16="http://schemas.microsoft.com/office/drawing/2014/main" id="{877E1D2C-5ADF-6A36-5BF0-2D0CFDB2BFC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255587" y="0"/>
              <a:ext cx="11680825" cy="685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" name="Line 5">
              <a:extLst>
                <a:ext uri="{FF2B5EF4-FFF2-40B4-BE49-F238E27FC236}">
                  <a16:creationId xmlns:a16="http://schemas.microsoft.com/office/drawing/2014/main" id="{0D30D355-85FD-52B3-F83A-46CFAAE8A0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2450" y="142875"/>
              <a:ext cx="0" cy="204470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" name="Rectangle 6">
              <a:extLst>
                <a:ext uri="{FF2B5EF4-FFF2-40B4-BE49-F238E27FC236}">
                  <a16:creationId xmlns:a16="http://schemas.microsoft.com/office/drawing/2014/main" id="{C71D135C-333E-C3B6-411D-60D8843CC8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125" y="33338"/>
              <a:ext cx="49213" cy="66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7">
              <a:extLst>
                <a:ext uri="{FF2B5EF4-FFF2-40B4-BE49-F238E27FC236}">
                  <a16:creationId xmlns:a16="http://schemas.microsoft.com/office/drawing/2014/main" id="{7F14B5AC-7A22-33C0-36E9-F1D8338C22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237" y="42863"/>
              <a:ext cx="131763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x1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Line 8">
              <a:extLst>
                <a:ext uri="{FF2B5EF4-FFF2-40B4-BE49-F238E27FC236}">
                  <a16:creationId xmlns:a16="http://schemas.microsoft.com/office/drawing/2014/main" id="{67A4AC3A-3303-E87C-0EF2-021155A57F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218757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" name="Rectangle 9">
              <a:extLst>
                <a:ext uri="{FF2B5EF4-FFF2-40B4-BE49-F238E27FC236}">
                  <a16:creationId xmlns:a16="http://schemas.microsoft.com/office/drawing/2014/main" id="{B27E0278-CF1F-F346-6886-AA7A96A96E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2147888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Line 10">
              <a:extLst>
                <a:ext uri="{FF2B5EF4-FFF2-40B4-BE49-F238E27FC236}">
                  <a16:creationId xmlns:a16="http://schemas.microsoft.com/office/drawing/2014/main" id="{44E00A27-7FBB-951D-C086-83503F1943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208280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" name="Rectangle 11">
              <a:extLst>
                <a:ext uri="{FF2B5EF4-FFF2-40B4-BE49-F238E27FC236}">
                  <a16:creationId xmlns:a16="http://schemas.microsoft.com/office/drawing/2014/main" id="{8DA71C0E-8D75-5531-84CB-A431E5D117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204311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Line 12">
              <a:extLst>
                <a:ext uri="{FF2B5EF4-FFF2-40B4-BE49-F238E27FC236}">
                  <a16:creationId xmlns:a16="http://schemas.microsoft.com/office/drawing/2014/main" id="{034F2C5D-7F43-DE87-F321-75A163296E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98278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4" name="Rectangle 13">
              <a:extLst>
                <a:ext uri="{FF2B5EF4-FFF2-40B4-BE49-F238E27FC236}">
                  <a16:creationId xmlns:a16="http://schemas.microsoft.com/office/drawing/2014/main" id="{0C513363-8F37-5367-536E-CCA45F5BB0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1944688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Line 14">
              <a:extLst>
                <a:ext uri="{FF2B5EF4-FFF2-40B4-BE49-F238E27FC236}">
                  <a16:creationId xmlns:a16="http://schemas.microsoft.com/office/drawing/2014/main" id="{CAAD1993-33F0-14AE-C6E7-A2339EC3BF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87801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6" name="Rectangle 15">
              <a:extLst>
                <a:ext uri="{FF2B5EF4-FFF2-40B4-BE49-F238E27FC236}">
                  <a16:creationId xmlns:a16="http://schemas.microsoft.com/office/drawing/2014/main" id="{E2B8FB17-9655-8C78-7281-D338E71BF8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183991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Line 16">
              <a:extLst>
                <a:ext uri="{FF2B5EF4-FFF2-40B4-BE49-F238E27FC236}">
                  <a16:creationId xmlns:a16="http://schemas.microsoft.com/office/drawing/2014/main" id="{7389F3B2-3100-F39C-7C4E-DE37D669B4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77323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8" name="Rectangle 17">
              <a:extLst>
                <a:ext uri="{FF2B5EF4-FFF2-40B4-BE49-F238E27FC236}">
                  <a16:creationId xmlns:a16="http://schemas.microsoft.com/office/drawing/2014/main" id="{2657B6B9-FAD4-34C5-760E-AB48B8D6B2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1735138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" name="Line 18">
              <a:extLst>
                <a:ext uri="{FF2B5EF4-FFF2-40B4-BE49-F238E27FC236}">
                  <a16:creationId xmlns:a16="http://schemas.microsoft.com/office/drawing/2014/main" id="{A6DD5DB1-D0F8-2A12-DFA8-5A44D436A3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6684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0" name="Rectangle 19">
              <a:extLst>
                <a:ext uri="{FF2B5EF4-FFF2-40B4-BE49-F238E27FC236}">
                  <a16:creationId xmlns:a16="http://schemas.microsoft.com/office/drawing/2014/main" id="{5938653E-0E76-0FBB-166E-A5A4470CF2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16303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Line 20">
              <a:extLst>
                <a:ext uri="{FF2B5EF4-FFF2-40B4-BE49-F238E27FC236}">
                  <a16:creationId xmlns:a16="http://schemas.microsoft.com/office/drawing/2014/main" id="{484BB167-A9CB-BBB2-8D9B-48AE61EFBD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57003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" name="Rectangle 21">
              <a:extLst>
                <a:ext uri="{FF2B5EF4-FFF2-40B4-BE49-F238E27FC236}">
                  <a16:creationId xmlns:a16="http://schemas.microsoft.com/office/drawing/2014/main" id="{4C961FFB-61B1-4086-7EDC-C842003AA1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1530350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" name="Line 22">
              <a:extLst>
                <a:ext uri="{FF2B5EF4-FFF2-40B4-BE49-F238E27FC236}">
                  <a16:creationId xmlns:a16="http://schemas.microsoft.com/office/drawing/2014/main" id="{F57EFA62-5F4B-7D6D-4B10-E75B72C019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4652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" name="Rectangle 23">
              <a:extLst>
                <a:ext uri="{FF2B5EF4-FFF2-40B4-BE49-F238E27FC236}">
                  <a16:creationId xmlns:a16="http://schemas.microsoft.com/office/drawing/2014/main" id="{8DC435C5-B3A8-BB90-005D-5168BFB54C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14255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Line 24">
              <a:extLst>
                <a:ext uri="{FF2B5EF4-FFF2-40B4-BE49-F238E27FC236}">
                  <a16:creationId xmlns:a16="http://schemas.microsoft.com/office/drawing/2014/main" id="{88BECD7D-46FF-0A0C-CA87-0CA6284261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36048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" name="Rectangle 25">
              <a:extLst>
                <a:ext uri="{FF2B5EF4-FFF2-40B4-BE49-F238E27FC236}">
                  <a16:creationId xmlns:a16="http://schemas.microsoft.com/office/drawing/2014/main" id="{EE93D7B0-BC23-53F8-02F1-41ED142BF9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1320800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" name="Line 26">
              <a:extLst>
                <a:ext uri="{FF2B5EF4-FFF2-40B4-BE49-F238E27FC236}">
                  <a16:creationId xmlns:a16="http://schemas.microsoft.com/office/drawing/2014/main" id="{0D993894-01A5-312A-28D4-A685B56436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2620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" name="Rectangle 27">
              <a:extLst>
                <a:ext uri="{FF2B5EF4-FFF2-40B4-BE49-F238E27FC236}">
                  <a16:creationId xmlns:a16="http://schemas.microsoft.com/office/drawing/2014/main" id="{6AAEC503-1D59-E795-DB1C-21255F3E3C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12223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Line 28">
              <a:extLst>
                <a:ext uri="{FF2B5EF4-FFF2-40B4-BE49-F238E27FC236}">
                  <a16:creationId xmlns:a16="http://schemas.microsoft.com/office/drawing/2014/main" id="{62318B65-E3D8-077E-CA9F-BD945F3819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15728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" name="Rectangle 29">
              <a:extLst>
                <a:ext uri="{FF2B5EF4-FFF2-40B4-BE49-F238E27FC236}">
                  <a16:creationId xmlns:a16="http://schemas.microsoft.com/office/drawing/2014/main" id="{D6978B1B-EADD-888E-7DFD-324A7E5838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1117600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" name="Line 30">
              <a:extLst>
                <a:ext uri="{FF2B5EF4-FFF2-40B4-BE49-F238E27FC236}">
                  <a16:creationId xmlns:a16="http://schemas.microsoft.com/office/drawing/2014/main" id="{5861C27C-0873-BBD5-E631-189EC11D54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105251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" name="Rectangle 31">
              <a:extLst>
                <a:ext uri="{FF2B5EF4-FFF2-40B4-BE49-F238E27FC236}">
                  <a16:creationId xmlns:a16="http://schemas.microsoft.com/office/drawing/2014/main" id="{FCC320EC-55F0-419B-3845-D34DF7D080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10128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" name="Line 32">
              <a:extLst>
                <a:ext uri="{FF2B5EF4-FFF2-40B4-BE49-F238E27FC236}">
                  <a16:creationId xmlns:a16="http://schemas.microsoft.com/office/drawing/2014/main" id="{0345835A-6357-5C6A-13AE-DAD9B0A82E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95250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" name="Rectangle 33">
              <a:extLst>
                <a:ext uri="{FF2B5EF4-FFF2-40B4-BE49-F238E27FC236}">
                  <a16:creationId xmlns:a16="http://schemas.microsoft.com/office/drawing/2014/main" id="{95DBC496-DD9E-35FE-87E8-C68F6480B4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914400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" name="Line 34">
              <a:extLst>
                <a:ext uri="{FF2B5EF4-FFF2-40B4-BE49-F238E27FC236}">
                  <a16:creationId xmlns:a16="http://schemas.microsoft.com/office/drawing/2014/main" id="{AAF64805-186E-8A76-BB63-718C84AFFE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84772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" name="Rectangle 35">
              <a:extLst>
                <a:ext uri="{FF2B5EF4-FFF2-40B4-BE49-F238E27FC236}">
                  <a16:creationId xmlns:a16="http://schemas.microsoft.com/office/drawing/2014/main" id="{AFFA9F25-4FB1-1E46-728D-4FCA96C703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8096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" name="Line 36">
              <a:extLst>
                <a:ext uri="{FF2B5EF4-FFF2-40B4-BE49-F238E27FC236}">
                  <a16:creationId xmlns:a16="http://schemas.microsoft.com/office/drawing/2014/main" id="{EA316C94-DD8B-0DFA-EC3A-A1F7CC4D4F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74295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" name="Rectangle 37">
              <a:extLst>
                <a:ext uri="{FF2B5EF4-FFF2-40B4-BE49-F238E27FC236}">
                  <a16:creationId xmlns:a16="http://schemas.microsoft.com/office/drawing/2014/main" id="{D8529CDA-2DF2-2BC0-18B2-8802949088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704850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" name="Line 38">
              <a:extLst>
                <a:ext uri="{FF2B5EF4-FFF2-40B4-BE49-F238E27FC236}">
                  <a16:creationId xmlns:a16="http://schemas.microsoft.com/office/drawing/2014/main" id="{2631F17E-4139-0552-0F4C-837324C252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6397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0" name="Rectangle 39">
              <a:extLst>
                <a:ext uri="{FF2B5EF4-FFF2-40B4-BE49-F238E27FC236}">
                  <a16:creationId xmlns:a16="http://schemas.microsoft.com/office/drawing/2014/main" id="{27BE840D-A39C-03C3-A6FF-262B929B6B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6000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1" name="Line 40">
              <a:extLst>
                <a:ext uri="{FF2B5EF4-FFF2-40B4-BE49-F238E27FC236}">
                  <a16:creationId xmlns:a16="http://schemas.microsoft.com/office/drawing/2014/main" id="{7D85DF18-5003-A75D-5C92-EBC21B68FE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3975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2" name="Rectangle 41">
              <a:extLst>
                <a:ext uri="{FF2B5EF4-FFF2-40B4-BE49-F238E27FC236}">
                  <a16:creationId xmlns:a16="http://schemas.microsoft.com/office/drawing/2014/main" id="{721A2353-17E9-DCAB-23F4-451291511A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5000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" name="Line 42">
              <a:extLst>
                <a:ext uri="{FF2B5EF4-FFF2-40B4-BE49-F238E27FC236}">
                  <a16:creationId xmlns:a16="http://schemas.microsoft.com/office/drawing/2014/main" id="{0F99D133-132C-7091-A273-C455C07BB4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43497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4" name="Rectangle 43">
              <a:extLst>
                <a:ext uri="{FF2B5EF4-FFF2-40B4-BE49-F238E27FC236}">
                  <a16:creationId xmlns:a16="http://schemas.microsoft.com/office/drawing/2014/main" id="{073C065E-95DD-6D00-BFF2-39A0D6A09A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3968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8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" name="Line 44">
              <a:extLst>
                <a:ext uri="{FF2B5EF4-FFF2-40B4-BE49-F238E27FC236}">
                  <a16:creationId xmlns:a16="http://schemas.microsoft.com/office/drawing/2014/main" id="{349CD4CC-48CD-7A4C-ECD0-8EEB4B9ACE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33020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6" name="Rectangle 45">
              <a:extLst>
                <a:ext uri="{FF2B5EF4-FFF2-40B4-BE49-F238E27FC236}">
                  <a16:creationId xmlns:a16="http://schemas.microsoft.com/office/drawing/2014/main" id="{067574BD-F724-1D06-C1EA-E0CBF29C23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292100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" name="Line 46">
              <a:extLst>
                <a:ext uri="{FF2B5EF4-FFF2-40B4-BE49-F238E27FC236}">
                  <a16:creationId xmlns:a16="http://schemas.microsoft.com/office/drawing/2014/main" id="{6FAB67EC-DB92-C134-92E5-DD06AC9F5F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23177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8" name="Rectangle 47">
              <a:extLst>
                <a:ext uri="{FF2B5EF4-FFF2-40B4-BE49-F238E27FC236}">
                  <a16:creationId xmlns:a16="http://schemas.microsoft.com/office/drawing/2014/main" id="{866A007C-B4AA-E61F-01A9-B9B6C08418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192088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9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Rectangle 48">
              <a:extLst>
                <a:ext uri="{FF2B5EF4-FFF2-40B4-BE49-F238E27FC236}">
                  <a16:creationId xmlns:a16="http://schemas.microsoft.com/office/drawing/2014/main" id="{B7FA5970-CB4A-853B-DB1D-5AC0EDB429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800" y="0"/>
              <a:ext cx="11372850" cy="22193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0" name="Rectangle 49">
              <a:extLst>
                <a:ext uri="{FF2B5EF4-FFF2-40B4-BE49-F238E27FC236}">
                  <a16:creationId xmlns:a16="http://schemas.microsoft.com/office/drawing/2014/main" id="{E743F314-99E4-E986-CFCB-D9F45FF22A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912" y="142875"/>
              <a:ext cx="11344275" cy="20447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1" name="Rectangle 50">
              <a:extLst>
                <a:ext uri="{FF2B5EF4-FFF2-40B4-BE49-F238E27FC236}">
                  <a16:creationId xmlns:a16="http://schemas.microsoft.com/office/drawing/2014/main" id="{591760CD-B1AE-00AF-4FEB-1E6D28A18C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025" y="38100"/>
              <a:ext cx="2874963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+ESI EIC(616.176140) Scan Frag=250.0V 20230203_006_Vayu RM_EEKB_1.5625 </a:t>
              </a:r>
              <a:r>
                <a:rPr kumimoji="0" lang="en-US" altLang="en-US" sz="5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uM</a:t>
              </a:r>
              <a:r>
                <a: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 </a:t>
              </a:r>
              <a:r>
                <a:rPr kumimoji="0" lang="en-US" altLang="en-US" sz="5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Hemin.d</a:t>
              </a:r>
              <a:r>
                <a: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 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3" name="Freeform 52">
              <a:extLst>
                <a:ext uri="{FF2B5EF4-FFF2-40B4-BE49-F238E27FC236}">
                  <a16:creationId xmlns:a16="http://schemas.microsoft.com/office/drawing/2014/main" id="{42B49C58-C07E-FD71-BEAC-6C9076215206}"/>
                </a:ext>
              </a:extLst>
            </p:cNvPr>
            <p:cNvSpPr>
              <a:spLocks/>
            </p:cNvSpPr>
            <p:nvPr/>
          </p:nvSpPr>
          <p:spPr bwMode="auto">
            <a:xfrm>
              <a:off x="4483100" y="328613"/>
              <a:ext cx="323850" cy="1852613"/>
            </a:xfrm>
            <a:custGeom>
              <a:avLst/>
              <a:gdLst>
                <a:gd name="T0" fmla="*/ 0 w 204"/>
                <a:gd name="T1" fmla="*/ 1167 h 1167"/>
                <a:gd name="T2" fmla="*/ 17 w 204"/>
                <a:gd name="T3" fmla="*/ 767 h 1167"/>
                <a:gd name="T4" fmla="*/ 34 w 204"/>
                <a:gd name="T5" fmla="*/ 0 h 1167"/>
                <a:gd name="T6" fmla="*/ 51 w 204"/>
                <a:gd name="T7" fmla="*/ 61 h 1167"/>
                <a:gd name="T8" fmla="*/ 68 w 204"/>
                <a:gd name="T9" fmla="*/ 523 h 1167"/>
                <a:gd name="T10" fmla="*/ 85 w 204"/>
                <a:gd name="T11" fmla="*/ 833 h 1167"/>
                <a:gd name="T12" fmla="*/ 102 w 204"/>
                <a:gd name="T13" fmla="*/ 993 h 1167"/>
                <a:gd name="T14" fmla="*/ 119 w 204"/>
                <a:gd name="T15" fmla="*/ 1059 h 1167"/>
                <a:gd name="T16" fmla="*/ 136 w 204"/>
                <a:gd name="T17" fmla="*/ 1092 h 1167"/>
                <a:gd name="T18" fmla="*/ 153 w 204"/>
                <a:gd name="T19" fmla="*/ 1118 h 1167"/>
                <a:gd name="T20" fmla="*/ 170 w 204"/>
                <a:gd name="T21" fmla="*/ 1133 h 1167"/>
                <a:gd name="T22" fmla="*/ 187 w 204"/>
                <a:gd name="T23" fmla="*/ 1144 h 1167"/>
                <a:gd name="T24" fmla="*/ 204 w 204"/>
                <a:gd name="T25" fmla="*/ 1150 h 1167"/>
                <a:gd name="T26" fmla="*/ 204 w 204"/>
                <a:gd name="T27" fmla="*/ 1150 h 1167"/>
                <a:gd name="T28" fmla="*/ 204 w 204"/>
                <a:gd name="T29" fmla="*/ 1150 h 1167"/>
                <a:gd name="T30" fmla="*/ 0 w 204"/>
                <a:gd name="T31" fmla="*/ 1167 h 1167"/>
                <a:gd name="T32" fmla="*/ 0 w 204"/>
                <a:gd name="T33" fmla="*/ 1167 h 1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04" h="1167">
                  <a:moveTo>
                    <a:pt x="0" y="1167"/>
                  </a:moveTo>
                  <a:lnTo>
                    <a:pt x="17" y="767"/>
                  </a:lnTo>
                  <a:lnTo>
                    <a:pt x="34" y="0"/>
                  </a:lnTo>
                  <a:lnTo>
                    <a:pt x="51" y="61"/>
                  </a:lnTo>
                  <a:lnTo>
                    <a:pt x="68" y="523"/>
                  </a:lnTo>
                  <a:lnTo>
                    <a:pt x="85" y="833"/>
                  </a:lnTo>
                  <a:lnTo>
                    <a:pt x="102" y="993"/>
                  </a:lnTo>
                  <a:lnTo>
                    <a:pt x="119" y="1059"/>
                  </a:lnTo>
                  <a:lnTo>
                    <a:pt x="136" y="1092"/>
                  </a:lnTo>
                  <a:lnTo>
                    <a:pt x="153" y="1118"/>
                  </a:lnTo>
                  <a:lnTo>
                    <a:pt x="170" y="1133"/>
                  </a:lnTo>
                  <a:lnTo>
                    <a:pt x="187" y="1144"/>
                  </a:lnTo>
                  <a:lnTo>
                    <a:pt x="204" y="1150"/>
                  </a:lnTo>
                  <a:lnTo>
                    <a:pt x="204" y="1150"/>
                  </a:lnTo>
                  <a:lnTo>
                    <a:pt x="204" y="1150"/>
                  </a:lnTo>
                  <a:lnTo>
                    <a:pt x="0" y="1167"/>
                  </a:lnTo>
                  <a:lnTo>
                    <a:pt x="0" y="1167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5" name="Freeform 54">
              <a:extLst>
                <a:ext uri="{FF2B5EF4-FFF2-40B4-BE49-F238E27FC236}">
                  <a16:creationId xmlns:a16="http://schemas.microsoft.com/office/drawing/2014/main" id="{9981CF82-413F-D5F7-2506-70D1F4879CED}"/>
                </a:ext>
              </a:extLst>
            </p:cNvPr>
            <p:cNvSpPr>
              <a:spLocks/>
            </p:cNvSpPr>
            <p:nvPr/>
          </p:nvSpPr>
          <p:spPr bwMode="auto">
            <a:xfrm>
              <a:off x="4483100" y="2154238"/>
              <a:ext cx="323850" cy="26988"/>
            </a:xfrm>
            <a:custGeom>
              <a:avLst/>
              <a:gdLst>
                <a:gd name="T0" fmla="*/ 0 w 204"/>
                <a:gd name="T1" fmla="*/ 17 h 17"/>
                <a:gd name="T2" fmla="*/ 0 w 204"/>
                <a:gd name="T3" fmla="*/ 17 h 17"/>
                <a:gd name="T4" fmla="*/ 204 w 204"/>
                <a:gd name="T5" fmla="*/ 0 h 17"/>
                <a:gd name="T6" fmla="*/ 204 w 204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4" h="17">
                  <a:moveTo>
                    <a:pt x="0" y="17"/>
                  </a:moveTo>
                  <a:lnTo>
                    <a:pt x="0" y="17"/>
                  </a:lnTo>
                  <a:lnTo>
                    <a:pt x="204" y="0"/>
                  </a:lnTo>
                  <a:lnTo>
                    <a:pt x="204" y="0"/>
                  </a:ln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6" name="Freeform 55">
              <a:extLst>
                <a:ext uri="{FF2B5EF4-FFF2-40B4-BE49-F238E27FC236}">
                  <a16:creationId xmlns:a16="http://schemas.microsoft.com/office/drawing/2014/main" id="{D5BC4D86-104A-8797-386C-A09ADA00178D}"/>
                </a:ext>
              </a:extLst>
            </p:cNvPr>
            <p:cNvSpPr>
              <a:spLocks/>
            </p:cNvSpPr>
            <p:nvPr/>
          </p:nvSpPr>
          <p:spPr bwMode="auto">
            <a:xfrm>
              <a:off x="552450" y="330200"/>
              <a:ext cx="6889750" cy="1857375"/>
            </a:xfrm>
            <a:custGeom>
              <a:avLst/>
              <a:gdLst>
                <a:gd name="T0" fmla="*/ 66 w 4340"/>
                <a:gd name="T1" fmla="*/ 1170 h 1170"/>
                <a:gd name="T2" fmla="*/ 153 w 4340"/>
                <a:gd name="T3" fmla="*/ 1170 h 1170"/>
                <a:gd name="T4" fmla="*/ 236 w 4340"/>
                <a:gd name="T5" fmla="*/ 1170 h 1170"/>
                <a:gd name="T6" fmla="*/ 323 w 4340"/>
                <a:gd name="T7" fmla="*/ 1170 h 1170"/>
                <a:gd name="T8" fmla="*/ 406 w 4340"/>
                <a:gd name="T9" fmla="*/ 1170 h 1170"/>
                <a:gd name="T10" fmla="*/ 493 w 4340"/>
                <a:gd name="T11" fmla="*/ 1170 h 1170"/>
                <a:gd name="T12" fmla="*/ 576 w 4340"/>
                <a:gd name="T13" fmla="*/ 1170 h 1170"/>
                <a:gd name="T14" fmla="*/ 659 w 4340"/>
                <a:gd name="T15" fmla="*/ 1170 h 1170"/>
                <a:gd name="T16" fmla="*/ 746 w 4340"/>
                <a:gd name="T17" fmla="*/ 1170 h 1170"/>
                <a:gd name="T18" fmla="*/ 829 w 4340"/>
                <a:gd name="T19" fmla="*/ 1170 h 1170"/>
                <a:gd name="T20" fmla="*/ 916 w 4340"/>
                <a:gd name="T21" fmla="*/ 1170 h 1170"/>
                <a:gd name="T22" fmla="*/ 999 w 4340"/>
                <a:gd name="T23" fmla="*/ 1170 h 1170"/>
                <a:gd name="T24" fmla="*/ 1086 w 4340"/>
                <a:gd name="T25" fmla="*/ 1170 h 1170"/>
                <a:gd name="T26" fmla="*/ 1169 w 4340"/>
                <a:gd name="T27" fmla="*/ 1170 h 1170"/>
                <a:gd name="T28" fmla="*/ 1256 w 4340"/>
                <a:gd name="T29" fmla="*/ 1170 h 1170"/>
                <a:gd name="T30" fmla="*/ 1339 w 4340"/>
                <a:gd name="T31" fmla="*/ 1170 h 1170"/>
                <a:gd name="T32" fmla="*/ 1423 w 4340"/>
                <a:gd name="T33" fmla="*/ 1170 h 1170"/>
                <a:gd name="T34" fmla="*/ 1509 w 4340"/>
                <a:gd name="T35" fmla="*/ 1170 h 1170"/>
                <a:gd name="T36" fmla="*/ 1593 w 4340"/>
                <a:gd name="T37" fmla="*/ 1170 h 1170"/>
                <a:gd name="T38" fmla="*/ 1679 w 4340"/>
                <a:gd name="T39" fmla="*/ 1170 h 1170"/>
                <a:gd name="T40" fmla="*/ 1763 w 4340"/>
                <a:gd name="T41" fmla="*/ 1170 h 1170"/>
                <a:gd name="T42" fmla="*/ 1849 w 4340"/>
                <a:gd name="T43" fmla="*/ 1170 h 1170"/>
                <a:gd name="T44" fmla="*/ 1933 w 4340"/>
                <a:gd name="T45" fmla="*/ 1170 h 1170"/>
                <a:gd name="T46" fmla="*/ 2019 w 4340"/>
                <a:gd name="T47" fmla="*/ 1170 h 1170"/>
                <a:gd name="T48" fmla="*/ 2103 w 4340"/>
                <a:gd name="T49" fmla="*/ 1170 h 1170"/>
                <a:gd name="T50" fmla="*/ 2186 w 4340"/>
                <a:gd name="T51" fmla="*/ 1170 h 1170"/>
                <a:gd name="T52" fmla="*/ 2273 w 4340"/>
                <a:gd name="T53" fmla="*/ 1170 h 1170"/>
                <a:gd name="T54" fmla="*/ 2356 w 4340"/>
                <a:gd name="T55" fmla="*/ 1170 h 1170"/>
                <a:gd name="T56" fmla="*/ 2443 w 4340"/>
                <a:gd name="T57" fmla="*/ 1170 h 1170"/>
                <a:gd name="T58" fmla="*/ 2526 w 4340"/>
                <a:gd name="T59" fmla="*/ 59 h 1170"/>
                <a:gd name="T60" fmla="*/ 2613 w 4340"/>
                <a:gd name="T61" fmla="*/ 1090 h 1170"/>
                <a:gd name="T62" fmla="*/ 2696 w 4340"/>
                <a:gd name="T63" fmla="*/ 1152 h 1170"/>
                <a:gd name="T64" fmla="*/ 2783 w 4340"/>
                <a:gd name="T65" fmla="*/ 1163 h 1170"/>
                <a:gd name="T66" fmla="*/ 2866 w 4340"/>
                <a:gd name="T67" fmla="*/ 1166 h 1170"/>
                <a:gd name="T68" fmla="*/ 2953 w 4340"/>
                <a:gd name="T69" fmla="*/ 1166 h 1170"/>
                <a:gd name="T70" fmla="*/ 3036 w 4340"/>
                <a:gd name="T71" fmla="*/ 1166 h 1170"/>
                <a:gd name="T72" fmla="*/ 3119 w 4340"/>
                <a:gd name="T73" fmla="*/ 1166 h 1170"/>
                <a:gd name="T74" fmla="*/ 3206 w 4340"/>
                <a:gd name="T75" fmla="*/ 1166 h 1170"/>
                <a:gd name="T76" fmla="*/ 3289 w 4340"/>
                <a:gd name="T77" fmla="*/ 1166 h 1170"/>
                <a:gd name="T78" fmla="*/ 3376 w 4340"/>
                <a:gd name="T79" fmla="*/ 1170 h 1170"/>
                <a:gd name="T80" fmla="*/ 3459 w 4340"/>
                <a:gd name="T81" fmla="*/ 1170 h 1170"/>
                <a:gd name="T82" fmla="*/ 3546 w 4340"/>
                <a:gd name="T83" fmla="*/ 1170 h 1170"/>
                <a:gd name="T84" fmla="*/ 3629 w 4340"/>
                <a:gd name="T85" fmla="*/ 1170 h 1170"/>
                <a:gd name="T86" fmla="*/ 3716 w 4340"/>
                <a:gd name="T87" fmla="*/ 1170 h 1170"/>
                <a:gd name="T88" fmla="*/ 3799 w 4340"/>
                <a:gd name="T89" fmla="*/ 1170 h 1170"/>
                <a:gd name="T90" fmla="*/ 3882 w 4340"/>
                <a:gd name="T91" fmla="*/ 1170 h 1170"/>
                <a:gd name="T92" fmla="*/ 3969 w 4340"/>
                <a:gd name="T93" fmla="*/ 1170 h 1170"/>
                <a:gd name="T94" fmla="*/ 4052 w 4340"/>
                <a:gd name="T95" fmla="*/ 1170 h 1170"/>
                <a:gd name="T96" fmla="*/ 4139 w 4340"/>
                <a:gd name="T97" fmla="*/ 1170 h 1170"/>
                <a:gd name="T98" fmla="*/ 4222 w 4340"/>
                <a:gd name="T99" fmla="*/ 1170 h 1170"/>
                <a:gd name="T100" fmla="*/ 4309 w 4340"/>
                <a:gd name="T101" fmla="*/ 1170 h 1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4340" h="1170">
                  <a:moveTo>
                    <a:pt x="0" y="1170"/>
                  </a:moveTo>
                  <a:lnTo>
                    <a:pt x="18" y="1170"/>
                  </a:lnTo>
                  <a:lnTo>
                    <a:pt x="35" y="1170"/>
                  </a:lnTo>
                  <a:lnTo>
                    <a:pt x="49" y="1170"/>
                  </a:lnTo>
                  <a:lnTo>
                    <a:pt x="66" y="1170"/>
                  </a:lnTo>
                  <a:lnTo>
                    <a:pt x="84" y="1170"/>
                  </a:lnTo>
                  <a:lnTo>
                    <a:pt x="101" y="1170"/>
                  </a:lnTo>
                  <a:lnTo>
                    <a:pt x="118" y="1170"/>
                  </a:lnTo>
                  <a:lnTo>
                    <a:pt x="136" y="1170"/>
                  </a:lnTo>
                  <a:lnTo>
                    <a:pt x="153" y="1170"/>
                  </a:lnTo>
                  <a:lnTo>
                    <a:pt x="170" y="1170"/>
                  </a:lnTo>
                  <a:lnTo>
                    <a:pt x="188" y="1170"/>
                  </a:lnTo>
                  <a:lnTo>
                    <a:pt x="202" y="1170"/>
                  </a:lnTo>
                  <a:lnTo>
                    <a:pt x="219" y="1170"/>
                  </a:lnTo>
                  <a:lnTo>
                    <a:pt x="236" y="1170"/>
                  </a:lnTo>
                  <a:lnTo>
                    <a:pt x="254" y="1170"/>
                  </a:lnTo>
                  <a:lnTo>
                    <a:pt x="271" y="1170"/>
                  </a:lnTo>
                  <a:lnTo>
                    <a:pt x="288" y="1170"/>
                  </a:lnTo>
                  <a:lnTo>
                    <a:pt x="306" y="1170"/>
                  </a:lnTo>
                  <a:lnTo>
                    <a:pt x="323" y="1170"/>
                  </a:lnTo>
                  <a:lnTo>
                    <a:pt x="340" y="1170"/>
                  </a:lnTo>
                  <a:lnTo>
                    <a:pt x="354" y="1170"/>
                  </a:lnTo>
                  <a:lnTo>
                    <a:pt x="372" y="1170"/>
                  </a:lnTo>
                  <a:lnTo>
                    <a:pt x="389" y="1170"/>
                  </a:lnTo>
                  <a:lnTo>
                    <a:pt x="406" y="1170"/>
                  </a:lnTo>
                  <a:lnTo>
                    <a:pt x="424" y="1170"/>
                  </a:lnTo>
                  <a:lnTo>
                    <a:pt x="441" y="1170"/>
                  </a:lnTo>
                  <a:lnTo>
                    <a:pt x="458" y="1170"/>
                  </a:lnTo>
                  <a:lnTo>
                    <a:pt x="476" y="1170"/>
                  </a:lnTo>
                  <a:lnTo>
                    <a:pt x="493" y="1170"/>
                  </a:lnTo>
                  <a:lnTo>
                    <a:pt x="507" y="1170"/>
                  </a:lnTo>
                  <a:lnTo>
                    <a:pt x="524" y="1170"/>
                  </a:lnTo>
                  <a:lnTo>
                    <a:pt x="542" y="1170"/>
                  </a:lnTo>
                  <a:lnTo>
                    <a:pt x="559" y="1170"/>
                  </a:lnTo>
                  <a:lnTo>
                    <a:pt x="576" y="1170"/>
                  </a:lnTo>
                  <a:lnTo>
                    <a:pt x="594" y="1170"/>
                  </a:lnTo>
                  <a:lnTo>
                    <a:pt x="611" y="1170"/>
                  </a:lnTo>
                  <a:lnTo>
                    <a:pt x="628" y="1170"/>
                  </a:lnTo>
                  <a:lnTo>
                    <a:pt x="646" y="1170"/>
                  </a:lnTo>
                  <a:lnTo>
                    <a:pt x="659" y="1170"/>
                  </a:lnTo>
                  <a:lnTo>
                    <a:pt x="677" y="1170"/>
                  </a:lnTo>
                  <a:lnTo>
                    <a:pt x="694" y="1170"/>
                  </a:lnTo>
                  <a:lnTo>
                    <a:pt x="712" y="1170"/>
                  </a:lnTo>
                  <a:lnTo>
                    <a:pt x="729" y="1170"/>
                  </a:lnTo>
                  <a:lnTo>
                    <a:pt x="746" y="1170"/>
                  </a:lnTo>
                  <a:lnTo>
                    <a:pt x="764" y="1170"/>
                  </a:lnTo>
                  <a:lnTo>
                    <a:pt x="781" y="1170"/>
                  </a:lnTo>
                  <a:lnTo>
                    <a:pt x="798" y="1170"/>
                  </a:lnTo>
                  <a:lnTo>
                    <a:pt x="812" y="1170"/>
                  </a:lnTo>
                  <a:lnTo>
                    <a:pt x="829" y="1170"/>
                  </a:lnTo>
                  <a:lnTo>
                    <a:pt x="847" y="1170"/>
                  </a:lnTo>
                  <a:lnTo>
                    <a:pt x="864" y="1170"/>
                  </a:lnTo>
                  <a:lnTo>
                    <a:pt x="881" y="1170"/>
                  </a:lnTo>
                  <a:lnTo>
                    <a:pt x="899" y="1170"/>
                  </a:lnTo>
                  <a:lnTo>
                    <a:pt x="916" y="1170"/>
                  </a:lnTo>
                  <a:lnTo>
                    <a:pt x="934" y="1170"/>
                  </a:lnTo>
                  <a:lnTo>
                    <a:pt x="951" y="1170"/>
                  </a:lnTo>
                  <a:lnTo>
                    <a:pt x="965" y="1170"/>
                  </a:lnTo>
                  <a:lnTo>
                    <a:pt x="982" y="1170"/>
                  </a:lnTo>
                  <a:lnTo>
                    <a:pt x="999" y="1170"/>
                  </a:lnTo>
                  <a:lnTo>
                    <a:pt x="1017" y="1170"/>
                  </a:lnTo>
                  <a:lnTo>
                    <a:pt x="1034" y="1170"/>
                  </a:lnTo>
                  <a:lnTo>
                    <a:pt x="1051" y="1170"/>
                  </a:lnTo>
                  <a:lnTo>
                    <a:pt x="1069" y="1170"/>
                  </a:lnTo>
                  <a:lnTo>
                    <a:pt x="1086" y="1170"/>
                  </a:lnTo>
                  <a:lnTo>
                    <a:pt x="1104" y="1170"/>
                  </a:lnTo>
                  <a:lnTo>
                    <a:pt x="1117" y="1170"/>
                  </a:lnTo>
                  <a:lnTo>
                    <a:pt x="1135" y="1170"/>
                  </a:lnTo>
                  <a:lnTo>
                    <a:pt x="1152" y="1170"/>
                  </a:lnTo>
                  <a:lnTo>
                    <a:pt x="1169" y="1170"/>
                  </a:lnTo>
                  <a:lnTo>
                    <a:pt x="1187" y="1170"/>
                  </a:lnTo>
                  <a:lnTo>
                    <a:pt x="1204" y="1170"/>
                  </a:lnTo>
                  <a:lnTo>
                    <a:pt x="1221" y="1170"/>
                  </a:lnTo>
                  <a:lnTo>
                    <a:pt x="1239" y="1170"/>
                  </a:lnTo>
                  <a:lnTo>
                    <a:pt x="1256" y="1170"/>
                  </a:lnTo>
                  <a:lnTo>
                    <a:pt x="1270" y="1170"/>
                  </a:lnTo>
                  <a:lnTo>
                    <a:pt x="1287" y="1170"/>
                  </a:lnTo>
                  <a:lnTo>
                    <a:pt x="1305" y="1170"/>
                  </a:lnTo>
                  <a:lnTo>
                    <a:pt x="1322" y="1170"/>
                  </a:lnTo>
                  <a:lnTo>
                    <a:pt x="1339" y="1170"/>
                  </a:lnTo>
                  <a:lnTo>
                    <a:pt x="1357" y="1170"/>
                  </a:lnTo>
                  <a:lnTo>
                    <a:pt x="1374" y="1170"/>
                  </a:lnTo>
                  <a:lnTo>
                    <a:pt x="1391" y="1170"/>
                  </a:lnTo>
                  <a:lnTo>
                    <a:pt x="1409" y="1170"/>
                  </a:lnTo>
                  <a:lnTo>
                    <a:pt x="1423" y="1170"/>
                  </a:lnTo>
                  <a:lnTo>
                    <a:pt x="1440" y="1170"/>
                  </a:lnTo>
                  <a:lnTo>
                    <a:pt x="1457" y="1170"/>
                  </a:lnTo>
                  <a:lnTo>
                    <a:pt x="1475" y="1170"/>
                  </a:lnTo>
                  <a:lnTo>
                    <a:pt x="1492" y="1170"/>
                  </a:lnTo>
                  <a:lnTo>
                    <a:pt x="1509" y="1170"/>
                  </a:lnTo>
                  <a:lnTo>
                    <a:pt x="1527" y="1170"/>
                  </a:lnTo>
                  <a:lnTo>
                    <a:pt x="1544" y="1170"/>
                  </a:lnTo>
                  <a:lnTo>
                    <a:pt x="1561" y="1170"/>
                  </a:lnTo>
                  <a:lnTo>
                    <a:pt x="1575" y="1170"/>
                  </a:lnTo>
                  <a:lnTo>
                    <a:pt x="1593" y="1170"/>
                  </a:lnTo>
                  <a:lnTo>
                    <a:pt x="1610" y="1170"/>
                  </a:lnTo>
                  <a:lnTo>
                    <a:pt x="1627" y="1170"/>
                  </a:lnTo>
                  <a:lnTo>
                    <a:pt x="1645" y="1170"/>
                  </a:lnTo>
                  <a:lnTo>
                    <a:pt x="1662" y="1170"/>
                  </a:lnTo>
                  <a:lnTo>
                    <a:pt x="1679" y="1170"/>
                  </a:lnTo>
                  <a:lnTo>
                    <a:pt x="1697" y="1170"/>
                  </a:lnTo>
                  <a:lnTo>
                    <a:pt x="1714" y="1170"/>
                  </a:lnTo>
                  <a:lnTo>
                    <a:pt x="1728" y="1170"/>
                  </a:lnTo>
                  <a:lnTo>
                    <a:pt x="1745" y="1170"/>
                  </a:lnTo>
                  <a:lnTo>
                    <a:pt x="1763" y="1170"/>
                  </a:lnTo>
                  <a:lnTo>
                    <a:pt x="1780" y="1170"/>
                  </a:lnTo>
                  <a:lnTo>
                    <a:pt x="1797" y="1170"/>
                  </a:lnTo>
                  <a:lnTo>
                    <a:pt x="1815" y="1170"/>
                  </a:lnTo>
                  <a:lnTo>
                    <a:pt x="1832" y="1170"/>
                  </a:lnTo>
                  <a:lnTo>
                    <a:pt x="1849" y="1170"/>
                  </a:lnTo>
                  <a:lnTo>
                    <a:pt x="1867" y="1170"/>
                  </a:lnTo>
                  <a:lnTo>
                    <a:pt x="1881" y="1170"/>
                  </a:lnTo>
                  <a:lnTo>
                    <a:pt x="1898" y="1170"/>
                  </a:lnTo>
                  <a:lnTo>
                    <a:pt x="1915" y="1170"/>
                  </a:lnTo>
                  <a:lnTo>
                    <a:pt x="1933" y="1170"/>
                  </a:lnTo>
                  <a:lnTo>
                    <a:pt x="1950" y="1170"/>
                  </a:lnTo>
                  <a:lnTo>
                    <a:pt x="1967" y="1170"/>
                  </a:lnTo>
                  <a:lnTo>
                    <a:pt x="1985" y="1170"/>
                  </a:lnTo>
                  <a:lnTo>
                    <a:pt x="2002" y="1170"/>
                  </a:lnTo>
                  <a:lnTo>
                    <a:pt x="2019" y="1170"/>
                  </a:lnTo>
                  <a:lnTo>
                    <a:pt x="2033" y="1170"/>
                  </a:lnTo>
                  <a:lnTo>
                    <a:pt x="2051" y="1170"/>
                  </a:lnTo>
                  <a:lnTo>
                    <a:pt x="2068" y="1170"/>
                  </a:lnTo>
                  <a:lnTo>
                    <a:pt x="2085" y="1170"/>
                  </a:lnTo>
                  <a:lnTo>
                    <a:pt x="2103" y="1170"/>
                  </a:lnTo>
                  <a:lnTo>
                    <a:pt x="2120" y="1170"/>
                  </a:lnTo>
                  <a:lnTo>
                    <a:pt x="2137" y="1170"/>
                  </a:lnTo>
                  <a:lnTo>
                    <a:pt x="2155" y="1170"/>
                  </a:lnTo>
                  <a:lnTo>
                    <a:pt x="2172" y="1170"/>
                  </a:lnTo>
                  <a:lnTo>
                    <a:pt x="2186" y="1170"/>
                  </a:lnTo>
                  <a:lnTo>
                    <a:pt x="2203" y="1170"/>
                  </a:lnTo>
                  <a:lnTo>
                    <a:pt x="2221" y="1170"/>
                  </a:lnTo>
                  <a:lnTo>
                    <a:pt x="2238" y="1170"/>
                  </a:lnTo>
                  <a:lnTo>
                    <a:pt x="2255" y="1170"/>
                  </a:lnTo>
                  <a:lnTo>
                    <a:pt x="2273" y="1170"/>
                  </a:lnTo>
                  <a:lnTo>
                    <a:pt x="2290" y="1170"/>
                  </a:lnTo>
                  <a:lnTo>
                    <a:pt x="2307" y="1170"/>
                  </a:lnTo>
                  <a:lnTo>
                    <a:pt x="2325" y="1170"/>
                  </a:lnTo>
                  <a:lnTo>
                    <a:pt x="2339" y="1170"/>
                  </a:lnTo>
                  <a:lnTo>
                    <a:pt x="2356" y="1170"/>
                  </a:lnTo>
                  <a:lnTo>
                    <a:pt x="2373" y="1170"/>
                  </a:lnTo>
                  <a:lnTo>
                    <a:pt x="2391" y="1170"/>
                  </a:lnTo>
                  <a:lnTo>
                    <a:pt x="2408" y="1170"/>
                  </a:lnTo>
                  <a:lnTo>
                    <a:pt x="2425" y="1170"/>
                  </a:lnTo>
                  <a:lnTo>
                    <a:pt x="2443" y="1170"/>
                  </a:lnTo>
                  <a:lnTo>
                    <a:pt x="2460" y="1170"/>
                  </a:lnTo>
                  <a:lnTo>
                    <a:pt x="2477" y="1166"/>
                  </a:lnTo>
                  <a:lnTo>
                    <a:pt x="2491" y="767"/>
                  </a:lnTo>
                  <a:lnTo>
                    <a:pt x="2509" y="0"/>
                  </a:lnTo>
                  <a:lnTo>
                    <a:pt x="2526" y="59"/>
                  </a:lnTo>
                  <a:lnTo>
                    <a:pt x="2543" y="521"/>
                  </a:lnTo>
                  <a:lnTo>
                    <a:pt x="2561" y="833"/>
                  </a:lnTo>
                  <a:lnTo>
                    <a:pt x="2578" y="993"/>
                  </a:lnTo>
                  <a:lnTo>
                    <a:pt x="2595" y="1059"/>
                  </a:lnTo>
                  <a:lnTo>
                    <a:pt x="2613" y="1090"/>
                  </a:lnTo>
                  <a:lnTo>
                    <a:pt x="2630" y="1117"/>
                  </a:lnTo>
                  <a:lnTo>
                    <a:pt x="2644" y="1131"/>
                  </a:lnTo>
                  <a:lnTo>
                    <a:pt x="2661" y="1142"/>
                  </a:lnTo>
                  <a:lnTo>
                    <a:pt x="2679" y="1149"/>
                  </a:lnTo>
                  <a:lnTo>
                    <a:pt x="2696" y="1152"/>
                  </a:lnTo>
                  <a:lnTo>
                    <a:pt x="2713" y="1156"/>
                  </a:lnTo>
                  <a:lnTo>
                    <a:pt x="2731" y="1159"/>
                  </a:lnTo>
                  <a:lnTo>
                    <a:pt x="2748" y="1159"/>
                  </a:lnTo>
                  <a:lnTo>
                    <a:pt x="2765" y="1159"/>
                  </a:lnTo>
                  <a:lnTo>
                    <a:pt x="2783" y="1163"/>
                  </a:lnTo>
                  <a:lnTo>
                    <a:pt x="2796" y="1163"/>
                  </a:lnTo>
                  <a:lnTo>
                    <a:pt x="2814" y="1163"/>
                  </a:lnTo>
                  <a:lnTo>
                    <a:pt x="2831" y="1163"/>
                  </a:lnTo>
                  <a:lnTo>
                    <a:pt x="2849" y="1163"/>
                  </a:lnTo>
                  <a:lnTo>
                    <a:pt x="2866" y="1166"/>
                  </a:lnTo>
                  <a:lnTo>
                    <a:pt x="2883" y="1163"/>
                  </a:lnTo>
                  <a:lnTo>
                    <a:pt x="2901" y="1166"/>
                  </a:lnTo>
                  <a:lnTo>
                    <a:pt x="2918" y="1166"/>
                  </a:lnTo>
                  <a:lnTo>
                    <a:pt x="2935" y="1166"/>
                  </a:lnTo>
                  <a:lnTo>
                    <a:pt x="2953" y="1166"/>
                  </a:lnTo>
                  <a:lnTo>
                    <a:pt x="2966" y="1166"/>
                  </a:lnTo>
                  <a:lnTo>
                    <a:pt x="2984" y="1166"/>
                  </a:lnTo>
                  <a:lnTo>
                    <a:pt x="3001" y="1166"/>
                  </a:lnTo>
                  <a:lnTo>
                    <a:pt x="3018" y="1166"/>
                  </a:lnTo>
                  <a:lnTo>
                    <a:pt x="3036" y="1166"/>
                  </a:lnTo>
                  <a:lnTo>
                    <a:pt x="3053" y="1166"/>
                  </a:lnTo>
                  <a:lnTo>
                    <a:pt x="3071" y="1166"/>
                  </a:lnTo>
                  <a:lnTo>
                    <a:pt x="3088" y="1166"/>
                  </a:lnTo>
                  <a:lnTo>
                    <a:pt x="3105" y="1166"/>
                  </a:lnTo>
                  <a:lnTo>
                    <a:pt x="3119" y="1166"/>
                  </a:lnTo>
                  <a:lnTo>
                    <a:pt x="3136" y="1166"/>
                  </a:lnTo>
                  <a:lnTo>
                    <a:pt x="3154" y="1166"/>
                  </a:lnTo>
                  <a:lnTo>
                    <a:pt x="3171" y="1166"/>
                  </a:lnTo>
                  <a:lnTo>
                    <a:pt x="3188" y="1166"/>
                  </a:lnTo>
                  <a:lnTo>
                    <a:pt x="3206" y="1166"/>
                  </a:lnTo>
                  <a:lnTo>
                    <a:pt x="3223" y="1170"/>
                  </a:lnTo>
                  <a:lnTo>
                    <a:pt x="3241" y="1166"/>
                  </a:lnTo>
                  <a:lnTo>
                    <a:pt x="3258" y="1170"/>
                  </a:lnTo>
                  <a:lnTo>
                    <a:pt x="3272" y="1170"/>
                  </a:lnTo>
                  <a:lnTo>
                    <a:pt x="3289" y="1166"/>
                  </a:lnTo>
                  <a:lnTo>
                    <a:pt x="3306" y="1170"/>
                  </a:lnTo>
                  <a:lnTo>
                    <a:pt x="3324" y="1170"/>
                  </a:lnTo>
                  <a:lnTo>
                    <a:pt x="3341" y="1170"/>
                  </a:lnTo>
                  <a:lnTo>
                    <a:pt x="3358" y="1170"/>
                  </a:lnTo>
                  <a:lnTo>
                    <a:pt x="3376" y="1170"/>
                  </a:lnTo>
                  <a:lnTo>
                    <a:pt x="3393" y="1170"/>
                  </a:lnTo>
                  <a:lnTo>
                    <a:pt x="3411" y="1170"/>
                  </a:lnTo>
                  <a:lnTo>
                    <a:pt x="3424" y="1170"/>
                  </a:lnTo>
                  <a:lnTo>
                    <a:pt x="3442" y="1170"/>
                  </a:lnTo>
                  <a:lnTo>
                    <a:pt x="3459" y="1170"/>
                  </a:lnTo>
                  <a:lnTo>
                    <a:pt x="3476" y="1170"/>
                  </a:lnTo>
                  <a:lnTo>
                    <a:pt x="3494" y="1170"/>
                  </a:lnTo>
                  <a:lnTo>
                    <a:pt x="3511" y="1170"/>
                  </a:lnTo>
                  <a:lnTo>
                    <a:pt x="3528" y="1170"/>
                  </a:lnTo>
                  <a:lnTo>
                    <a:pt x="3546" y="1170"/>
                  </a:lnTo>
                  <a:lnTo>
                    <a:pt x="3563" y="1170"/>
                  </a:lnTo>
                  <a:lnTo>
                    <a:pt x="3577" y="1170"/>
                  </a:lnTo>
                  <a:lnTo>
                    <a:pt x="3594" y="1170"/>
                  </a:lnTo>
                  <a:lnTo>
                    <a:pt x="3612" y="1170"/>
                  </a:lnTo>
                  <a:lnTo>
                    <a:pt x="3629" y="1170"/>
                  </a:lnTo>
                  <a:lnTo>
                    <a:pt x="3646" y="1170"/>
                  </a:lnTo>
                  <a:lnTo>
                    <a:pt x="3664" y="1170"/>
                  </a:lnTo>
                  <a:lnTo>
                    <a:pt x="3681" y="1170"/>
                  </a:lnTo>
                  <a:lnTo>
                    <a:pt x="3698" y="1170"/>
                  </a:lnTo>
                  <a:lnTo>
                    <a:pt x="3716" y="1170"/>
                  </a:lnTo>
                  <a:lnTo>
                    <a:pt x="3730" y="1170"/>
                  </a:lnTo>
                  <a:lnTo>
                    <a:pt x="3747" y="1170"/>
                  </a:lnTo>
                  <a:lnTo>
                    <a:pt x="3764" y="1170"/>
                  </a:lnTo>
                  <a:lnTo>
                    <a:pt x="3782" y="1170"/>
                  </a:lnTo>
                  <a:lnTo>
                    <a:pt x="3799" y="1170"/>
                  </a:lnTo>
                  <a:lnTo>
                    <a:pt x="3816" y="1170"/>
                  </a:lnTo>
                  <a:lnTo>
                    <a:pt x="3834" y="1170"/>
                  </a:lnTo>
                  <a:lnTo>
                    <a:pt x="3851" y="1170"/>
                  </a:lnTo>
                  <a:lnTo>
                    <a:pt x="3868" y="1170"/>
                  </a:lnTo>
                  <a:lnTo>
                    <a:pt x="3882" y="1170"/>
                  </a:lnTo>
                  <a:lnTo>
                    <a:pt x="3900" y="1170"/>
                  </a:lnTo>
                  <a:lnTo>
                    <a:pt x="3917" y="1170"/>
                  </a:lnTo>
                  <a:lnTo>
                    <a:pt x="3934" y="1170"/>
                  </a:lnTo>
                  <a:lnTo>
                    <a:pt x="3952" y="1170"/>
                  </a:lnTo>
                  <a:lnTo>
                    <a:pt x="3969" y="1170"/>
                  </a:lnTo>
                  <a:lnTo>
                    <a:pt x="3986" y="1170"/>
                  </a:lnTo>
                  <a:lnTo>
                    <a:pt x="4004" y="1170"/>
                  </a:lnTo>
                  <a:lnTo>
                    <a:pt x="4021" y="1170"/>
                  </a:lnTo>
                  <a:lnTo>
                    <a:pt x="4035" y="1170"/>
                  </a:lnTo>
                  <a:lnTo>
                    <a:pt x="4052" y="1170"/>
                  </a:lnTo>
                  <a:lnTo>
                    <a:pt x="4070" y="1170"/>
                  </a:lnTo>
                  <a:lnTo>
                    <a:pt x="4087" y="1170"/>
                  </a:lnTo>
                  <a:lnTo>
                    <a:pt x="4104" y="1170"/>
                  </a:lnTo>
                  <a:lnTo>
                    <a:pt x="4122" y="1170"/>
                  </a:lnTo>
                  <a:lnTo>
                    <a:pt x="4139" y="1170"/>
                  </a:lnTo>
                  <a:lnTo>
                    <a:pt x="4156" y="1170"/>
                  </a:lnTo>
                  <a:lnTo>
                    <a:pt x="4174" y="1170"/>
                  </a:lnTo>
                  <a:lnTo>
                    <a:pt x="4188" y="1170"/>
                  </a:lnTo>
                  <a:lnTo>
                    <a:pt x="4205" y="1170"/>
                  </a:lnTo>
                  <a:lnTo>
                    <a:pt x="4222" y="1170"/>
                  </a:lnTo>
                  <a:lnTo>
                    <a:pt x="4240" y="1170"/>
                  </a:lnTo>
                  <a:lnTo>
                    <a:pt x="4257" y="1170"/>
                  </a:lnTo>
                  <a:lnTo>
                    <a:pt x="4274" y="1170"/>
                  </a:lnTo>
                  <a:lnTo>
                    <a:pt x="4292" y="1170"/>
                  </a:lnTo>
                  <a:lnTo>
                    <a:pt x="4309" y="1170"/>
                  </a:lnTo>
                  <a:lnTo>
                    <a:pt x="4326" y="1170"/>
                  </a:lnTo>
                  <a:lnTo>
                    <a:pt x="4340" y="117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7" name="Rectangle 56">
              <a:extLst>
                <a:ext uri="{FF2B5EF4-FFF2-40B4-BE49-F238E27FC236}">
                  <a16:creationId xmlns:a16="http://schemas.microsoft.com/office/drawing/2014/main" id="{A2588F00-1FB4-3354-8951-A1CB77EC08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9470" y="155403"/>
              <a:ext cx="69089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 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.914 min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189" name="Rectangle 58">
              <a:extLst>
                <a:ext uri="{FF2B5EF4-FFF2-40B4-BE49-F238E27FC236}">
                  <a16:creationId xmlns:a16="http://schemas.microsoft.com/office/drawing/2014/main" id="{ACA91A4A-B18E-E3C9-E4FB-3C07F8C237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562" y="142875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808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Line 61">
              <a:extLst>
                <a:ext uri="{FF2B5EF4-FFF2-40B4-BE49-F238E27FC236}">
                  <a16:creationId xmlns:a16="http://schemas.microsoft.com/office/drawing/2014/main" id="{9E1E59A6-34B9-2D66-ABE4-F6FC65BDAD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2450" y="2368550"/>
              <a:ext cx="0" cy="2043113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3" name="Rectangle 62">
              <a:extLst>
                <a:ext uri="{FF2B5EF4-FFF2-40B4-BE49-F238E27FC236}">
                  <a16:creationId xmlns:a16="http://schemas.microsoft.com/office/drawing/2014/main" id="{7E6F48B9-7FA0-1CFD-17AC-A293E55EAA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125" y="2257425"/>
              <a:ext cx="49213" cy="66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4" name="Rectangle 63">
              <a:extLst>
                <a:ext uri="{FF2B5EF4-FFF2-40B4-BE49-F238E27FC236}">
                  <a16:creationId xmlns:a16="http://schemas.microsoft.com/office/drawing/2014/main" id="{E22585CF-AA20-CD1A-FF4E-7F116357E1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237" y="2268538"/>
              <a:ext cx="131763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x1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5" name="Line 64">
              <a:extLst>
                <a:ext uri="{FF2B5EF4-FFF2-40B4-BE49-F238E27FC236}">
                  <a16:creationId xmlns:a16="http://schemas.microsoft.com/office/drawing/2014/main" id="{E259DDCF-86FD-AB12-5698-720A522732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44116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6" name="Rectangle 65">
              <a:extLst>
                <a:ext uri="{FF2B5EF4-FFF2-40B4-BE49-F238E27FC236}">
                  <a16:creationId xmlns:a16="http://schemas.microsoft.com/office/drawing/2014/main" id="{A88F3422-BE28-00FD-2E64-7590D95259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43735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7" name="Line 66">
              <a:extLst>
                <a:ext uri="{FF2B5EF4-FFF2-40B4-BE49-F238E27FC236}">
                  <a16:creationId xmlns:a16="http://schemas.microsoft.com/office/drawing/2014/main" id="{838946A0-22EE-1797-AABD-11C8F8BA7B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429101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8" name="Rectangle 67">
              <a:extLst>
                <a:ext uri="{FF2B5EF4-FFF2-40B4-BE49-F238E27FC236}">
                  <a16:creationId xmlns:a16="http://schemas.microsoft.com/office/drawing/2014/main" id="{FED014D7-9728-9C2C-ECA8-A472D6068F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42513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9" name="Line 68">
              <a:extLst>
                <a:ext uri="{FF2B5EF4-FFF2-40B4-BE49-F238E27FC236}">
                  <a16:creationId xmlns:a16="http://schemas.microsoft.com/office/drawing/2014/main" id="{5800DFD5-9880-DBD7-DF9A-DCFE0E0402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416401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0" name="Rectangle 69">
              <a:extLst>
                <a:ext uri="{FF2B5EF4-FFF2-40B4-BE49-F238E27FC236}">
                  <a16:creationId xmlns:a16="http://schemas.microsoft.com/office/drawing/2014/main" id="{214FB418-FDC7-4E36-441D-0460814227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412591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1" name="Line 70">
              <a:extLst>
                <a:ext uri="{FF2B5EF4-FFF2-40B4-BE49-F238E27FC236}">
                  <a16:creationId xmlns:a16="http://schemas.microsoft.com/office/drawing/2014/main" id="{EEB4A72A-D4AB-9E2F-AF4B-E12533D5E7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40433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2" name="Rectangle 71">
              <a:extLst>
                <a:ext uri="{FF2B5EF4-FFF2-40B4-BE49-F238E27FC236}">
                  <a16:creationId xmlns:a16="http://schemas.microsoft.com/office/drawing/2014/main" id="{BE5E1D08-76E9-547E-82D9-16E45D7F62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40036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3" name="Line 72">
              <a:extLst>
                <a:ext uri="{FF2B5EF4-FFF2-40B4-BE49-F238E27FC236}">
                  <a16:creationId xmlns:a16="http://schemas.microsoft.com/office/drawing/2014/main" id="{D896CEA4-BF8D-07E1-7B26-296FA4547A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39163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4" name="Rectangle 73">
              <a:extLst>
                <a:ext uri="{FF2B5EF4-FFF2-40B4-BE49-F238E27FC236}">
                  <a16:creationId xmlns:a16="http://schemas.microsoft.com/office/drawing/2014/main" id="{D1F260C2-6DE7-4E33-BD50-3626F61F82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38766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5" name="Line 74">
              <a:extLst>
                <a:ext uri="{FF2B5EF4-FFF2-40B4-BE49-F238E27FC236}">
                  <a16:creationId xmlns:a16="http://schemas.microsoft.com/office/drawing/2014/main" id="{9153C1A6-EAA9-DE6D-2320-3E2F3FA220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379571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" name="Rectangle 75">
              <a:extLst>
                <a:ext uri="{FF2B5EF4-FFF2-40B4-BE49-F238E27FC236}">
                  <a16:creationId xmlns:a16="http://schemas.microsoft.com/office/drawing/2014/main" id="{DB98349C-5B73-49DD-4978-9273B02133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37560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7" name="Line 76">
              <a:extLst>
                <a:ext uri="{FF2B5EF4-FFF2-40B4-BE49-F238E27FC236}">
                  <a16:creationId xmlns:a16="http://schemas.microsoft.com/office/drawing/2014/main" id="{7CEE677E-73BF-180C-2072-BDD3E11BD4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366871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" name="Rectangle 77">
              <a:extLst>
                <a:ext uri="{FF2B5EF4-FFF2-40B4-BE49-F238E27FC236}">
                  <a16:creationId xmlns:a16="http://schemas.microsoft.com/office/drawing/2014/main" id="{1CE4AAA9-90CE-FBB8-C42B-AD6718BDC1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36290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9" name="Line 78">
              <a:extLst>
                <a:ext uri="{FF2B5EF4-FFF2-40B4-BE49-F238E27FC236}">
                  <a16:creationId xmlns:a16="http://schemas.microsoft.com/office/drawing/2014/main" id="{2A36E437-1A16-77B1-1E0D-AA1A9B603D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35480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" name="Rectangle 79">
              <a:extLst>
                <a:ext uri="{FF2B5EF4-FFF2-40B4-BE49-F238E27FC236}">
                  <a16:creationId xmlns:a16="http://schemas.microsoft.com/office/drawing/2014/main" id="{9B5E6496-D359-B1B6-40A8-F8BE513BBC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35083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Line 80">
              <a:extLst>
                <a:ext uri="{FF2B5EF4-FFF2-40B4-BE49-F238E27FC236}">
                  <a16:creationId xmlns:a16="http://schemas.microsoft.com/office/drawing/2014/main" id="{27B9938E-27D5-742D-DD65-3616634764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342582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2" name="Rectangle 81">
              <a:extLst>
                <a:ext uri="{FF2B5EF4-FFF2-40B4-BE49-F238E27FC236}">
                  <a16:creationId xmlns:a16="http://schemas.microsoft.com/office/drawing/2014/main" id="{30DF2623-A718-5B05-D3A3-5A055CD1BE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33877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3" name="Line 82">
              <a:extLst>
                <a:ext uri="{FF2B5EF4-FFF2-40B4-BE49-F238E27FC236}">
                  <a16:creationId xmlns:a16="http://schemas.microsoft.com/office/drawing/2014/main" id="{1AEF36F3-8617-614E-8523-DD525811D8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329882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" name="Rectangle 83">
              <a:extLst>
                <a:ext uri="{FF2B5EF4-FFF2-40B4-BE49-F238E27FC236}">
                  <a16:creationId xmlns:a16="http://schemas.microsoft.com/office/drawing/2014/main" id="{E77EDC98-F6CC-EF0F-0EC0-BE08C3CAA7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32607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5" name="Line 84">
              <a:extLst>
                <a:ext uri="{FF2B5EF4-FFF2-40B4-BE49-F238E27FC236}">
                  <a16:creationId xmlns:a16="http://schemas.microsoft.com/office/drawing/2014/main" id="{A27C4508-BB1C-1E97-57D3-3D7CA4A1D9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317817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" name="Rectangle 85">
              <a:extLst>
                <a:ext uri="{FF2B5EF4-FFF2-40B4-BE49-F238E27FC236}">
                  <a16:creationId xmlns:a16="http://schemas.microsoft.com/office/drawing/2014/main" id="{CF769EC0-00A1-0C8D-BF4E-EFAF4C1906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3140075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7" name="Line 86">
              <a:extLst>
                <a:ext uri="{FF2B5EF4-FFF2-40B4-BE49-F238E27FC236}">
                  <a16:creationId xmlns:a16="http://schemas.microsoft.com/office/drawing/2014/main" id="{BE81CF1B-651B-609A-E129-8C8D03FB25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305117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" name="Rectangle 87">
              <a:extLst>
                <a:ext uri="{FF2B5EF4-FFF2-40B4-BE49-F238E27FC236}">
                  <a16:creationId xmlns:a16="http://schemas.microsoft.com/office/drawing/2014/main" id="{B2FB6DEF-71AE-EAE2-1989-EF25CA12F4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30130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9" name="Line 88">
              <a:extLst>
                <a:ext uri="{FF2B5EF4-FFF2-40B4-BE49-F238E27FC236}">
                  <a16:creationId xmlns:a16="http://schemas.microsoft.com/office/drawing/2014/main" id="{F2A25BA3-E4A9-08FC-F55B-4B08FBD45B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293052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" name="Rectangle 89">
              <a:extLst>
                <a:ext uri="{FF2B5EF4-FFF2-40B4-BE49-F238E27FC236}">
                  <a16:creationId xmlns:a16="http://schemas.microsoft.com/office/drawing/2014/main" id="{01029A91-D1E5-6884-E128-18AD6C8AD3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2890838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1" name="Line 90">
              <a:extLst>
                <a:ext uri="{FF2B5EF4-FFF2-40B4-BE49-F238E27FC236}">
                  <a16:creationId xmlns:a16="http://schemas.microsoft.com/office/drawing/2014/main" id="{D9142AA4-7F6E-388F-155A-039919ED6B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280352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2" name="Rectangle 91">
              <a:extLst>
                <a:ext uri="{FF2B5EF4-FFF2-40B4-BE49-F238E27FC236}">
                  <a16:creationId xmlns:a16="http://schemas.microsoft.com/office/drawing/2014/main" id="{36CC8F58-C9CA-F236-E8F6-E969AB8675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27654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3" name="Line 92">
              <a:extLst>
                <a:ext uri="{FF2B5EF4-FFF2-40B4-BE49-F238E27FC236}">
                  <a16:creationId xmlns:a16="http://schemas.microsoft.com/office/drawing/2014/main" id="{C28C4C38-28A7-6D9B-0A48-1FA1D1571B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268287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4" name="Rectangle 93">
              <a:extLst>
                <a:ext uri="{FF2B5EF4-FFF2-40B4-BE49-F238E27FC236}">
                  <a16:creationId xmlns:a16="http://schemas.microsoft.com/office/drawing/2014/main" id="{A5C60AFA-DCE5-78D9-5208-99323239FF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2643188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5" name="Line 94">
              <a:extLst>
                <a:ext uri="{FF2B5EF4-FFF2-40B4-BE49-F238E27FC236}">
                  <a16:creationId xmlns:a16="http://schemas.microsoft.com/office/drawing/2014/main" id="{BA3F96B3-0E4D-062F-6875-2C24C972DC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256063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6" name="Rectangle 95">
              <a:extLst>
                <a:ext uri="{FF2B5EF4-FFF2-40B4-BE49-F238E27FC236}">
                  <a16:creationId xmlns:a16="http://schemas.microsoft.com/office/drawing/2014/main" id="{628998A9-792F-7D53-9350-3FA040B905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2522538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7" name="Line 96">
              <a:extLst>
                <a:ext uri="{FF2B5EF4-FFF2-40B4-BE49-F238E27FC236}">
                  <a16:creationId xmlns:a16="http://schemas.microsoft.com/office/drawing/2014/main" id="{74CFBA3B-20CB-D232-1889-3BA95072C3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243522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8" name="Rectangle 97">
              <a:extLst>
                <a:ext uri="{FF2B5EF4-FFF2-40B4-BE49-F238E27FC236}">
                  <a16:creationId xmlns:a16="http://schemas.microsoft.com/office/drawing/2014/main" id="{F3CA26A5-B7A3-1135-6C37-D150C3CB82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2395538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9" name="Rectangle 98">
              <a:extLst>
                <a:ext uri="{FF2B5EF4-FFF2-40B4-BE49-F238E27FC236}">
                  <a16:creationId xmlns:a16="http://schemas.microsoft.com/office/drawing/2014/main" id="{7016C948-A55F-7309-0193-9C9D1410E3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800" y="2225675"/>
              <a:ext cx="11372850" cy="22193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0" name="Rectangle 99">
              <a:extLst>
                <a:ext uri="{FF2B5EF4-FFF2-40B4-BE49-F238E27FC236}">
                  <a16:creationId xmlns:a16="http://schemas.microsoft.com/office/drawing/2014/main" id="{F8036C1A-7BCE-574D-C32F-C79CD199B4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912" y="2368550"/>
              <a:ext cx="11344275" cy="20431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1" name="Rectangle 100">
              <a:extLst>
                <a:ext uri="{FF2B5EF4-FFF2-40B4-BE49-F238E27FC236}">
                  <a16:creationId xmlns:a16="http://schemas.microsoft.com/office/drawing/2014/main" id="{16EE6494-3C70-6FB8-A8D2-9FCB4D6CA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025" y="2263775"/>
              <a:ext cx="2439988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+ESI EIC(616.176140) Scan Frag=250.0V 20230203_031_Vayu RM_EEKB_H3.d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3" name="Freeform 102">
              <a:extLst>
                <a:ext uri="{FF2B5EF4-FFF2-40B4-BE49-F238E27FC236}">
                  <a16:creationId xmlns:a16="http://schemas.microsoft.com/office/drawing/2014/main" id="{71D00484-AD52-8919-7F72-D8287FA32413}"/>
                </a:ext>
              </a:extLst>
            </p:cNvPr>
            <p:cNvSpPr>
              <a:spLocks/>
            </p:cNvSpPr>
            <p:nvPr/>
          </p:nvSpPr>
          <p:spPr bwMode="auto">
            <a:xfrm>
              <a:off x="4418012" y="2554288"/>
              <a:ext cx="377825" cy="1836738"/>
            </a:xfrm>
            <a:custGeom>
              <a:avLst/>
              <a:gdLst>
                <a:gd name="T0" fmla="*/ 0 w 238"/>
                <a:gd name="T1" fmla="*/ 1157 h 1157"/>
                <a:gd name="T2" fmla="*/ 18 w 238"/>
                <a:gd name="T3" fmla="*/ 1145 h 1157"/>
                <a:gd name="T4" fmla="*/ 34 w 238"/>
                <a:gd name="T5" fmla="*/ 740 h 1157"/>
                <a:gd name="T6" fmla="*/ 51 w 238"/>
                <a:gd name="T7" fmla="*/ 0 h 1157"/>
                <a:gd name="T8" fmla="*/ 68 w 238"/>
                <a:gd name="T9" fmla="*/ 235 h 1157"/>
                <a:gd name="T10" fmla="*/ 85 w 238"/>
                <a:gd name="T11" fmla="*/ 697 h 1157"/>
                <a:gd name="T12" fmla="*/ 102 w 238"/>
                <a:gd name="T13" fmla="*/ 955 h 1157"/>
                <a:gd name="T14" fmla="*/ 119 w 238"/>
                <a:gd name="T15" fmla="*/ 1028 h 1157"/>
                <a:gd name="T16" fmla="*/ 136 w 238"/>
                <a:gd name="T17" fmla="*/ 1086 h 1157"/>
                <a:gd name="T18" fmla="*/ 153 w 238"/>
                <a:gd name="T19" fmla="*/ 1107 h 1157"/>
                <a:gd name="T20" fmla="*/ 170 w 238"/>
                <a:gd name="T21" fmla="*/ 1123 h 1157"/>
                <a:gd name="T22" fmla="*/ 187 w 238"/>
                <a:gd name="T23" fmla="*/ 1131 h 1157"/>
                <a:gd name="T24" fmla="*/ 204 w 238"/>
                <a:gd name="T25" fmla="*/ 1141 h 1157"/>
                <a:gd name="T26" fmla="*/ 221 w 238"/>
                <a:gd name="T27" fmla="*/ 1147 h 1157"/>
                <a:gd name="T28" fmla="*/ 238 w 238"/>
                <a:gd name="T29" fmla="*/ 1147 h 1157"/>
                <a:gd name="T30" fmla="*/ 238 w 238"/>
                <a:gd name="T31" fmla="*/ 1147 h 1157"/>
                <a:gd name="T32" fmla="*/ 238 w 238"/>
                <a:gd name="T33" fmla="*/ 1147 h 1157"/>
                <a:gd name="T34" fmla="*/ 0 w 238"/>
                <a:gd name="T35" fmla="*/ 1157 h 1157"/>
                <a:gd name="T36" fmla="*/ 0 w 238"/>
                <a:gd name="T37" fmla="*/ 1157 h 1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38" h="1157">
                  <a:moveTo>
                    <a:pt x="0" y="1157"/>
                  </a:moveTo>
                  <a:lnTo>
                    <a:pt x="18" y="1145"/>
                  </a:lnTo>
                  <a:lnTo>
                    <a:pt x="34" y="740"/>
                  </a:lnTo>
                  <a:lnTo>
                    <a:pt x="51" y="0"/>
                  </a:lnTo>
                  <a:lnTo>
                    <a:pt x="68" y="235"/>
                  </a:lnTo>
                  <a:lnTo>
                    <a:pt x="85" y="697"/>
                  </a:lnTo>
                  <a:lnTo>
                    <a:pt x="102" y="955"/>
                  </a:lnTo>
                  <a:lnTo>
                    <a:pt x="119" y="1028"/>
                  </a:lnTo>
                  <a:lnTo>
                    <a:pt x="136" y="1086"/>
                  </a:lnTo>
                  <a:lnTo>
                    <a:pt x="153" y="1107"/>
                  </a:lnTo>
                  <a:lnTo>
                    <a:pt x="170" y="1123"/>
                  </a:lnTo>
                  <a:lnTo>
                    <a:pt x="187" y="1131"/>
                  </a:lnTo>
                  <a:lnTo>
                    <a:pt x="204" y="1141"/>
                  </a:lnTo>
                  <a:lnTo>
                    <a:pt x="221" y="1147"/>
                  </a:lnTo>
                  <a:lnTo>
                    <a:pt x="238" y="1147"/>
                  </a:lnTo>
                  <a:lnTo>
                    <a:pt x="238" y="1147"/>
                  </a:lnTo>
                  <a:lnTo>
                    <a:pt x="238" y="1147"/>
                  </a:lnTo>
                  <a:lnTo>
                    <a:pt x="0" y="1157"/>
                  </a:lnTo>
                  <a:lnTo>
                    <a:pt x="0" y="1157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5" name="Freeform 104">
              <a:extLst>
                <a:ext uri="{FF2B5EF4-FFF2-40B4-BE49-F238E27FC236}">
                  <a16:creationId xmlns:a16="http://schemas.microsoft.com/office/drawing/2014/main" id="{F2F4AAD3-76B0-4941-CFF1-26F04460FA2F}"/>
                </a:ext>
              </a:extLst>
            </p:cNvPr>
            <p:cNvSpPr>
              <a:spLocks/>
            </p:cNvSpPr>
            <p:nvPr/>
          </p:nvSpPr>
          <p:spPr bwMode="auto">
            <a:xfrm>
              <a:off x="4418012" y="4375150"/>
              <a:ext cx="377825" cy="15875"/>
            </a:xfrm>
            <a:custGeom>
              <a:avLst/>
              <a:gdLst>
                <a:gd name="T0" fmla="*/ 0 w 238"/>
                <a:gd name="T1" fmla="*/ 10 h 10"/>
                <a:gd name="T2" fmla="*/ 0 w 238"/>
                <a:gd name="T3" fmla="*/ 10 h 10"/>
                <a:gd name="T4" fmla="*/ 238 w 238"/>
                <a:gd name="T5" fmla="*/ 0 h 10"/>
                <a:gd name="T6" fmla="*/ 238 w 238"/>
                <a:gd name="T7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38" h="10">
                  <a:moveTo>
                    <a:pt x="0" y="10"/>
                  </a:moveTo>
                  <a:lnTo>
                    <a:pt x="0" y="10"/>
                  </a:lnTo>
                  <a:lnTo>
                    <a:pt x="238" y="0"/>
                  </a:lnTo>
                  <a:lnTo>
                    <a:pt x="238" y="0"/>
                  </a:ln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6" name="Freeform 105">
              <a:extLst>
                <a:ext uri="{FF2B5EF4-FFF2-40B4-BE49-F238E27FC236}">
                  <a16:creationId xmlns:a16="http://schemas.microsoft.com/office/drawing/2014/main" id="{618D85F5-C711-FDAE-97D9-1D2434A8F1B3}"/>
                </a:ext>
              </a:extLst>
            </p:cNvPr>
            <p:cNvSpPr>
              <a:spLocks/>
            </p:cNvSpPr>
            <p:nvPr/>
          </p:nvSpPr>
          <p:spPr bwMode="auto">
            <a:xfrm>
              <a:off x="569912" y="2555875"/>
              <a:ext cx="6867525" cy="1855788"/>
            </a:xfrm>
            <a:custGeom>
              <a:avLst/>
              <a:gdLst>
                <a:gd name="T0" fmla="*/ 66 w 4326"/>
                <a:gd name="T1" fmla="*/ 1169 h 1169"/>
                <a:gd name="T2" fmla="*/ 152 w 4326"/>
                <a:gd name="T3" fmla="*/ 1169 h 1169"/>
                <a:gd name="T4" fmla="*/ 236 w 4326"/>
                <a:gd name="T5" fmla="*/ 1169 h 1169"/>
                <a:gd name="T6" fmla="*/ 322 w 4326"/>
                <a:gd name="T7" fmla="*/ 1169 h 1169"/>
                <a:gd name="T8" fmla="*/ 406 w 4326"/>
                <a:gd name="T9" fmla="*/ 1169 h 1169"/>
                <a:gd name="T10" fmla="*/ 492 w 4326"/>
                <a:gd name="T11" fmla="*/ 1169 h 1169"/>
                <a:gd name="T12" fmla="*/ 576 w 4326"/>
                <a:gd name="T13" fmla="*/ 1169 h 1169"/>
                <a:gd name="T14" fmla="*/ 659 w 4326"/>
                <a:gd name="T15" fmla="*/ 1169 h 1169"/>
                <a:gd name="T16" fmla="*/ 746 w 4326"/>
                <a:gd name="T17" fmla="*/ 1169 h 1169"/>
                <a:gd name="T18" fmla="*/ 829 w 4326"/>
                <a:gd name="T19" fmla="*/ 1169 h 1169"/>
                <a:gd name="T20" fmla="*/ 916 w 4326"/>
                <a:gd name="T21" fmla="*/ 1169 h 1169"/>
                <a:gd name="T22" fmla="*/ 999 w 4326"/>
                <a:gd name="T23" fmla="*/ 1169 h 1169"/>
                <a:gd name="T24" fmla="*/ 1086 w 4326"/>
                <a:gd name="T25" fmla="*/ 1169 h 1169"/>
                <a:gd name="T26" fmla="*/ 1169 w 4326"/>
                <a:gd name="T27" fmla="*/ 1169 h 1169"/>
                <a:gd name="T28" fmla="*/ 1256 w 4326"/>
                <a:gd name="T29" fmla="*/ 1169 h 1169"/>
                <a:gd name="T30" fmla="*/ 1339 w 4326"/>
                <a:gd name="T31" fmla="*/ 1169 h 1169"/>
                <a:gd name="T32" fmla="*/ 1422 w 4326"/>
                <a:gd name="T33" fmla="*/ 1169 h 1169"/>
                <a:gd name="T34" fmla="*/ 1509 w 4326"/>
                <a:gd name="T35" fmla="*/ 1169 h 1169"/>
                <a:gd name="T36" fmla="*/ 1592 w 4326"/>
                <a:gd name="T37" fmla="*/ 1169 h 1169"/>
                <a:gd name="T38" fmla="*/ 1679 w 4326"/>
                <a:gd name="T39" fmla="*/ 1169 h 1169"/>
                <a:gd name="T40" fmla="*/ 1762 w 4326"/>
                <a:gd name="T41" fmla="*/ 1169 h 1169"/>
                <a:gd name="T42" fmla="*/ 1849 w 4326"/>
                <a:gd name="T43" fmla="*/ 1169 h 1169"/>
                <a:gd name="T44" fmla="*/ 1932 w 4326"/>
                <a:gd name="T45" fmla="*/ 1169 h 1169"/>
                <a:gd name="T46" fmla="*/ 2019 w 4326"/>
                <a:gd name="T47" fmla="*/ 1169 h 1169"/>
                <a:gd name="T48" fmla="*/ 2102 w 4326"/>
                <a:gd name="T49" fmla="*/ 1169 h 1169"/>
                <a:gd name="T50" fmla="*/ 2185 w 4326"/>
                <a:gd name="T51" fmla="*/ 1169 h 1169"/>
                <a:gd name="T52" fmla="*/ 2272 w 4326"/>
                <a:gd name="T53" fmla="*/ 1169 h 1169"/>
                <a:gd name="T54" fmla="*/ 2355 w 4326"/>
                <a:gd name="T55" fmla="*/ 1162 h 1169"/>
                <a:gd name="T56" fmla="*/ 2442 w 4326"/>
                <a:gd name="T57" fmla="*/ 1145 h 1169"/>
                <a:gd name="T58" fmla="*/ 2525 w 4326"/>
                <a:gd name="T59" fmla="*/ 954 h 1169"/>
                <a:gd name="T60" fmla="*/ 2612 w 4326"/>
                <a:gd name="T61" fmla="*/ 1131 h 1169"/>
                <a:gd name="T62" fmla="*/ 2695 w 4326"/>
                <a:gd name="T63" fmla="*/ 1159 h 1169"/>
                <a:gd name="T64" fmla="*/ 2782 w 4326"/>
                <a:gd name="T65" fmla="*/ 1155 h 1169"/>
                <a:gd name="T66" fmla="*/ 2865 w 4326"/>
                <a:gd name="T67" fmla="*/ 1159 h 1169"/>
                <a:gd name="T68" fmla="*/ 2952 w 4326"/>
                <a:gd name="T69" fmla="*/ 1162 h 1169"/>
                <a:gd name="T70" fmla="*/ 3035 w 4326"/>
                <a:gd name="T71" fmla="*/ 1166 h 1169"/>
                <a:gd name="T72" fmla="*/ 3119 w 4326"/>
                <a:gd name="T73" fmla="*/ 1166 h 1169"/>
                <a:gd name="T74" fmla="*/ 3205 w 4326"/>
                <a:gd name="T75" fmla="*/ 1166 h 1169"/>
                <a:gd name="T76" fmla="*/ 3288 w 4326"/>
                <a:gd name="T77" fmla="*/ 1166 h 1169"/>
                <a:gd name="T78" fmla="*/ 3375 w 4326"/>
                <a:gd name="T79" fmla="*/ 1166 h 1169"/>
                <a:gd name="T80" fmla="*/ 3458 w 4326"/>
                <a:gd name="T81" fmla="*/ 1166 h 1169"/>
                <a:gd name="T82" fmla="*/ 3545 w 4326"/>
                <a:gd name="T83" fmla="*/ 1166 h 1169"/>
                <a:gd name="T84" fmla="*/ 3628 w 4326"/>
                <a:gd name="T85" fmla="*/ 1166 h 1169"/>
                <a:gd name="T86" fmla="*/ 3715 w 4326"/>
                <a:gd name="T87" fmla="*/ 1169 h 1169"/>
                <a:gd name="T88" fmla="*/ 3798 w 4326"/>
                <a:gd name="T89" fmla="*/ 1166 h 1169"/>
                <a:gd name="T90" fmla="*/ 3882 w 4326"/>
                <a:gd name="T91" fmla="*/ 1169 h 1169"/>
                <a:gd name="T92" fmla="*/ 3968 w 4326"/>
                <a:gd name="T93" fmla="*/ 1169 h 1169"/>
                <a:gd name="T94" fmla="*/ 4052 w 4326"/>
                <a:gd name="T95" fmla="*/ 1166 h 1169"/>
                <a:gd name="T96" fmla="*/ 4138 w 4326"/>
                <a:gd name="T97" fmla="*/ 1162 h 1169"/>
                <a:gd name="T98" fmla="*/ 4222 w 4326"/>
                <a:gd name="T99" fmla="*/ 1166 h 1169"/>
                <a:gd name="T100" fmla="*/ 4308 w 4326"/>
                <a:gd name="T101" fmla="*/ 1169 h 1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4326" h="1169">
                  <a:moveTo>
                    <a:pt x="0" y="1169"/>
                  </a:moveTo>
                  <a:lnTo>
                    <a:pt x="17" y="1169"/>
                  </a:lnTo>
                  <a:lnTo>
                    <a:pt x="34" y="1169"/>
                  </a:lnTo>
                  <a:lnTo>
                    <a:pt x="48" y="1169"/>
                  </a:lnTo>
                  <a:lnTo>
                    <a:pt x="66" y="1169"/>
                  </a:lnTo>
                  <a:lnTo>
                    <a:pt x="83" y="1169"/>
                  </a:lnTo>
                  <a:lnTo>
                    <a:pt x="100" y="1169"/>
                  </a:lnTo>
                  <a:lnTo>
                    <a:pt x="118" y="1169"/>
                  </a:lnTo>
                  <a:lnTo>
                    <a:pt x="135" y="1169"/>
                  </a:lnTo>
                  <a:lnTo>
                    <a:pt x="152" y="1169"/>
                  </a:lnTo>
                  <a:lnTo>
                    <a:pt x="170" y="1169"/>
                  </a:lnTo>
                  <a:lnTo>
                    <a:pt x="187" y="1169"/>
                  </a:lnTo>
                  <a:lnTo>
                    <a:pt x="201" y="1169"/>
                  </a:lnTo>
                  <a:lnTo>
                    <a:pt x="218" y="1169"/>
                  </a:lnTo>
                  <a:lnTo>
                    <a:pt x="236" y="1169"/>
                  </a:lnTo>
                  <a:lnTo>
                    <a:pt x="253" y="1169"/>
                  </a:lnTo>
                  <a:lnTo>
                    <a:pt x="270" y="1169"/>
                  </a:lnTo>
                  <a:lnTo>
                    <a:pt x="288" y="1169"/>
                  </a:lnTo>
                  <a:lnTo>
                    <a:pt x="305" y="1169"/>
                  </a:lnTo>
                  <a:lnTo>
                    <a:pt x="322" y="1169"/>
                  </a:lnTo>
                  <a:lnTo>
                    <a:pt x="340" y="1169"/>
                  </a:lnTo>
                  <a:lnTo>
                    <a:pt x="354" y="1169"/>
                  </a:lnTo>
                  <a:lnTo>
                    <a:pt x="371" y="1169"/>
                  </a:lnTo>
                  <a:lnTo>
                    <a:pt x="388" y="1169"/>
                  </a:lnTo>
                  <a:lnTo>
                    <a:pt x="406" y="1169"/>
                  </a:lnTo>
                  <a:lnTo>
                    <a:pt x="423" y="1169"/>
                  </a:lnTo>
                  <a:lnTo>
                    <a:pt x="440" y="1169"/>
                  </a:lnTo>
                  <a:lnTo>
                    <a:pt x="458" y="1169"/>
                  </a:lnTo>
                  <a:lnTo>
                    <a:pt x="475" y="1169"/>
                  </a:lnTo>
                  <a:lnTo>
                    <a:pt x="492" y="1169"/>
                  </a:lnTo>
                  <a:lnTo>
                    <a:pt x="506" y="1169"/>
                  </a:lnTo>
                  <a:lnTo>
                    <a:pt x="524" y="1169"/>
                  </a:lnTo>
                  <a:lnTo>
                    <a:pt x="541" y="1169"/>
                  </a:lnTo>
                  <a:lnTo>
                    <a:pt x="558" y="1169"/>
                  </a:lnTo>
                  <a:lnTo>
                    <a:pt x="576" y="1169"/>
                  </a:lnTo>
                  <a:lnTo>
                    <a:pt x="593" y="1169"/>
                  </a:lnTo>
                  <a:lnTo>
                    <a:pt x="610" y="1169"/>
                  </a:lnTo>
                  <a:lnTo>
                    <a:pt x="628" y="1169"/>
                  </a:lnTo>
                  <a:lnTo>
                    <a:pt x="645" y="1169"/>
                  </a:lnTo>
                  <a:lnTo>
                    <a:pt x="659" y="1169"/>
                  </a:lnTo>
                  <a:lnTo>
                    <a:pt x="676" y="1169"/>
                  </a:lnTo>
                  <a:lnTo>
                    <a:pt x="694" y="1169"/>
                  </a:lnTo>
                  <a:lnTo>
                    <a:pt x="711" y="1169"/>
                  </a:lnTo>
                  <a:lnTo>
                    <a:pt x="728" y="1169"/>
                  </a:lnTo>
                  <a:lnTo>
                    <a:pt x="746" y="1169"/>
                  </a:lnTo>
                  <a:lnTo>
                    <a:pt x="763" y="1169"/>
                  </a:lnTo>
                  <a:lnTo>
                    <a:pt x="780" y="1169"/>
                  </a:lnTo>
                  <a:lnTo>
                    <a:pt x="798" y="1169"/>
                  </a:lnTo>
                  <a:lnTo>
                    <a:pt x="812" y="1169"/>
                  </a:lnTo>
                  <a:lnTo>
                    <a:pt x="829" y="1169"/>
                  </a:lnTo>
                  <a:lnTo>
                    <a:pt x="846" y="1169"/>
                  </a:lnTo>
                  <a:lnTo>
                    <a:pt x="864" y="1169"/>
                  </a:lnTo>
                  <a:lnTo>
                    <a:pt x="881" y="1169"/>
                  </a:lnTo>
                  <a:lnTo>
                    <a:pt x="898" y="1169"/>
                  </a:lnTo>
                  <a:lnTo>
                    <a:pt x="916" y="1169"/>
                  </a:lnTo>
                  <a:lnTo>
                    <a:pt x="933" y="1169"/>
                  </a:lnTo>
                  <a:lnTo>
                    <a:pt x="950" y="1169"/>
                  </a:lnTo>
                  <a:lnTo>
                    <a:pt x="964" y="1169"/>
                  </a:lnTo>
                  <a:lnTo>
                    <a:pt x="982" y="1169"/>
                  </a:lnTo>
                  <a:lnTo>
                    <a:pt x="999" y="1169"/>
                  </a:lnTo>
                  <a:lnTo>
                    <a:pt x="1016" y="1169"/>
                  </a:lnTo>
                  <a:lnTo>
                    <a:pt x="1034" y="1169"/>
                  </a:lnTo>
                  <a:lnTo>
                    <a:pt x="1051" y="1169"/>
                  </a:lnTo>
                  <a:lnTo>
                    <a:pt x="1068" y="1169"/>
                  </a:lnTo>
                  <a:lnTo>
                    <a:pt x="1086" y="1169"/>
                  </a:lnTo>
                  <a:lnTo>
                    <a:pt x="1103" y="1169"/>
                  </a:lnTo>
                  <a:lnTo>
                    <a:pt x="1117" y="1169"/>
                  </a:lnTo>
                  <a:lnTo>
                    <a:pt x="1134" y="1169"/>
                  </a:lnTo>
                  <a:lnTo>
                    <a:pt x="1151" y="1169"/>
                  </a:lnTo>
                  <a:lnTo>
                    <a:pt x="1169" y="1169"/>
                  </a:lnTo>
                  <a:lnTo>
                    <a:pt x="1186" y="1169"/>
                  </a:lnTo>
                  <a:lnTo>
                    <a:pt x="1204" y="1169"/>
                  </a:lnTo>
                  <a:lnTo>
                    <a:pt x="1221" y="1169"/>
                  </a:lnTo>
                  <a:lnTo>
                    <a:pt x="1238" y="1169"/>
                  </a:lnTo>
                  <a:lnTo>
                    <a:pt x="1256" y="1169"/>
                  </a:lnTo>
                  <a:lnTo>
                    <a:pt x="1269" y="1169"/>
                  </a:lnTo>
                  <a:lnTo>
                    <a:pt x="1287" y="1169"/>
                  </a:lnTo>
                  <a:lnTo>
                    <a:pt x="1304" y="1169"/>
                  </a:lnTo>
                  <a:lnTo>
                    <a:pt x="1321" y="1169"/>
                  </a:lnTo>
                  <a:lnTo>
                    <a:pt x="1339" y="1169"/>
                  </a:lnTo>
                  <a:lnTo>
                    <a:pt x="1356" y="1169"/>
                  </a:lnTo>
                  <a:lnTo>
                    <a:pt x="1374" y="1169"/>
                  </a:lnTo>
                  <a:lnTo>
                    <a:pt x="1391" y="1169"/>
                  </a:lnTo>
                  <a:lnTo>
                    <a:pt x="1408" y="1169"/>
                  </a:lnTo>
                  <a:lnTo>
                    <a:pt x="1422" y="1169"/>
                  </a:lnTo>
                  <a:lnTo>
                    <a:pt x="1439" y="1169"/>
                  </a:lnTo>
                  <a:lnTo>
                    <a:pt x="1457" y="1169"/>
                  </a:lnTo>
                  <a:lnTo>
                    <a:pt x="1474" y="1169"/>
                  </a:lnTo>
                  <a:lnTo>
                    <a:pt x="1491" y="1169"/>
                  </a:lnTo>
                  <a:lnTo>
                    <a:pt x="1509" y="1169"/>
                  </a:lnTo>
                  <a:lnTo>
                    <a:pt x="1526" y="1169"/>
                  </a:lnTo>
                  <a:lnTo>
                    <a:pt x="1544" y="1169"/>
                  </a:lnTo>
                  <a:lnTo>
                    <a:pt x="1561" y="1169"/>
                  </a:lnTo>
                  <a:lnTo>
                    <a:pt x="1575" y="1169"/>
                  </a:lnTo>
                  <a:lnTo>
                    <a:pt x="1592" y="1169"/>
                  </a:lnTo>
                  <a:lnTo>
                    <a:pt x="1609" y="1169"/>
                  </a:lnTo>
                  <a:lnTo>
                    <a:pt x="1627" y="1169"/>
                  </a:lnTo>
                  <a:lnTo>
                    <a:pt x="1644" y="1169"/>
                  </a:lnTo>
                  <a:lnTo>
                    <a:pt x="1661" y="1169"/>
                  </a:lnTo>
                  <a:lnTo>
                    <a:pt x="1679" y="1169"/>
                  </a:lnTo>
                  <a:lnTo>
                    <a:pt x="1696" y="1169"/>
                  </a:lnTo>
                  <a:lnTo>
                    <a:pt x="1713" y="1169"/>
                  </a:lnTo>
                  <a:lnTo>
                    <a:pt x="1727" y="1169"/>
                  </a:lnTo>
                  <a:lnTo>
                    <a:pt x="1745" y="1169"/>
                  </a:lnTo>
                  <a:lnTo>
                    <a:pt x="1762" y="1169"/>
                  </a:lnTo>
                  <a:lnTo>
                    <a:pt x="1779" y="1169"/>
                  </a:lnTo>
                  <a:lnTo>
                    <a:pt x="1797" y="1169"/>
                  </a:lnTo>
                  <a:lnTo>
                    <a:pt x="1814" y="1169"/>
                  </a:lnTo>
                  <a:lnTo>
                    <a:pt x="1831" y="1169"/>
                  </a:lnTo>
                  <a:lnTo>
                    <a:pt x="1849" y="1169"/>
                  </a:lnTo>
                  <a:lnTo>
                    <a:pt x="1866" y="1169"/>
                  </a:lnTo>
                  <a:lnTo>
                    <a:pt x="1880" y="1169"/>
                  </a:lnTo>
                  <a:lnTo>
                    <a:pt x="1897" y="1169"/>
                  </a:lnTo>
                  <a:lnTo>
                    <a:pt x="1915" y="1169"/>
                  </a:lnTo>
                  <a:lnTo>
                    <a:pt x="1932" y="1169"/>
                  </a:lnTo>
                  <a:lnTo>
                    <a:pt x="1949" y="1169"/>
                  </a:lnTo>
                  <a:lnTo>
                    <a:pt x="1967" y="1169"/>
                  </a:lnTo>
                  <a:lnTo>
                    <a:pt x="1984" y="1169"/>
                  </a:lnTo>
                  <a:lnTo>
                    <a:pt x="2001" y="1169"/>
                  </a:lnTo>
                  <a:lnTo>
                    <a:pt x="2019" y="1169"/>
                  </a:lnTo>
                  <a:lnTo>
                    <a:pt x="2033" y="1169"/>
                  </a:lnTo>
                  <a:lnTo>
                    <a:pt x="2050" y="1169"/>
                  </a:lnTo>
                  <a:lnTo>
                    <a:pt x="2067" y="1169"/>
                  </a:lnTo>
                  <a:lnTo>
                    <a:pt x="2085" y="1169"/>
                  </a:lnTo>
                  <a:lnTo>
                    <a:pt x="2102" y="1169"/>
                  </a:lnTo>
                  <a:lnTo>
                    <a:pt x="2119" y="1166"/>
                  </a:lnTo>
                  <a:lnTo>
                    <a:pt x="2137" y="1169"/>
                  </a:lnTo>
                  <a:lnTo>
                    <a:pt x="2154" y="1169"/>
                  </a:lnTo>
                  <a:lnTo>
                    <a:pt x="2171" y="1169"/>
                  </a:lnTo>
                  <a:lnTo>
                    <a:pt x="2185" y="1169"/>
                  </a:lnTo>
                  <a:lnTo>
                    <a:pt x="2203" y="1166"/>
                  </a:lnTo>
                  <a:lnTo>
                    <a:pt x="2220" y="1169"/>
                  </a:lnTo>
                  <a:lnTo>
                    <a:pt x="2237" y="1169"/>
                  </a:lnTo>
                  <a:lnTo>
                    <a:pt x="2255" y="1169"/>
                  </a:lnTo>
                  <a:lnTo>
                    <a:pt x="2272" y="1169"/>
                  </a:lnTo>
                  <a:lnTo>
                    <a:pt x="2289" y="1169"/>
                  </a:lnTo>
                  <a:lnTo>
                    <a:pt x="2307" y="1166"/>
                  </a:lnTo>
                  <a:lnTo>
                    <a:pt x="2324" y="1169"/>
                  </a:lnTo>
                  <a:lnTo>
                    <a:pt x="2338" y="1169"/>
                  </a:lnTo>
                  <a:lnTo>
                    <a:pt x="2355" y="1162"/>
                  </a:lnTo>
                  <a:lnTo>
                    <a:pt x="2373" y="1155"/>
                  </a:lnTo>
                  <a:lnTo>
                    <a:pt x="2390" y="1155"/>
                  </a:lnTo>
                  <a:lnTo>
                    <a:pt x="2407" y="1152"/>
                  </a:lnTo>
                  <a:lnTo>
                    <a:pt x="2425" y="1155"/>
                  </a:lnTo>
                  <a:lnTo>
                    <a:pt x="2442" y="1145"/>
                  </a:lnTo>
                  <a:lnTo>
                    <a:pt x="2459" y="739"/>
                  </a:lnTo>
                  <a:lnTo>
                    <a:pt x="2477" y="0"/>
                  </a:lnTo>
                  <a:lnTo>
                    <a:pt x="2491" y="233"/>
                  </a:lnTo>
                  <a:lnTo>
                    <a:pt x="2508" y="697"/>
                  </a:lnTo>
                  <a:lnTo>
                    <a:pt x="2525" y="954"/>
                  </a:lnTo>
                  <a:lnTo>
                    <a:pt x="2543" y="1027"/>
                  </a:lnTo>
                  <a:lnTo>
                    <a:pt x="2560" y="1086"/>
                  </a:lnTo>
                  <a:lnTo>
                    <a:pt x="2577" y="1107"/>
                  </a:lnTo>
                  <a:lnTo>
                    <a:pt x="2595" y="1121"/>
                  </a:lnTo>
                  <a:lnTo>
                    <a:pt x="2612" y="1131"/>
                  </a:lnTo>
                  <a:lnTo>
                    <a:pt x="2629" y="1138"/>
                  </a:lnTo>
                  <a:lnTo>
                    <a:pt x="2643" y="1145"/>
                  </a:lnTo>
                  <a:lnTo>
                    <a:pt x="2661" y="1145"/>
                  </a:lnTo>
                  <a:lnTo>
                    <a:pt x="2678" y="1155"/>
                  </a:lnTo>
                  <a:lnTo>
                    <a:pt x="2695" y="1159"/>
                  </a:lnTo>
                  <a:lnTo>
                    <a:pt x="2713" y="1155"/>
                  </a:lnTo>
                  <a:lnTo>
                    <a:pt x="2730" y="1159"/>
                  </a:lnTo>
                  <a:lnTo>
                    <a:pt x="2747" y="1159"/>
                  </a:lnTo>
                  <a:lnTo>
                    <a:pt x="2765" y="1159"/>
                  </a:lnTo>
                  <a:lnTo>
                    <a:pt x="2782" y="1155"/>
                  </a:lnTo>
                  <a:lnTo>
                    <a:pt x="2796" y="1159"/>
                  </a:lnTo>
                  <a:lnTo>
                    <a:pt x="2813" y="1162"/>
                  </a:lnTo>
                  <a:lnTo>
                    <a:pt x="2831" y="1162"/>
                  </a:lnTo>
                  <a:lnTo>
                    <a:pt x="2848" y="1159"/>
                  </a:lnTo>
                  <a:lnTo>
                    <a:pt x="2865" y="1159"/>
                  </a:lnTo>
                  <a:lnTo>
                    <a:pt x="2883" y="1162"/>
                  </a:lnTo>
                  <a:lnTo>
                    <a:pt x="2900" y="1166"/>
                  </a:lnTo>
                  <a:lnTo>
                    <a:pt x="2917" y="1152"/>
                  </a:lnTo>
                  <a:lnTo>
                    <a:pt x="2935" y="1159"/>
                  </a:lnTo>
                  <a:lnTo>
                    <a:pt x="2952" y="1162"/>
                  </a:lnTo>
                  <a:lnTo>
                    <a:pt x="2966" y="1162"/>
                  </a:lnTo>
                  <a:lnTo>
                    <a:pt x="2983" y="1162"/>
                  </a:lnTo>
                  <a:lnTo>
                    <a:pt x="3001" y="1166"/>
                  </a:lnTo>
                  <a:lnTo>
                    <a:pt x="3018" y="1166"/>
                  </a:lnTo>
                  <a:lnTo>
                    <a:pt x="3035" y="1166"/>
                  </a:lnTo>
                  <a:lnTo>
                    <a:pt x="3053" y="1166"/>
                  </a:lnTo>
                  <a:lnTo>
                    <a:pt x="3070" y="1166"/>
                  </a:lnTo>
                  <a:lnTo>
                    <a:pt x="3087" y="1162"/>
                  </a:lnTo>
                  <a:lnTo>
                    <a:pt x="3105" y="1166"/>
                  </a:lnTo>
                  <a:lnTo>
                    <a:pt x="3119" y="1166"/>
                  </a:lnTo>
                  <a:lnTo>
                    <a:pt x="3136" y="1166"/>
                  </a:lnTo>
                  <a:lnTo>
                    <a:pt x="3153" y="1166"/>
                  </a:lnTo>
                  <a:lnTo>
                    <a:pt x="3171" y="1166"/>
                  </a:lnTo>
                  <a:lnTo>
                    <a:pt x="3188" y="1166"/>
                  </a:lnTo>
                  <a:lnTo>
                    <a:pt x="3205" y="1166"/>
                  </a:lnTo>
                  <a:lnTo>
                    <a:pt x="3223" y="1166"/>
                  </a:lnTo>
                  <a:lnTo>
                    <a:pt x="3240" y="1169"/>
                  </a:lnTo>
                  <a:lnTo>
                    <a:pt x="3257" y="1166"/>
                  </a:lnTo>
                  <a:lnTo>
                    <a:pt x="3271" y="1166"/>
                  </a:lnTo>
                  <a:lnTo>
                    <a:pt x="3288" y="1166"/>
                  </a:lnTo>
                  <a:lnTo>
                    <a:pt x="3306" y="1166"/>
                  </a:lnTo>
                  <a:lnTo>
                    <a:pt x="3323" y="1166"/>
                  </a:lnTo>
                  <a:lnTo>
                    <a:pt x="3341" y="1166"/>
                  </a:lnTo>
                  <a:lnTo>
                    <a:pt x="3358" y="1166"/>
                  </a:lnTo>
                  <a:lnTo>
                    <a:pt x="3375" y="1166"/>
                  </a:lnTo>
                  <a:lnTo>
                    <a:pt x="3393" y="1166"/>
                  </a:lnTo>
                  <a:lnTo>
                    <a:pt x="3410" y="1166"/>
                  </a:lnTo>
                  <a:lnTo>
                    <a:pt x="3424" y="1166"/>
                  </a:lnTo>
                  <a:lnTo>
                    <a:pt x="3441" y="1166"/>
                  </a:lnTo>
                  <a:lnTo>
                    <a:pt x="3458" y="1166"/>
                  </a:lnTo>
                  <a:lnTo>
                    <a:pt x="3476" y="1166"/>
                  </a:lnTo>
                  <a:lnTo>
                    <a:pt x="3493" y="1166"/>
                  </a:lnTo>
                  <a:lnTo>
                    <a:pt x="3511" y="1166"/>
                  </a:lnTo>
                  <a:lnTo>
                    <a:pt x="3528" y="1166"/>
                  </a:lnTo>
                  <a:lnTo>
                    <a:pt x="3545" y="1166"/>
                  </a:lnTo>
                  <a:lnTo>
                    <a:pt x="3563" y="1166"/>
                  </a:lnTo>
                  <a:lnTo>
                    <a:pt x="3576" y="1169"/>
                  </a:lnTo>
                  <a:lnTo>
                    <a:pt x="3594" y="1169"/>
                  </a:lnTo>
                  <a:lnTo>
                    <a:pt x="3611" y="1166"/>
                  </a:lnTo>
                  <a:lnTo>
                    <a:pt x="3628" y="1166"/>
                  </a:lnTo>
                  <a:lnTo>
                    <a:pt x="3646" y="1166"/>
                  </a:lnTo>
                  <a:lnTo>
                    <a:pt x="3663" y="1166"/>
                  </a:lnTo>
                  <a:lnTo>
                    <a:pt x="3681" y="1166"/>
                  </a:lnTo>
                  <a:lnTo>
                    <a:pt x="3698" y="1166"/>
                  </a:lnTo>
                  <a:lnTo>
                    <a:pt x="3715" y="1169"/>
                  </a:lnTo>
                  <a:lnTo>
                    <a:pt x="3729" y="1169"/>
                  </a:lnTo>
                  <a:lnTo>
                    <a:pt x="3746" y="1166"/>
                  </a:lnTo>
                  <a:lnTo>
                    <a:pt x="3764" y="1169"/>
                  </a:lnTo>
                  <a:lnTo>
                    <a:pt x="3781" y="1169"/>
                  </a:lnTo>
                  <a:lnTo>
                    <a:pt x="3798" y="1166"/>
                  </a:lnTo>
                  <a:lnTo>
                    <a:pt x="3816" y="1169"/>
                  </a:lnTo>
                  <a:lnTo>
                    <a:pt x="3833" y="1169"/>
                  </a:lnTo>
                  <a:lnTo>
                    <a:pt x="3850" y="1166"/>
                  </a:lnTo>
                  <a:lnTo>
                    <a:pt x="3868" y="1166"/>
                  </a:lnTo>
                  <a:lnTo>
                    <a:pt x="3882" y="1169"/>
                  </a:lnTo>
                  <a:lnTo>
                    <a:pt x="3899" y="1169"/>
                  </a:lnTo>
                  <a:lnTo>
                    <a:pt x="3916" y="1169"/>
                  </a:lnTo>
                  <a:lnTo>
                    <a:pt x="3934" y="1169"/>
                  </a:lnTo>
                  <a:lnTo>
                    <a:pt x="3951" y="1169"/>
                  </a:lnTo>
                  <a:lnTo>
                    <a:pt x="3968" y="1169"/>
                  </a:lnTo>
                  <a:lnTo>
                    <a:pt x="3986" y="1166"/>
                  </a:lnTo>
                  <a:lnTo>
                    <a:pt x="4003" y="1169"/>
                  </a:lnTo>
                  <a:lnTo>
                    <a:pt x="4020" y="1169"/>
                  </a:lnTo>
                  <a:lnTo>
                    <a:pt x="4034" y="1166"/>
                  </a:lnTo>
                  <a:lnTo>
                    <a:pt x="4052" y="1166"/>
                  </a:lnTo>
                  <a:lnTo>
                    <a:pt x="4069" y="1166"/>
                  </a:lnTo>
                  <a:lnTo>
                    <a:pt x="4086" y="1162"/>
                  </a:lnTo>
                  <a:lnTo>
                    <a:pt x="4104" y="1166"/>
                  </a:lnTo>
                  <a:lnTo>
                    <a:pt x="4121" y="1162"/>
                  </a:lnTo>
                  <a:lnTo>
                    <a:pt x="4138" y="1162"/>
                  </a:lnTo>
                  <a:lnTo>
                    <a:pt x="4156" y="1162"/>
                  </a:lnTo>
                  <a:lnTo>
                    <a:pt x="4173" y="1162"/>
                  </a:lnTo>
                  <a:lnTo>
                    <a:pt x="4187" y="1162"/>
                  </a:lnTo>
                  <a:lnTo>
                    <a:pt x="4204" y="1166"/>
                  </a:lnTo>
                  <a:lnTo>
                    <a:pt x="4222" y="1166"/>
                  </a:lnTo>
                  <a:lnTo>
                    <a:pt x="4239" y="1166"/>
                  </a:lnTo>
                  <a:lnTo>
                    <a:pt x="4256" y="1166"/>
                  </a:lnTo>
                  <a:lnTo>
                    <a:pt x="4274" y="1169"/>
                  </a:lnTo>
                  <a:lnTo>
                    <a:pt x="4291" y="1169"/>
                  </a:lnTo>
                  <a:lnTo>
                    <a:pt x="4308" y="1169"/>
                  </a:lnTo>
                  <a:lnTo>
                    <a:pt x="4326" y="1169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7" name="Rectangle 106">
              <a:extLst>
                <a:ext uri="{FF2B5EF4-FFF2-40B4-BE49-F238E27FC236}">
                  <a16:creationId xmlns:a16="http://schemas.microsoft.com/office/drawing/2014/main" id="{1299EA2A-245C-E11D-66A7-503861DE91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9470" y="2389507"/>
              <a:ext cx="67326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887 min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8" name="Rectangle 107">
              <a:extLst>
                <a:ext uri="{FF2B5EF4-FFF2-40B4-BE49-F238E27FC236}">
                  <a16:creationId xmlns:a16="http://schemas.microsoft.com/office/drawing/2014/main" id="{84651723-CCA7-C588-5C83-6B3ECAEE2D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562" y="2230438"/>
              <a:ext cx="11361738" cy="2209800"/>
            </a:xfrm>
            <a:prstGeom prst="rect">
              <a:avLst/>
            </a:prstGeom>
            <a:noFill/>
            <a:ln w="11113" cap="flat">
              <a:solidFill>
                <a:srgbClr val="F0F0F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9" name="Rectangle 108">
              <a:extLst>
                <a:ext uri="{FF2B5EF4-FFF2-40B4-BE49-F238E27FC236}">
                  <a16:creationId xmlns:a16="http://schemas.microsoft.com/office/drawing/2014/main" id="{A0C70EA9-FB5D-7F2D-9482-BA7A344B6F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450" y="2368550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808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Line 111">
              <a:extLst>
                <a:ext uri="{FF2B5EF4-FFF2-40B4-BE49-F238E27FC236}">
                  <a16:creationId xmlns:a16="http://schemas.microsoft.com/office/drawing/2014/main" id="{7B966289-EE8D-7117-5FBC-3F82A82E94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2450" y="4594225"/>
              <a:ext cx="0" cy="2043113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3" name="Rectangle 112">
              <a:extLst>
                <a:ext uri="{FF2B5EF4-FFF2-40B4-BE49-F238E27FC236}">
                  <a16:creationId xmlns:a16="http://schemas.microsoft.com/office/drawing/2014/main" id="{5DE4AF0F-9732-F121-82B9-CB2B4BEA21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125" y="4483100"/>
              <a:ext cx="49213" cy="66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4" name="Rectangle 113">
              <a:extLst>
                <a:ext uri="{FF2B5EF4-FFF2-40B4-BE49-F238E27FC236}">
                  <a16:creationId xmlns:a16="http://schemas.microsoft.com/office/drawing/2014/main" id="{35B6E72A-8DEC-5C84-0B2F-D83AE8E1F2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237" y="4494213"/>
              <a:ext cx="131763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x1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5" name="Line 114">
              <a:extLst>
                <a:ext uri="{FF2B5EF4-FFF2-40B4-BE49-F238E27FC236}">
                  <a16:creationId xmlns:a16="http://schemas.microsoft.com/office/drawing/2014/main" id="{7EEE938E-35D2-E7A4-19AD-F4D9FEC610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663733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6" name="Rectangle 115">
              <a:extLst>
                <a:ext uri="{FF2B5EF4-FFF2-40B4-BE49-F238E27FC236}">
                  <a16:creationId xmlns:a16="http://schemas.microsoft.com/office/drawing/2014/main" id="{AC32B963-4204-F4AF-F4CE-6262697059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6599238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7" name="Line 116">
              <a:extLst>
                <a:ext uri="{FF2B5EF4-FFF2-40B4-BE49-F238E27FC236}">
                  <a16:creationId xmlns:a16="http://schemas.microsoft.com/office/drawing/2014/main" id="{0177EF4A-175D-1EE7-B067-0E85A00D54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654367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8" name="Rectangle 117">
              <a:extLst>
                <a:ext uri="{FF2B5EF4-FFF2-40B4-BE49-F238E27FC236}">
                  <a16:creationId xmlns:a16="http://schemas.microsoft.com/office/drawing/2014/main" id="{B3BB6780-8A85-203E-7CC8-D225C12E22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65055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" name="Line 118">
              <a:extLst>
                <a:ext uri="{FF2B5EF4-FFF2-40B4-BE49-F238E27FC236}">
                  <a16:creationId xmlns:a16="http://schemas.microsoft.com/office/drawing/2014/main" id="{B873A7EA-1702-4F08-81DC-C4C75BFF6B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645001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0" name="Rectangle 119">
              <a:extLst>
                <a:ext uri="{FF2B5EF4-FFF2-40B4-BE49-F238E27FC236}">
                  <a16:creationId xmlns:a16="http://schemas.microsoft.com/office/drawing/2014/main" id="{40FD2D27-74FF-B13F-BAFA-9C1EEAC972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641191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1" name="Line 120">
              <a:extLst>
                <a:ext uri="{FF2B5EF4-FFF2-40B4-BE49-F238E27FC236}">
                  <a16:creationId xmlns:a16="http://schemas.microsoft.com/office/drawing/2014/main" id="{73CF1FD1-CE68-B450-7767-3821573CD8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635635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2" name="Rectangle 121">
              <a:extLst>
                <a:ext uri="{FF2B5EF4-FFF2-40B4-BE49-F238E27FC236}">
                  <a16:creationId xmlns:a16="http://schemas.microsoft.com/office/drawing/2014/main" id="{800C4808-6F41-4668-0DB1-580DE4FD62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6318250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3" name="Line 122">
              <a:extLst>
                <a:ext uri="{FF2B5EF4-FFF2-40B4-BE49-F238E27FC236}">
                  <a16:creationId xmlns:a16="http://schemas.microsoft.com/office/drawing/2014/main" id="{24F350ED-D804-3179-3BCE-08A58A0474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626268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4" name="Rectangle 123">
              <a:extLst>
                <a:ext uri="{FF2B5EF4-FFF2-40B4-BE49-F238E27FC236}">
                  <a16:creationId xmlns:a16="http://schemas.microsoft.com/office/drawing/2014/main" id="{C2E1CCBB-CCFB-A2F6-9759-BD6C8C5F4C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6224588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5" name="Line 124">
              <a:extLst>
                <a:ext uri="{FF2B5EF4-FFF2-40B4-BE49-F238E27FC236}">
                  <a16:creationId xmlns:a16="http://schemas.microsoft.com/office/drawing/2014/main" id="{EE1BA69F-5EF9-9EFD-7DDF-4B47376F7A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616902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6" name="Rectangle 125">
              <a:extLst>
                <a:ext uri="{FF2B5EF4-FFF2-40B4-BE49-F238E27FC236}">
                  <a16:creationId xmlns:a16="http://schemas.microsoft.com/office/drawing/2014/main" id="{24B71BD0-71C0-DC7F-519B-09A508073C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6130925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7" name="Line 126">
              <a:extLst>
                <a:ext uri="{FF2B5EF4-FFF2-40B4-BE49-F238E27FC236}">
                  <a16:creationId xmlns:a16="http://schemas.microsoft.com/office/drawing/2014/main" id="{24C8F10A-587D-789C-6E15-AE917EE7EC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60753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8" name="Rectangle 127">
              <a:extLst>
                <a:ext uri="{FF2B5EF4-FFF2-40B4-BE49-F238E27FC236}">
                  <a16:creationId xmlns:a16="http://schemas.microsoft.com/office/drawing/2014/main" id="{8D9A39C9-498B-936C-90A7-B9D45C5D5D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60372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9" name="Line 128">
              <a:extLst>
                <a:ext uri="{FF2B5EF4-FFF2-40B4-BE49-F238E27FC236}">
                  <a16:creationId xmlns:a16="http://schemas.microsoft.com/office/drawing/2014/main" id="{FE55C9C2-A9CD-FFCB-646B-59A59DC759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98170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0" name="Rectangle 129">
              <a:extLst>
                <a:ext uri="{FF2B5EF4-FFF2-40B4-BE49-F238E27FC236}">
                  <a16:creationId xmlns:a16="http://schemas.microsoft.com/office/drawing/2014/main" id="{DDBD4051-1BD9-4F49-2772-488FE31983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5943600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1" name="Line 130">
              <a:extLst>
                <a:ext uri="{FF2B5EF4-FFF2-40B4-BE49-F238E27FC236}">
                  <a16:creationId xmlns:a16="http://schemas.microsoft.com/office/drawing/2014/main" id="{86BA4CF6-7EFA-8BA9-1B5D-47FA7C792D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88803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2" name="Rectangle 131">
              <a:extLst>
                <a:ext uri="{FF2B5EF4-FFF2-40B4-BE49-F238E27FC236}">
                  <a16:creationId xmlns:a16="http://schemas.microsoft.com/office/drawing/2014/main" id="{B03DD51F-9214-E156-73F3-F4A5EF240C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5849938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3" name="Line 132">
              <a:extLst>
                <a:ext uri="{FF2B5EF4-FFF2-40B4-BE49-F238E27FC236}">
                  <a16:creationId xmlns:a16="http://schemas.microsoft.com/office/drawing/2014/main" id="{6C11F834-330D-AA93-9E81-4327D3E65C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79437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4" name="Rectangle 133">
              <a:extLst>
                <a:ext uri="{FF2B5EF4-FFF2-40B4-BE49-F238E27FC236}">
                  <a16:creationId xmlns:a16="http://schemas.microsoft.com/office/drawing/2014/main" id="{04C8D681-75D4-DD63-3F12-48C2D12F8D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57562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5" name="Line 134">
              <a:extLst>
                <a:ext uri="{FF2B5EF4-FFF2-40B4-BE49-F238E27FC236}">
                  <a16:creationId xmlns:a16="http://schemas.microsoft.com/office/drawing/2014/main" id="{6BA0113B-C589-D626-DFDD-3476B195CC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70071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6" name="Rectangle 135">
              <a:extLst>
                <a:ext uri="{FF2B5EF4-FFF2-40B4-BE49-F238E27FC236}">
                  <a16:creationId xmlns:a16="http://schemas.microsoft.com/office/drawing/2014/main" id="{CDF2E0E2-3FA5-79CB-DD1A-CD228269A1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566261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7" name="Line 136">
              <a:extLst>
                <a:ext uri="{FF2B5EF4-FFF2-40B4-BE49-F238E27FC236}">
                  <a16:creationId xmlns:a16="http://schemas.microsoft.com/office/drawing/2014/main" id="{DA8160F5-DCD4-8F86-5C55-CABA17CB56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60705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8" name="Rectangle 137">
              <a:extLst>
                <a:ext uri="{FF2B5EF4-FFF2-40B4-BE49-F238E27FC236}">
                  <a16:creationId xmlns:a16="http://schemas.microsoft.com/office/drawing/2014/main" id="{08A487CD-9C51-D979-DD29-4AB10BEDEF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5568950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9" name="Line 138">
              <a:extLst>
                <a:ext uri="{FF2B5EF4-FFF2-40B4-BE49-F238E27FC236}">
                  <a16:creationId xmlns:a16="http://schemas.microsoft.com/office/drawing/2014/main" id="{B2F68174-1615-184C-F28D-6BE7DCE5BA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51338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0" name="Rectangle 139">
              <a:extLst>
                <a:ext uri="{FF2B5EF4-FFF2-40B4-BE49-F238E27FC236}">
                  <a16:creationId xmlns:a16="http://schemas.microsoft.com/office/drawing/2014/main" id="{C514ED6D-5B39-4957-2187-506B93868A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5475288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1" name="Line 140">
              <a:extLst>
                <a:ext uri="{FF2B5EF4-FFF2-40B4-BE49-F238E27FC236}">
                  <a16:creationId xmlns:a16="http://schemas.microsoft.com/office/drawing/2014/main" id="{A9D193FF-8DAE-E2CC-EA97-DE7DA8961C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41972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2" name="Rectangle 141">
              <a:extLst>
                <a:ext uri="{FF2B5EF4-FFF2-40B4-BE49-F238E27FC236}">
                  <a16:creationId xmlns:a16="http://schemas.microsoft.com/office/drawing/2014/main" id="{E1883063-A425-15CD-DDFB-128F78B521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53816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3" name="Line 142">
              <a:extLst>
                <a:ext uri="{FF2B5EF4-FFF2-40B4-BE49-F238E27FC236}">
                  <a16:creationId xmlns:a16="http://schemas.microsoft.com/office/drawing/2014/main" id="{DEC56739-4884-F80B-D9EA-8C3A48FE2B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32606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4" name="Rectangle 143">
              <a:extLst>
                <a:ext uri="{FF2B5EF4-FFF2-40B4-BE49-F238E27FC236}">
                  <a16:creationId xmlns:a16="http://schemas.microsoft.com/office/drawing/2014/main" id="{B00F7A51-8781-BC5A-2347-EA54E4752A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52879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5" name="Line 144">
              <a:extLst>
                <a:ext uri="{FF2B5EF4-FFF2-40B4-BE49-F238E27FC236}">
                  <a16:creationId xmlns:a16="http://schemas.microsoft.com/office/drawing/2014/main" id="{2911DF0B-CC2C-00E5-BC8F-1DBFA78843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23240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" name="Rectangle 145">
              <a:extLst>
                <a:ext uri="{FF2B5EF4-FFF2-40B4-BE49-F238E27FC236}">
                  <a16:creationId xmlns:a16="http://schemas.microsoft.com/office/drawing/2014/main" id="{B1926A58-CBE3-E7B4-BD75-615BAB2F97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5194300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7" name="Line 146">
              <a:extLst>
                <a:ext uri="{FF2B5EF4-FFF2-40B4-BE49-F238E27FC236}">
                  <a16:creationId xmlns:a16="http://schemas.microsoft.com/office/drawing/2014/main" id="{684F3DC2-2432-5AE9-B037-69FD2161A3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13873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8" name="Rectangle 147">
              <a:extLst>
                <a:ext uri="{FF2B5EF4-FFF2-40B4-BE49-F238E27FC236}">
                  <a16:creationId xmlns:a16="http://schemas.microsoft.com/office/drawing/2014/main" id="{32787B5D-F7EC-39F9-D886-4823A5A19B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5100638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9" name="Line 148">
              <a:extLst>
                <a:ext uri="{FF2B5EF4-FFF2-40B4-BE49-F238E27FC236}">
                  <a16:creationId xmlns:a16="http://schemas.microsoft.com/office/drawing/2014/main" id="{531ECA19-B47E-401A-A011-B5F3806C3A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504507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0" name="Rectangle 149">
              <a:extLst>
                <a:ext uri="{FF2B5EF4-FFF2-40B4-BE49-F238E27FC236}">
                  <a16:creationId xmlns:a16="http://schemas.microsoft.com/office/drawing/2014/main" id="{0F44B685-4815-B02E-2006-1EE4B1AFFB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500697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1" name="Line 150">
              <a:extLst>
                <a:ext uri="{FF2B5EF4-FFF2-40B4-BE49-F238E27FC236}">
                  <a16:creationId xmlns:a16="http://schemas.microsoft.com/office/drawing/2014/main" id="{1FED7F8A-96BB-1C7C-1E9D-37446D5AB2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4951413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2" name="Rectangle 151">
              <a:extLst>
                <a:ext uri="{FF2B5EF4-FFF2-40B4-BE49-F238E27FC236}">
                  <a16:creationId xmlns:a16="http://schemas.microsoft.com/office/drawing/2014/main" id="{A09B4E11-10B1-0FDC-16FD-DC1D343929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491331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3" name="Line 152">
              <a:extLst>
                <a:ext uri="{FF2B5EF4-FFF2-40B4-BE49-F238E27FC236}">
                  <a16:creationId xmlns:a16="http://schemas.microsoft.com/office/drawing/2014/main" id="{0D5B6772-BC1C-7608-E524-B2BA134016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4857750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4" name="Rectangle 153">
              <a:extLst>
                <a:ext uri="{FF2B5EF4-FFF2-40B4-BE49-F238E27FC236}">
                  <a16:creationId xmlns:a16="http://schemas.microsoft.com/office/drawing/2014/main" id="{F956C7BC-5723-AEFF-D80B-F5959D3F7D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4819650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5" name="Line 154">
              <a:extLst>
                <a:ext uri="{FF2B5EF4-FFF2-40B4-BE49-F238E27FC236}">
                  <a16:creationId xmlns:a16="http://schemas.microsoft.com/office/drawing/2014/main" id="{3C14275B-3807-500E-CD1D-75163E8B19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4764088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6" name="Rectangle 155">
              <a:extLst>
                <a:ext uri="{FF2B5EF4-FFF2-40B4-BE49-F238E27FC236}">
                  <a16:creationId xmlns:a16="http://schemas.microsoft.com/office/drawing/2014/main" id="{436228F8-9999-C06B-014B-6492D40025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2" y="4725988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7" name="Line 156">
              <a:extLst>
                <a:ext uri="{FF2B5EF4-FFF2-40B4-BE49-F238E27FC236}">
                  <a16:creationId xmlns:a16="http://schemas.microsoft.com/office/drawing/2014/main" id="{2AA2B3C8-781A-C39C-266F-0F25A23B02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0225" y="4670425"/>
              <a:ext cx="2222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8" name="Rectangle 157">
              <a:extLst>
                <a:ext uri="{FF2B5EF4-FFF2-40B4-BE49-F238E27FC236}">
                  <a16:creationId xmlns:a16="http://schemas.microsoft.com/office/drawing/2014/main" id="{86D5B4B3-599C-5D7E-F434-B2869BC9D8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562" y="4632325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9" name="Rectangle 158">
              <a:extLst>
                <a:ext uri="{FF2B5EF4-FFF2-40B4-BE49-F238E27FC236}">
                  <a16:creationId xmlns:a16="http://schemas.microsoft.com/office/drawing/2014/main" id="{1A7F1154-9378-F8CE-0D89-A13E40E6F5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800" y="4451350"/>
              <a:ext cx="11372850" cy="22193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0" name="Rectangle 159">
              <a:extLst>
                <a:ext uri="{FF2B5EF4-FFF2-40B4-BE49-F238E27FC236}">
                  <a16:creationId xmlns:a16="http://schemas.microsoft.com/office/drawing/2014/main" id="{DE9C686F-2DBB-BE6E-C8C7-958C63D24E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912" y="4594225"/>
              <a:ext cx="11344275" cy="20431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1" name="Rectangle 160">
              <a:extLst>
                <a:ext uri="{FF2B5EF4-FFF2-40B4-BE49-F238E27FC236}">
                  <a16:creationId xmlns:a16="http://schemas.microsoft.com/office/drawing/2014/main" id="{8610422C-7C66-91AB-64E8-77E488ED27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025" y="4489450"/>
              <a:ext cx="247332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+ESI EIC(616.176140) Scan Frag=250.0V 20230203_041_Vayu RM_EEKB_H13.d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3" name="Freeform 162">
              <a:extLst>
                <a:ext uri="{FF2B5EF4-FFF2-40B4-BE49-F238E27FC236}">
                  <a16:creationId xmlns:a16="http://schemas.microsoft.com/office/drawing/2014/main" id="{9FACF473-CB54-4701-FCA7-C248C718ADD2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6900" y="4983163"/>
              <a:ext cx="350838" cy="1644650"/>
            </a:xfrm>
            <a:custGeom>
              <a:avLst/>
              <a:gdLst>
                <a:gd name="T0" fmla="*/ 0 w 221"/>
                <a:gd name="T1" fmla="*/ 1036 h 1036"/>
                <a:gd name="T2" fmla="*/ 17 w 221"/>
                <a:gd name="T3" fmla="*/ 1025 h 1036"/>
                <a:gd name="T4" fmla="*/ 34 w 221"/>
                <a:gd name="T5" fmla="*/ 605 h 1036"/>
                <a:gd name="T6" fmla="*/ 51 w 221"/>
                <a:gd name="T7" fmla="*/ 0 h 1036"/>
                <a:gd name="T8" fmla="*/ 68 w 221"/>
                <a:gd name="T9" fmla="*/ 220 h 1036"/>
                <a:gd name="T10" fmla="*/ 85 w 221"/>
                <a:gd name="T11" fmla="*/ 623 h 1036"/>
                <a:gd name="T12" fmla="*/ 102 w 221"/>
                <a:gd name="T13" fmla="*/ 833 h 1036"/>
                <a:gd name="T14" fmla="*/ 119 w 221"/>
                <a:gd name="T15" fmla="*/ 918 h 1036"/>
                <a:gd name="T16" fmla="*/ 136 w 221"/>
                <a:gd name="T17" fmla="*/ 965 h 1036"/>
                <a:gd name="T18" fmla="*/ 153 w 221"/>
                <a:gd name="T19" fmla="*/ 986 h 1036"/>
                <a:gd name="T20" fmla="*/ 170 w 221"/>
                <a:gd name="T21" fmla="*/ 1005 h 1036"/>
                <a:gd name="T22" fmla="*/ 187 w 221"/>
                <a:gd name="T23" fmla="*/ 1015 h 1036"/>
                <a:gd name="T24" fmla="*/ 204 w 221"/>
                <a:gd name="T25" fmla="*/ 1021 h 1036"/>
                <a:gd name="T26" fmla="*/ 221 w 221"/>
                <a:gd name="T27" fmla="*/ 1025 h 1036"/>
                <a:gd name="T28" fmla="*/ 221 w 221"/>
                <a:gd name="T29" fmla="*/ 1025 h 1036"/>
                <a:gd name="T30" fmla="*/ 221 w 221"/>
                <a:gd name="T31" fmla="*/ 1025 h 1036"/>
                <a:gd name="T32" fmla="*/ 0 w 221"/>
                <a:gd name="T33" fmla="*/ 1036 h 1036"/>
                <a:gd name="T34" fmla="*/ 0 w 221"/>
                <a:gd name="T35" fmla="*/ 1036 h 10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21" h="1036">
                  <a:moveTo>
                    <a:pt x="0" y="1036"/>
                  </a:moveTo>
                  <a:lnTo>
                    <a:pt x="17" y="1025"/>
                  </a:lnTo>
                  <a:lnTo>
                    <a:pt x="34" y="605"/>
                  </a:lnTo>
                  <a:lnTo>
                    <a:pt x="51" y="0"/>
                  </a:lnTo>
                  <a:lnTo>
                    <a:pt x="68" y="220"/>
                  </a:lnTo>
                  <a:lnTo>
                    <a:pt x="85" y="623"/>
                  </a:lnTo>
                  <a:lnTo>
                    <a:pt x="102" y="833"/>
                  </a:lnTo>
                  <a:lnTo>
                    <a:pt x="119" y="918"/>
                  </a:lnTo>
                  <a:lnTo>
                    <a:pt x="136" y="965"/>
                  </a:lnTo>
                  <a:lnTo>
                    <a:pt x="153" y="986"/>
                  </a:lnTo>
                  <a:lnTo>
                    <a:pt x="170" y="1005"/>
                  </a:lnTo>
                  <a:lnTo>
                    <a:pt x="187" y="1015"/>
                  </a:lnTo>
                  <a:lnTo>
                    <a:pt x="204" y="1021"/>
                  </a:lnTo>
                  <a:lnTo>
                    <a:pt x="221" y="1025"/>
                  </a:lnTo>
                  <a:lnTo>
                    <a:pt x="221" y="1025"/>
                  </a:lnTo>
                  <a:lnTo>
                    <a:pt x="221" y="1025"/>
                  </a:lnTo>
                  <a:lnTo>
                    <a:pt x="0" y="1036"/>
                  </a:lnTo>
                  <a:lnTo>
                    <a:pt x="0" y="1036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5" name="Freeform 164">
              <a:extLst>
                <a:ext uri="{FF2B5EF4-FFF2-40B4-BE49-F238E27FC236}">
                  <a16:creationId xmlns:a16="http://schemas.microsoft.com/office/drawing/2014/main" id="{6F526AE5-FEDD-3B48-948D-EC8F3B88D314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6900" y="6610350"/>
              <a:ext cx="350838" cy="17463"/>
            </a:xfrm>
            <a:custGeom>
              <a:avLst/>
              <a:gdLst>
                <a:gd name="T0" fmla="*/ 0 w 221"/>
                <a:gd name="T1" fmla="*/ 11 h 11"/>
                <a:gd name="T2" fmla="*/ 0 w 221"/>
                <a:gd name="T3" fmla="*/ 11 h 11"/>
                <a:gd name="T4" fmla="*/ 221 w 221"/>
                <a:gd name="T5" fmla="*/ 0 h 11"/>
                <a:gd name="T6" fmla="*/ 221 w 221"/>
                <a:gd name="T7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21" h="11">
                  <a:moveTo>
                    <a:pt x="0" y="11"/>
                  </a:moveTo>
                  <a:lnTo>
                    <a:pt x="0" y="11"/>
                  </a:lnTo>
                  <a:lnTo>
                    <a:pt x="221" y="0"/>
                  </a:lnTo>
                  <a:lnTo>
                    <a:pt x="221" y="0"/>
                  </a:ln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6" name="Freeform 165">
              <a:extLst>
                <a:ext uri="{FF2B5EF4-FFF2-40B4-BE49-F238E27FC236}">
                  <a16:creationId xmlns:a16="http://schemas.microsoft.com/office/drawing/2014/main" id="{D77E255C-8E3D-682B-B131-C4CF50F84126}"/>
                </a:ext>
              </a:extLst>
            </p:cNvPr>
            <p:cNvSpPr>
              <a:spLocks/>
            </p:cNvSpPr>
            <p:nvPr/>
          </p:nvSpPr>
          <p:spPr bwMode="auto">
            <a:xfrm>
              <a:off x="558800" y="4984750"/>
              <a:ext cx="6889750" cy="1652588"/>
            </a:xfrm>
            <a:custGeom>
              <a:avLst/>
              <a:gdLst>
                <a:gd name="T0" fmla="*/ 66 w 4340"/>
                <a:gd name="T1" fmla="*/ 1041 h 1041"/>
                <a:gd name="T2" fmla="*/ 152 w 4340"/>
                <a:gd name="T3" fmla="*/ 1041 h 1041"/>
                <a:gd name="T4" fmla="*/ 236 w 4340"/>
                <a:gd name="T5" fmla="*/ 1041 h 1041"/>
                <a:gd name="T6" fmla="*/ 322 w 4340"/>
                <a:gd name="T7" fmla="*/ 1041 h 1041"/>
                <a:gd name="T8" fmla="*/ 406 w 4340"/>
                <a:gd name="T9" fmla="*/ 1041 h 1041"/>
                <a:gd name="T10" fmla="*/ 489 w 4340"/>
                <a:gd name="T11" fmla="*/ 1041 h 1041"/>
                <a:gd name="T12" fmla="*/ 576 w 4340"/>
                <a:gd name="T13" fmla="*/ 1041 h 1041"/>
                <a:gd name="T14" fmla="*/ 659 w 4340"/>
                <a:gd name="T15" fmla="*/ 1041 h 1041"/>
                <a:gd name="T16" fmla="*/ 746 w 4340"/>
                <a:gd name="T17" fmla="*/ 1041 h 1041"/>
                <a:gd name="T18" fmla="*/ 829 w 4340"/>
                <a:gd name="T19" fmla="*/ 1041 h 1041"/>
                <a:gd name="T20" fmla="*/ 916 w 4340"/>
                <a:gd name="T21" fmla="*/ 1041 h 1041"/>
                <a:gd name="T22" fmla="*/ 999 w 4340"/>
                <a:gd name="T23" fmla="*/ 1041 h 1041"/>
                <a:gd name="T24" fmla="*/ 1086 w 4340"/>
                <a:gd name="T25" fmla="*/ 1041 h 1041"/>
                <a:gd name="T26" fmla="*/ 1169 w 4340"/>
                <a:gd name="T27" fmla="*/ 1041 h 1041"/>
                <a:gd name="T28" fmla="*/ 1252 w 4340"/>
                <a:gd name="T29" fmla="*/ 1041 h 1041"/>
                <a:gd name="T30" fmla="*/ 1339 w 4340"/>
                <a:gd name="T31" fmla="*/ 1041 h 1041"/>
                <a:gd name="T32" fmla="*/ 1422 w 4340"/>
                <a:gd name="T33" fmla="*/ 1041 h 1041"/>
                <a:gd name="T34" fmla="*/ 1509 w 4340"/>
                <a:gd name="T35" fmla="*/ 1041 h 1041"/>
                <a:gd name="T36" fmla="*/ 1592 w 4340"/>
                <a:gd name="T37" fmla="*/ 1041 h 1041"/>
                <a:gd name="T38" fmla="*/ 1679 w 4340"/>
                <a:gd name="T39" fmla="*/ 1041 h 1041"/>
                <a:gd name="T40" fmla="*/ 1762 w 4340"/>
                <a:gd name="T41" fmla="*/ 1041 h 1041"/>
                <a:gd name="T42" fmla="*/ 1849 w 4340"/>
                <a:gd name="T43" fmla="*/ 1041 h 1041"/>
                <a:gd name="T44" fmla="*/ 1932 w 4340"/>
                <a:gd name="T45" fmla="*/ 1041 h 1041"/>
                <a:gd name="T46" fmla="*/ 2019 w 4340"/>
                <a:gd name="T47" fmla="*/ 1041 h 1041"/>
                <a:gd name="T48" fmla="*/ 2102 w 4340"/>
                <a:gd name="T49" fmla="*/ 1041 h 1041"/>
                <a:gd name="T50" fmla="*/ 2185 w 4340"/>
                <a:gd name="T51" fmla="*/ 1041 h 1041"/>
                <a:gd name="T52" fmla="*/ 2272 w 4340"/>
                <a:gd name="T53" fmla="*/ 1041 h 1041"/>
                <a:gd name="T54" fmla="*/ 2355 w 4340"/>
                <a:gd name="T55" fmla="*/ 1038 h 1041"/>
                <a:gd name="T56" fmla="*/ 2442 w 4340"/>
                <a:gd name="T57" fmla="*/ 1024 h 1041"/>
                <a:gd name="T58" fmla="*/ 2525 w 4340"/>
                <a:gd name="T59" fmla="*/ 833 h 1041"/>
                <a:gd name="T60" fmla="*/ 2612 w 4340"/>
                <a:gd name="T61" fmla="*/ 1013 h 1041"/>
                <a:gd name="T62" fmla="*/ 2695 w 4340"/>
                <a:gd name="T63" fmla="*/ 1031 h 1041"/>
                <a:gd name="T64" fmla="*/ 2782 w 4340"/>
                <a:gd name="T65" fmla="*/ 1038 h 1041"/>
                <a:gd name="T66" fmla="*/ 2865 w 4340"/>
                <a:gd name="T67" fmla="*/ 1038 h 1041"/>
                <a:gd name="T68" fmla="*/ 2949 w 4340"/>
                <a:gd name="T69" fmla="*/ 1038 h 1041"/>
                <a:gd name="T70" fmla="*/ 3035 w 4340"/>
                <a:gd name="T71" fmla="*/ 1041 h 1041"/>
                <a:gd name="T72" fmla="*/ 3119 w 4340"/>
                <a:gd name="T73" fmla="*/ 1041 h 1041"/>
                <a:gd name="T74" fmla="*/ 3205 w 4340"/>
                <a:gd name="T75" fmla="*/ 1038 h 1041"/>
                <a:gd name="T76" fmla="*/ 3289 w 4340"/>
                <a:gd name="T77" fmla="*/ 1038 h 1041"/>
                <a:gd name="T78" fmla="*/ 3375 w 4340"/>
                <a:gd name="T79" fmla="*/ 1038 h 1041"/>
                <a:gd name="T80" fmla="*/ 3459 w 4340"/>
                <a:gd name="T81" fmla="*/ 1041 h 1041"/>
                <a:gd name="T82" fmla="*/ 3545 w 4340"/>
                <a:gd name="T83" fmla="*/ 1041 h 1041"/>
                <a:gd name="T84" fmla="*/ 3629 w 4340"/>
                <a:gd name="T85" fmla="*/ 1041 h 1041"/>
                <a:gd name="T86" fmla="*/ 3712 w 4340"/>
                <a:gd name="T87" fmla="*/ 1041 h 1041"/>
                <a:gd name="T88" fmla="*/ 3799 w 4340"/>
                <a:gd name="T89" fmla="*/ 1041 h 1041"/>
                <a:gd name="T90" fmla="*/ 3882 w 4340"/>
                <a:gd name="T91" fmla="*/ 1041 h 1041"/>
                <a:gd name="T92" fmla="*/ 3969 w 4340"/>
                <a:gd name="T93" fmla="*/ 1041 h 1041"/>
                <a:gd name="T94" fmla="*/ 4052 w 4340"/>
                <a:gd name="T95" fmla="*/ 1041 h 1041"/>
                <a:gd name="T96" fmla="*/ 4138 w 4340"/>
                <a:gd name="T97" fmla="*/ 1038 h 1041"/>
                <a:gd name="T98" fmla="*/ 4222 w 4340"/>
                <a:gd name="T99" fmla="*/ 1041 h 1041"/>
                <a:gd name="T100" fmla="*/ 4308 w 4340"/>
                <a:gd name="T101" fmla="*/ 1041 h 10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4340" h="1041">
                  <a:moveTo>
                    <a:pt x="0" y="1041"/>
                  </a:moveTo>
                  <a:lnTo>
                    <a:pt x="17" y="1041"/>
                  </a:lnTo>
                  <a:lnTo>
                    <a:pt x="31" y="1041"/>
                  </a:lnTo>
                  <a:lnTo>
                    <a:pt x="48" y="1041"/>
                  </a:lnTo>
                  <a:lnTo>
                    <a:pt x="66" y="1041"/>
                  </a:lnTo>
                  <a:lnTo>
                    <a:pt x="83" y="1041"/>
                  </a:lnTo>
                  <a:lnTo>
                    <a:pt x="100" y="1041"/>
                  </a:lnTo>
                  <a:lnTo>
                    <a:pt x="118" y="1041"/>
                  </a:lnTo>
                  <a:lnTo>
                    <a:pt x="135" y="1041"/>
                  </a:lnTo>
                  <a:lnTo>
                    <a:pt x="152" y="1041"/>
                  </a:lnTo>
                  <a:lnTo>
                    <a:pt x="170" y="1041"/>
                  </a:lnTo>
                  <a:lnTo>
                    <a:pt x="184" y="1041"/>
                  </a:lnTo>
                  <a:lnTo>
                    <a:pt x="201" y="1041"/>
                  </a:lnTo>
                  <a:lnTo>
                    <a:pt x="218" y="1041"/>
                  </a:lnTo>
                  <a:lnTo>
                    <a:pt x="236" y="1041"/>
                  </a:lnTo>
                  <a:lnTo>
                    <a:pt x="253" y="1041"/>
                  </a:lnTo>
                  <a:lnTo>
                    <a:pt x="270" y="1041"/>
                  </a:lnTo>
                  <a:lnTo>
                    <a:pt x="288" y="1041"/>
                  </a:lnTo>
                  <a:lnTo>
                    <a:pt x="305" y="1041"/>
                  </a:lnTo>
                  <a:lnTo>
                    <a:pt x="322" y="1041"/>
                  </a:lnTo>
                  <a:lnTo>
                    <a:pt x="336" y="1041"/>
                  </a:lnTo>
                  <a:lnTo>
                    <a:pt x="354" y="1041"/>
                  </a:lnTo>
                  <a:lnTo>
                    <a:pt x="371" y="1041"/>
                  </a:lnTo>
                  <a:lnTo>
                    <a:pt x="388" y="1041"/>
                  </a:lnTo>
                  <a:lnTo>
                    <a:pt x="406" y="1041"/>
                  </a:lnTo>
                  <a:lnTo>
                    <a:pt x="423" y="1041"/>
                  </a:lnTo>
                  <a:lnTo>
                    <a:pt x="440" y="1041"/>
                  </a:lnTo>
                  <a:lnTo>
                    <a:pt x="458" y="1041"/>
                  </a:lnTo>
                  <a:lnTo>
                    <a:pt x="475" y="1041"/>
                  </a:lnTo>
                  <a:lnTo>
                    <a:pt x="489" y="1041"/>
                  </a:lnTo>
                  <a:lnTo>
                    <a:pt x="506" y="1041"/>
                  </a:lnTo>
                  <a:lnTo>
                    <a:pt x="524" y="1041"/>
                  </a:lnTo>
                  <a:lnTo>
                    <a:pt x="541" y="1041"/>
                  </a:lnTo>
                  <a:lnTo>
                    <a:pt x="558" y="1041"/>
                  </a:lnTo>
                  <a:lnTo>
                    <a:pt x="576" y="1041"/>
                  </a:lnTo>
                  <a:lnTo>
                    <a:pt x="593" y="1041"/>
                  </a:lnTo>
                  <a:lnTo>
                    <a:pt x="610" y="1041"/>
                  </a:lnTo>
                  <a:lnTo>
                    <a:pt x="628" y="1041"/>
                  </a:lnTo>
                  <a:lnTo>
                    <a:pt x="642" y="1041"/>
                  </a:lnTo>
                  <a:lnTo>
                    <a:pt x="659" y="1041"/>
                  </a:lnTo>
                  <a:lnTo>
                    <a:pt x="676" y="1041"/>
                  </a:lnTo>
                  <a:lnTo>
                    <a:pt x="694" y="1041"/>
                  </a:lnTo>
                  <a:lnTo>
                    <a:pt x="711" y="1041"/>
                  </a:lnTo>
                  <a:lnTo>
                    <a:pt x="728" y="1041"/>
                  </a:lnTo>
                  <a:lnTo>
                    <a:pt x="746" y="1041"/>
                  </a:lnTo>
                  <a:lnTo>
                    <a:pt x="763" y="1041"/>
                  </a:lnTo>
                  <a:lnTo>
                    <a:pt x="780" y="1041"/>
                  </a:lnTo>
                  <a:lnTo>
                    <a:pt x="794" y="1041"/>
                  </a:lnTo>
                  <a:lnTo>
                    <a:pt x="812" y="1041"/>
                  </a:lnTo>
                  <a:lnTo>
                    <a:pt x="829" y="1041"/>
                  </a:lnTo>
                  <a:lnTo>
                    <a:pt x="846" y="1041"/>
                  </a:lnTo>
                  <a:lnTo>
                    <a:pt x="864" y="1041"/>
                  </a:lnTo>
                  <a:lnTo>
                    <a:pt x="881" y="1041"/>
                  </a:lnTo>
                  <a:lnTo>
                    <a:pt x="898" y="1041"/>
                  </a:lnTo>
                  <a:lnTo>
                    <a:pt x="916" y="1041"/>
                  </a:lnTo>
                  <a:lnTo>
                    <a:pt x="933" y="1041"/>
                  </a:lnTo>
                  <a:lnTo>
                    <a:pt x="947" y="1041"/>
                  </a:lnTo>
                  <a:lnTo>
                    <a:pt x="964" y="1041"/>
                  </a:lnTo>
                  <a:lnTo>
                    <a:pt x="982" y="1041"/>
                  </a:lnTo>
                  <a:lnTo>
                    <a:pt x="999" y="1041"/>
                  </a:lnTo>
                  <a:lnTo>
                    <a:pt x="1016" y="1041"/>
                  </a:lnTo>
                  <a:lnTo>
                    <a:pt x="1034" y="1041"/>
                  </a:lnTo>
                  <a:lnTo>
                    <a:pt x="1051" y="1041"/>
                  </a:lnTo>
                  <a:lnTo>
                    <a:pt x="1068" y="1041"/>
                  </a:lnTo>
                  <a:lnTo>
                    <a:pt x="1086" y="1041"/>
                  </a:lnTo>
                  <a:lnTo>
                    <a:pt x="1100" y="1041"/>
                  </a:lnTo>
                  <a:lnTo>
                    <a:pt x="1117" y="1041"/>
                  </a:lnTo>
                  <a:lnTo>
                    <a:pt x="1134" y="1041"/>
                  </a:lnTo>
                  <a:lnTo>
                    <a:pt x="1152" y="1041"/>
                  </a:lnTo>
                  <a:lnTo>
                    <a:pt x="1169" y="1041"/>
                  </a:lnTo>
                  <a:lnTo>
                    <a:pt x="1186" y="1041"/>
                  </a:lnTo>
                  <a:lnTo>
                    <a:pt x="1204" y="1041"/>
                  </a:lnTo>
                  <a:lnTo>
                    <a:pt x="1221" y="1041"/>
                  </a:lnTo>
                  <a:lnTo>
                    <a:pt x="1238" y="1041"/>
                  </a:lnTo>
                  <a:lnTo>
                    <a:pt x="1252" y="1041"/>
                  </a:lnTo>
                  <a:lnTo>
                    <a:pt x="1270" y="1041"/>
                  </a:lnTo>
                  <a:lnTo>
                    <a:pt x="1287" y="1041"/>
                  </a:lnTo>
                  <a:lnTo>
                    <a:pt x="1304" y="1041"/>
                  </a:lnTo>
                  <a:lnTo>
                    <a:pt x="1322" y="1041"/>
                  </a:lnTo>
                  <a:lnTo>
                    <a:pt x="1339" y="1041"/>
                  </a:lnTo>
                  <a:lnTo>
                    <a:pt x="1356" y="1041"/>
                  </a:lnTo>
                  <a:lnTo>
                    <a:pt x="1374" y="1041"/>
                  </a:lnTo>
                  <a:lnTo>
                    <a:pt x="1391" y="1041"/>
                  </a:lnTo>
                  <a:lnTo>
                    <a:pt x="1405" y="1041"/>
                  </a:lnTo>
                  <a:lnTo>
                    <a:pt x="1422" y="1041"/>
                  </a:lnTo>
                  <a:lnTo>
                    <a:pt x="1439" y="1041"/>
                  </a:lnTo>
                  <a:lnTo>
                    <a:pt x="1457" y="1041"/>
                  </a:lnTo>
                  <a:lnTo>
                    <a:pt x="1474" y="1041"/>
                  </a:lnTo>
                  <a:lnTo>
                    <a:pt x="1492" y="1041"/>
                  </a:lnTo>
                  <a:lnTo>
                    <a:pt x="1509" y="1041"/>
                  </a:lnTo>
                  <a:lnTo>
                    <a:pt x="1526" y="1041"/>
                  </a:lnTo>
                  <a:lnTo>
                    <a:pt x="1544" y="1041"/>
                  </a:lnTo>
                  <a:lnTo>
                    <a:pt x="1557" y="1041"/>
                  </a:lnTo>
                  <a:lnTo>
                    <a:pt x="1575" y="1041"/>
                  </a:lnTo>
                  <a:lnTo>
                    <a:pt x="1592" y="1041"/>
                  </a:lnTo>
                  <a:lnTo>
                    <a:pt x="1609" y="1041"/>
                  </a:lnTo>
                  <a:lnTo>
                    <a:pt x="1627" y="1041"/>
                  </a:lnTo>
                  <a:lnTo>
                    <a:pt x="1644" y="1041"/>
                  </a:lnTo>
                  <a:lnTo>
                    <a:pt x="1662" y="1041"/>
                  </a:lnTo>
                  <a:lnTo>
                    <a:pt x="1679" y="1041"/>
                  </a:lnTo>
                  <a:lnTo>
                    <a:pt x="1696" y="1041"/>
                  </a:lnTo>
                  <a:lnTo>
                    <a:pt x="1710" y="1041"/>
                  </a:lnTo>
                  <a:lnTo>
                    <a:pt x="1727" y="1041"/>
                  </a:lnTo>
                  <a:lnTo>
                    <a:pt x="1745" y="1041"/>
                  </a:lnTo>
                  <a:lnTo>
                    <a:pt x="1762" y="1041"/>
                  </a:lnTo>
                  <a:lnTo>
                    <a:pt x="1779" y="1041"/>
                  </a:lnTo>
                  <a:lnTo>
                    <a:pt x="1797" y="1041"/>
                  </a:lnTo>
                  <a:lnTo>
                    <a:pt x="1814" y="1041"/>
                  </a:lnTo>
                  <a:lnTo>
                    <a:pt x="1832" y="1041"/>
                  </a:lnTo>
                  <a:lnTo>
                    <a:pt x="1849" y="1041"/>
                  </a:lnTo>
                  <a:lnTo>
                    <a:pt x="1863" y="1041"/>
                  </a:lnTo>
                  <a:lnTo>
                    <a:pt x="1880" y="1041"/>
                  </a:lnTo>
                  <a:lnTo>
                    <a:pt x="1897" y="1041"/>
                  </a:lnTo>
                  <a:lnTo>
                    <a:pt x="1915" y="1041"/>
                  </a:lnTo>
                  <a:lnTo>
                    <a:pt x="1932" y="1041"/>
                  </a:lnTo>
                  <a:lnTo>
                    <a:pt x="1949" y="1041"/>
                  </a:lnTo>
                  <a:lnTo>
                    <a:pt x="1967" y="1041"/>
                  </a:lnTo>
                  <a:lnTo>
                    <a:pt x="1984" y="1041"/>
                  </a:lnTo>
                  <a:lnTo>
                    <a:pt x="2001" y="1041"/>
                  </a:lnTo>
                  <a:lnTo>
                    <a:pt x="2019" y="1041"/>
                  </a:lnTo>
                  <a:lnTo>
                    <a:pt x="2033" y="1041"/>
                  </a:lnTo>
                  <a:lnTo>
                    <a:pt x="2050" y="1041"/>
                  </a:lnTo>
                  <a:lnTo>
                    <a:pt x="2067" y="1041"/>
                  </a:lnTo>
                  <a:lnTo>
                    <a:pt x="2085" y="1041"/>
                  </a:lnTo>
                  <a:lnTo>
                    <a:pt x="2102" y="1041"/>
                  </a:lnTo>
                  <a:lnTo>
                    <a:pt x="2119" y="1041"/>
                  </a:lnTo>
                  <a:lnTo>
                    <a:pt x="2137" y="1041"/>
                  </a:lnTo>
                  <a:lnTo>
                    <a:pt x="2154" y="1041"/>
                  </a:lnTo>
                  <a:lnTo>
                    <a:pt x="2171" y="1041"/>
                  </a:lnTo>
                  <a:lnTo>
                    <a:pt x="2185" y="1041"/>
                  </a:lnTo>
                  <a:lnTo>
                    <a:pt x="2203" y="1041"/>
                  </a:lnTo>
                  <a:lnTo>
                    <a:pt x="2220" y="1041"/>
                  </a:lnTo>
                  <a:lnTo>
                    <a:pt x="2237" y="1041"/>
                  </a:lnTo>
                  <a:lnTo>
                    <a:pt x="2255" y="1041"/>
                  </a:lnTo>
                  <a:lnTo>
                    <a:pt x="2272" y="1041"/>
                  </a:lnTo>
                  <a:lnTo>
                    <a:pt x="2289" y="1041"/>
                  </a:lnTo>
                  <a:lnTo>
                    <a:pt x="2307" y="1031"/>
                  </a:lnTo>
                  <a:lnTo>
                    <a:pt x="2324" y="1031"/>
                  </a:lnTo>
                  <a:lnTo>
                    <a:pt x="2338" y="1034"/>
                  </a:lnTo>
                  <a:lnTo>
                    <a:pt x="2355" y="1038"/>
                  </a:lnTo>
                  <a:lnTo>
                    <a:pt x="2373" y="1034"/>
                  </a:lnTo>
                  <a:lnTo>
                    <a:pt x="2390" y="1034"/>
                  </a:lnTo>
                  <a:lnTo>
                    <a:pt x="2407" y="1034"/>
                  </a:lnTo>
                  <a:lnTo>
                    <a:pt x="2425" y="1034"/>
                  </a:lnTo>
                  <a:lnTo>
                    <a:pt x="2442" y="1024"/>
                  </a:lnTo>
                  <a:lnTo>
                    <a:pt x="2459" y="604"/>
                  </a:lnTo>
                  <a:lnTo>
                    <a:pt x="2477" y="0"/>
                  </a:lnTo>
                  <a:lnTo>
                    <a:pt x="2491" y="219"/>
                  </a:lnTo>
                  <a:lnTo>
                    <a:pt x="2508" y="621"/>
                  </a:lnTo>
                  <a:lnTo>
                    <a:pt x="2525" y="833"/>
                  </a:lnTo>
                  <a:lnTo>
                    <a:pt x="2543" y="916"/>
                  </a:lnTo>
                  <a:lnTo>
                    <a:pt x="2560" y="965"/>
                  </a:lnTo>
                  <a:lnTo>
                    <a:pt x="2577" y="986"/>
                  </a:lnTo>
                  <a:lnTo>
                    <a:pt x="2595" y="1003"/>
                  </a:lnTo>
                  <a:lnTo>
                    <a:pt x="2612" y="1013"/>
                  </a:lnTo>
                  <a:lnTo>
                    <a:pt x="2629" y="1020"/>
                  </a:lnTo>
                  <a:lnTo>
                    <a:pt x="2643" y="1024"/>
                  </a:lnTo>
                  <a:lnTo>
                    <a:pt x="2661" y="1024"/>
                  </a:lnTo>
                  <a:lnTo>
                    <a:pt x="2678" y="1031"/>
                  </a:lnTo>
                  <a:lnTo>
                    <a:pt x="2695" y="1031"/>
                  </a:lnTo>
                  <a:lnTo>
                    <a:pt x="2713" y="1034"/>
                  </a:lnTo>
                  <a:lnTo>
                    <a:pt x="2730" y="1034"/>
                  </a:lnTo>
                  <a:lnTo>
                    <a:pt x="2747" y="1034"/>
                  </a:lnTo>
                  <a:lnTo>
                    <a:pt x="2765" y="1038"/>
                  </a:lnTo>
                  <a:lnTo>
                    <a:pt x="2782" y="1038"/>
                  </a:lnTo>
                  <a:lnTo>
                    <a:pt x="2796" y="1038"/>
                  </a:lnTo>
                  <a:lnTo>
                    <a:pt x="2813" y="1038"/>
                  </a:lnTo>
                  <a:lnTo>
                    <a:pt x="2831" y="1038"/>
                  </a:lnTo>
                  <a:lnTo>
                    <a:pt x="2848" y="1038"/>
                  </a:lnTo>
                  <a:lnTo>
                    <a:pt x="2865" y="1038"/>
                  </a:lnTo>
                  <a:lnTo>
                    <a:pt x="2883" y="1038"/>
                  </a:lnTo>
                  <a:lnTo>
                    <a:pt x="2900" y="1038"/>
                  </a:lnTo>
                  <a:lnTo>
                    <a:pt x="2917" y="1038"/>
                  </a:lnTo>
                  <a:lnTo>
                    <a:pt x="2935" y="1038"/>
                  </a:lnTo>
                  <a:lnTo>
                    <a:pt x="2949" y="1038"/>
                  </a:lnTo>
                  <a:lnTo>
                    <a:pt x="2966" y="1038"/>
                  </a:lnTo>
                  <a:lnTo>
                    <a:pt x="2983" y="1038"/>
                  </a:lnTo>
                  <a:lnTo>
                    <a:pt x="3001" y="1038"/>
                  </a:lnTo>
                  <a:lnTo>
                    <a:pt x="3018" y="1041"/>
                  </a:lnTo>
                  <a:lnTo>
                    <a:pt x="3035" y="1041"/>
                  </a:lnTo>
                  <a:lnTo>
                    <a:pt x="3053" y="1038"/>
                  </a:lnTo>
                  <a:lnTo>
                    <a:pt x="3070" y="1038"/>
                  </a:lnTo>
                  <a:lnTo>
                    <a:pt x="3087" y="1038"/>
                  </a:lnTo>
                  <a:lnTo>
                    <a:pt x="3101" y="1038"/>
                  </a:lnTo>
                  <a:lnTo>
                    <a:pt x="3119" y="1041"/>
                  </a:lnTo>
                  <a:lnTo>
                    <a:pt x="3136" y="1038"/>
                  </a:lnTo>
                  <a:lnTo>
                    <a:pt x="3153" y="1041"/>
                  </a:lnTo>
                  <a:lnTo>
                    <a:pt x="3171" y="1041"/>
                  </a:lnTo>
                  <a:lnTo>
                    <a:pt x="3188" y="1041"/>
                  </a:lnTo>
                  <a:lnTo>
                    <a:pt x="3205" y="1038"/>
                  </a:lnTo>
                  <a:lnTo>
                    <a:pt x="3223" y="1041"/>
                  </a:lnTo>
                  <a:lnTo>
                    <a:pt x="3240" y="1038"/>
                  </a:lnTo>
                  <a:lnTo>
                    <a:pt x="3254" y="1041"/>
                  </a:lnTo>
                  <a:lnTo>
                    <a:pt x="3271" y="1041"/>
                  </a:lnTo>
                  <a:lnTo>
                    <a:pt x="3289" y="1038"/>
                  </a:lnTo>
                  <a:lnTo>
                    <a:pt x="3306" y="1038"/>
                  </a:lnTo>
                  <a:lnTo>
                    <a:pt x="3323" y="1038"/>
                  </a:lnTo>
                  <a:lnTo>
                    <a:pt x="3341" y="1041"/>
                  </a:lnTo>
                  <a:lnTo>
                    <a:pt x="3358" y="1038"/>
                  </a:lnTo>
                  <a:lnTo>
                    <a:pt x="3375" y="1038"/>
                  </a:lnTo>
                  <a:lnTo>
                    <a:pt x="3393" y="1041"/>
                  </a:lnTo>
                  <a:lnTo>
                    <a:pt x="3407" y="1041"/>
                  </a:lnTo>
                  <a:lnTo>
                    <a:pt x="3424" y="1041"/>
                  </a:lnTo>
                  <a:lnTo>
                    <a:pt x="3441" y="1041"/>
                  </a:lnTo>
                  <a:lnTo>
                    <a:pt x="3459" y="1041"/>
                  </a:lnTo>
                  <a:lnTo>
                    <a:pt x="3476" y="1041"/>
                  </a:lnTo>
                  <a:lnTo>
                    <a:pt x="3493" y="1041"/>
                  </a:lnTo>
                  <a:lnTo>
                    <a:pt x="3511" y="1041"/>
                  </a:lnTo>
                  <a:lnTo>
                    <a:pt x="3528" y="1041"/>
                  </a:lnTo>
                  <a:lnTo>
                    <a:pt x="3545" y="1041"/>
                  </a:lnTo>
                  <a:lnTo>
                    <a:pt x="3559" y="1041"/>
                  </a:lnTo>
                  <a:lnTo>
                    <a:pt x="3576" y="1041"/>
                  </a:lnTo>
                  <a:lnTo>
                    <a:pt x="3594" y="1041"/>
                  </a:lnTo>
                  <a:lnTo>
                    <a:pt x="3611" y="1041"/>
                  </a:lnTo>
                  <a:lnTo>
                    <a:pt x="3629" y="1041"/>
                  </a:lnTo>
                  <a:lnTo>
                    <a:pt x="3646" y="1041"/>
                  </a:lnTo>
                  <a:lnTo>
                    <a:pt x="3663" y="1041"/>
                  </a:lnTo>
                  <a:lnTo>
                    <a:pt x="3681" y="1041"/>
                  </a:lnTo>
                  <a:lnTo>
                    <a:pt x="3698" y="1041"/>
                  </a:lnTo>
                  <a:lnTo>
                    <a:pt x="3712" y="1041"/>
                  </a:lnTo>
                  <a:lnTo>
                    <a:pt x="3729" y="1041"/>
                  </a:lnTo>
                  <a:lnTo>
                    <a:pt x="3746" y="1041"/>
                  </a:lnTo>
                  <a:lnTo>
                    <a:pt x="3764" y="1041"/>
                  </a:lnTo>
                  <a:lnTo>
                    <a:pt x="3781" y="1041"/>
                  </a:lnTo>
                  <a:lnTo>
                    <a:pt x="3799" y="1041"/>
                  </a:lnTo>
                  <a:lnTo>
                    <a:pt x="3816" y="1041"/>
                  </a:lnTo>
                  <a:lnTo>
                    <a:pt x="3833" y="1041"/>
                  </a:lnTo>
                  <a:lnTo>
                    <a:pt x="3851" y="1041"/>
                  </a:lnTo>
                  <a:lnTo>
                    <a:pt x="3864" y="1041"/>
                  </a:lnTo>
                  <a:lnTo>
                    <a:pt x="3882" y="1041"/>
                  </a:lnTo>
                  <a:lnTo>
                    <a:pt x="3899" y="1041"/>
                  </a:lnTo>
                  <a:lnTo>
                    <a:pt x="3916" y="1041"/>
                  </a:lnTo>
                  <a:lnTo>
                    <a:pt x="3934" y="1041"/>
                  </a:lnTo>
                  <a:lnTo>
                    <a:pt x="3951" y="1041"/>
                  </a:lnTo>
                  <a:lnTo>
                    <a:pt x="3969" y="1041"/>
                  </a:lnTo>
                  <a:lnTo>
                    <a:pt x="3986" y="1041"/>
                  </a:lnTo>
                  <a:lnTo>
                    <a:pt x="4003" y="1041"/>
                  </a:lnTo>
                  <a:lnTo>
                    <a:pt x="4017" y="1041"/>
                  </a:lnTo>
                  <a:lnTo>
                    <a:pt x="4034" y="1041"/>
                  </a:lnTo>
                  <a:lnTo>
                    <a:pt x="4052" y="1041"/>
                  </a:lnTo>
                  <a:lnTo>
                    <a:pt x="4069" y="1038"/>
                  </a:lnTo>
                  <a:lnTo>
                    <a:pt x="4086" y="1041"/>
                  </a:lnTo>
                  <a:lnTo>
                    <a:pt x="4104" y="1038"/>
                  </a:lnTo>
                  <a:lnTo>
                    <a:pt x="4121" y="1038"/>
                  </a:lnTo>
                  <a:lnTo>
                    <a:pt x="4138" y="1038"/>
                  </a:lnTo>
                  <a:lnTo>
                    <a:pt x="4156" y="1038"/>
                  </a:lnTo>
                  <a:lnTo>
                    <a:pt x="4170" y="1038"/>
                  </a:lnTo>
                  <a:lnTo>
                    <a:pt x="4187" y="1038"/>
                  </a:lnTo>
                  <a:lnTo>
                    <a:pt x="4204" y="1041"/>
                  </a:lnTo>
                  <a:lnTo>
                    <a:pt x="4222" y="1041"/>
                  </a:lnTo>
                  <a:lnTo>
                    <a:pt x="4239" y="1041"/>
                  </a:lnTo>
                  <a:lnTo>
                    <a:pt x="4256" y="1041"/>
                  </a:lnTo>
                  <a:lnTo>
                    <a:pt x="4274" y="1041"/>
                  </a:lnTo>
                  <a:lnTo>
                    <a:pt x="4291" y="1041"/>
                  </a:lnTo>
                  <a:lnTo>
                    <a:pt x="4308" y="1041"/>
                  </a:lnTo>
                  <a:lnTo>
                    <a:pt x="4322" y="1041"/>
                  </a:lnTo>
                  <a:lnTo>
                    <a:pt x="4340" y="104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7" name="Rectangle 166">
              <a:extLst>
                <a:ext uri="{FF2B5EF4-FFF2-40B4-BE49-F238E27FC236}">
                  <a16:creationId xmlns:a16="http://schemas.microsoft.com/office/drawing/2014/main" id="{484208A7-33FF-6983-8887-A27A3F056B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7594" y="4809868"/>
              <a:ext cx="67326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2" charset="0"/>
                </a:rPr>
                <a:t>2.879 min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endParaRPr>
            </a:p>
          </p:txBody>
        </p:sp>
        <p:sp>
          <p:nvSpPr>
            <p:cNvPr id="298" name="Rectangle 167">
              <a:extLst>
                <a:ext uri="{FF2B5EF4-FFF2-40B4-BE49-F238E27FC236}">
                  <a16:creationId xmlns:a16="http://schemas.microsoft.com/office/drawing/2014/main" id="{088783DD-B3E9-F2A8-F48F-A7C34E0BE8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562" y="4456113"/>
              <a:ext cx="11361738" cy="2209800"/>
            </a:xfrm>
            <a:prstGeom prst="rect">
              <a:avLst/>
            </a:prstGeom>
            <a:noFill/>
            <a:ln w="11113" cap="flat">
              <a:solidFill>
                <a:srgbClr val="F0F0F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9" name="Rectangle 168">
              <a:extLst>
                <a:ext uri="{FF2B5EF4-FFF2-40B4-BE49-F238E27FC236}">
                  <a16:creationId xmlns:a16="http://schemas.microsoft.com/office/drawing/2014/main" id="{C29F4E76-8612-C865-E1F1-6B1A4218B9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912" y="4594225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808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3" name="Line 172">
              <a:extLst>
                <a:ext uri="{FF2B5EF4-FFF2-40B4-BE49-F238E27FC236}">
                  <a16:creationId xmlns:a16="http://schemas.microsoft.com/office/drawing/2014/main" id="{AFB47047-4A98-4E92-6CFE-E693D0CBC5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9912" y="6675438"/>
              <a:ext cx="11344275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4" name="Line 173">
              <a:extLst>
                <a:ext uri="{FF2B5EF4-FFF2-40B4-BE49-F238E27FC236}">
                  <a16:creationId xmlns:a16="http://schemas.microsoft.com/office/drawing/2014/main" id="{C0F1B0C2-6E41-5CFD-E2B2-1ECF0BE0AA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0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5" name="Line 174">
              <a:extLst>
                <a:ext uri="{FF2B5EF4-FFF2-40B4-BE49-F238E27FC236}">
                  <a16:creationId xmlns:a16="http://schemas.microsoft.com/office/drawing/2014/main" id="{79CE019D-E47B-FCE1-597B-8268B2EEA3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61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6" name="Rectangle 175">
              <a:extLst>
                <a:ext uri="{FF2B5EF4-FFF2-40B4-BE49-F238E27FC236}">
                  <a16:creationId xmlns:a16="http://schemas.microsoft.com/office/drawing/2014/main" id="{34CC693B-AE6E-0BFF-6A15-EA9BC6A1D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6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7" name="Line 176">
              <a:extLst>
                <a:ext uri="{FF2B5EF4-FFF2-40B4-BE49-F238E27FC236}">
                  <a16:creationId xmlns:a16="http://schemas.microsoft.com/office/drawing/2014/main" id="{06E83971-783F-C061-5B65-71BE995C9E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26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8" name="Rectangle 177">
              <a:extLst>
                <a:ext uri="{FF2B5EF4-FFF2-40B4-BE49-F238E27FC236}">
                  <a16:creationId xmlns:a16="http://schemas.microsoft.com/office/drawing/2014/main" id="{EAA3B3F7-7E3F-5C46-359B-6A0CBBD6B6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7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9" name="Line 178">
              <a:extLst>
                <a:ext uri="{FF2B5EF4-FFF2-40B4-BE49-F238E27FC236}">
                  <a16:creationId xmlns:a16="http://schemas.microsoft.com/office/drawing/2014/main" id="{7B656B7E-F360-7768-9B32-6A9F87F8C9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1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" name="Rectangle 179">
              <a:extLst>
                <a:ext uri="{FF2B5EF4-FFF2-40B4-BE49-F238E27FC236}">
                  <a16:creationId xmlns:a16="http://schemas.microsoft.com/office/drawing/2014/main" id="{4F5CEEFB-9D9C-0592-1606-53E3E4FAFB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26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1" name="Line 180">
              <a:extLst>
                <a:ext uri="{FF2B5EF4-FFF2-40B4-BE49-F238E27FC236}">
                  <a16:creationId xmlns:a16="http://schemas.microsoft.com/office/drawing/2014/main" id="{517ADE3F-C2B3-CDE6-B5B5-810D3373F6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636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2" name="Rectangle 181">
              <a:extLst>
                <a:ext uri="{FF2B5EF4-FFF2-40B4-BE49-F238E27FC236}">
                  <a16:creationId xmlns:a16="http://schemas.microsoft.com/office/drawing/2014/main" id="{8CA1999D-636F-5FF6-FDFB-B8CB26CA57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07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3" name="Line 182">
              <a:extLst>
                <a:ext uri="{FF2B5EF4-FFF2-40B4-BE49-F238E27FC236}">
                  <a16:creationId xmlns:a16="http://schemas.microsoft.com/office/drawing/2014/main" id="{2F4B2648-441C-E60F-C1C1-766AFC8136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017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4" name="Rectangle 183">
              <a:extLst>
                <a:ext uri="{FF2B5EF4-FFF2-40B4-BE49-F238E27FC236}">
                  <a16:creationId xmlns:a16="http://schemas.microsoft.com/office/drawing/2014/main" id="{874357B6-3B03-099B-A96D-2BBA40A776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3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5" name="Line 184">
              <a:extLst>
                <a:ext uri="{FF2B5EF4-FFF2-40B4-BE49-F238E27FC236}">
                  <a16:creationId xmlns:a16="http://schemas.microsoft.com/office/drawing/2014/main" id="{6C39DE9F-39A3-39B8-C6D7-3B5F99CC5E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46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6" name="Rectangle 185">
              <a:extLst>
                <a:ext uri="{FF2B5EF4-FFF2-40B4-BE49-F238E27FC236}">
                  <a16:creationId xmlns:a16="http://schemas.microsoft.com/office/drawing/2014/main" id="{A980E3BD-EB92-D787-E05F-733ECEEC97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17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7" name="Line 186">
              <a:extLst>
                <a:ext uri="{FF2B5EF4-FFF2-40B4-BE49-F238E27FC236}">
                  <a16:creationId xmlns:a16="http://schemas.microsoft.com/office/drawing/2014/main" id="{453C963C-C405-7605-FFA3-7C128E5D08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27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" name="Rectangle 187">
              <a:extLst>
                <a:ext uri="{FF2B5EF4-FFF2-40B4-BE49-F238E27FC236}">
                  <a16:creationId xmlns:a16="http://schemas.microsoft.com/office/drawing/2014/main" id="{97C80376-0329-C235-4119-05A40D28B3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82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9" name="Line 188">
              <a:extLst>
                <a:ext uri="{FF2B5EF4-FFF2-40B4-BE49-F238E27FC236}">
                  <a16:creationId xmlns:a16="http://schemas.microsoft.com/office/drawing/2014/main" id="{A2E0B040-2D11-EA8C-1E41-07AABEA108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208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" name="Rectangle 189">
              <a:extLst>
                <a:ext uri="{FF2B5EF4-FFF2-40B4-BE49-F238E27FC236}">
                  <a16:creationId xmlns:a16="http://schemas.microsoft.com/office/drawing/2014/main" id="{5F0ECE4A-4C92-63D1-3D37-D18E2CAD6C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64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1" name="Line 190">
              <a:extLst>
                <a:ext uri="{FF2B5EF4-FFF2-40B4-BE49-F238E27FC236}">
                  <a16:creationId xmlns:a16="http://schemas.microsoft.com/office/drawing/2014/main" id="{8CDBC025-288E-FB98-03A6-E5C0A513EA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37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" name="Rectangle 191">
              <a:extLst>
                <a:ext uri="{FF2B5EF4-FFF2-40B4-BE49-F238E27FC236}">
                  <a16:creationId xmlns:a16="http://schemas.microsoft.com/office/drawing/2014/main" id="{7FA9A7BD-96F4-2604-1E4A-71C62994D4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7850" y="66976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3" name="Line 192">
              <a:extLst>
                <a:ext uri="{FF2B5EF4-FFF2-40B4-BE49-F238E27FC236}">
                  <a16:creationId xmlns:a16="http://schemas.microsoft.com/office/drawing/2014/main" id="{CE90058A-DAFC-4D8C-D052-7A076BBA27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018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4" name="Rectangle 193">
              <a:extLst>
                <a:ext uri="{FF2B5EF4-FFF2-40B4-BE49-F238E27FC236}">
                  <a16:creationId xmlns:a16="http://schemas.microsoft.com/office/drawing/2014/main" id="{4AB0DD24-8C8B-9AED-F1E8-125EC007B0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73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5" name="Line 194">
              <a:extLst>
                <a:ext uri="{FF2B5EF4-FFF2-40B4-BE49-F238E27FC236}">
                  <a16:creationId xmlns:a16="http://schemas.microsoft.com/office/drawing/2014/main" id="{CF9AFF81-55B9-9D32-3482-35551B4E3D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447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6" name="Rectangle 195">
              <a:extLst>
                <a:ext uri="{FF2B5EF4-FFF2-40B4-BE49-F238E27FC236}">
                  <a16:creationId xmlns:a16="http://schemas.microsoft.com/office/drawing/2014/main" id="{D51B8FE3-46F1-0C8E-9D63-D26B8D03F7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02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7" name="Line 196">
              <a:extLst>
                <a:ext uri="{FF2B5EF4-FFF2-40B4-BE49-F238E27FC236}">
                  <a16:creationId xmlns:a16="http://schemas.microsoft.com/office/drawing/2014/main" id="{2856AD89-25AD-EDB1-FE3D-88032E75BA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28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8" name="Rectangle 197">
              <a:extLst>
                <a:ext uri="{FF2B5EF4-FFF2-40B4-BE49-F238E27FC236}">
                  <a16:creationId xmlns:a16="http://schemas.microsoft.com/office/drawing/2014/main" id="{7995654F-63D2-E654-A946-E3A16C55E2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83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9" name="Line 198">
              <a:extLst>
                <a:ext uri="{FF2B5EF4-FFF2-40B4-BE49-F238E27FC236}">
                  <a16:creationId xmlns:a16="http://schemas.microsoft.com/office/drawing/2014/main" id="{64FED7A4-E45B-5819-395D-2C8DEB5EB1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193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0" name="Rectangle 199">
              <a:extLst>
                <a:ext uri="{FF2B5EF4-FFF2-40B4-BE49-F238E27FC236}">
                  <a16:creationId xmlns:a16="http://schemas.microsoft.com/office/drawing/2014/main" id="{627D0FF1-1547-2791-1A53-DE606596FA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64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1" name="Line 200">
              <a:extLst>
                <a:ext uri="{FF2B5EF4-FFF2-40B4-BE49-F238E27FC236}">
                  <a16:creationId xmlns:a16="http://schemas.microsoft.com/office/drawing/2014/main" id="{9BA08D06-39D4-7E53-805A-EF8D3A8476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38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2" name="Rectangle 201">
              <a:extLst>
                <a:ext uri="{FF2B5EF4-FFF2-40B4-BE49-F238E27FC236}">
                  <a16:creationId xmlns:a16="http://schemas.microsoft.com/office/drawing/2014/main" id="{F592C252-32EB-936E-7C64-C0B992810A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93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3" name="Line 202">
              <a:extLst>
                <a:ext uri="{FF2B5EF4-FFF2-40B4-BE49-F238E27FC236}">
                  <a16:creationId xmlns:a16="http://schemas.microsoft.com/office/drawing/2014/main" id="{29F2594D-5E59-331A-5B67-D2ECC65CBE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03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4" name="Rectangle 203">
              <a:extLst>
                <a:ext uri="{FF2B5EF4-FFF2-40B4-BE49-F238E27FC236}">
                  <a16:creationId xmlns:a16="http://schemas.microsoft.com/office/drawing/2014/main" id="{B59D4D7B-6C23-0D73-67B9-4DD94E4D08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74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5" name="Line 204">
              <a:extLst>
                <a:ext uri="{FF2B5EF4-FFF2-40B4-BE49-F238E27FC236}">
                  <a16:creationId xmlns:a16="http://schemas.microsoft.com/office/drawing/2014/main" id="{3F2F1C6D-53F2-7915-2BE1-D6F2C4D740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84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" name="Rectangle 206">
              <a:extLst>
                <a:ext uri="{FF2B5EF4-FFF2-40B4-BE49-F238E27FC236}">
                  <a16:creationId xmlns:a16="http://schemas.microsoft.com/office/drawing/2014/main" id="{7FE0C642-2BFA-219A-050B-7A0021D2EE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40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Line 207">
              <a:extLst>
                <a:ext uri="{FF2B5EF4-FFF2-40B4-BE49-F238E27FC236}">
                  <a16:creationId xmlns:a16="http://schemas.microsoft.com/office/drawing/2014/main" id="{165BAEB2-F192-7EF9-D3ED-221AF11BD2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13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Rectangle 208">
              <a:extLst>
                <a:ext uri="{FF2B5EF4-FFF2-40B4-BE49-F238E27FC236}">
                  <a16:creationId xmlns:a16="http://schemas.microsoft.com/office/drawing/2014/main" id="{C8809DB4-24E9-085C-5D63-58D74E301C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68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Line 209">
              <a:extLst>
                <a:ext uri="{FF2B5EF4-FFF2-40B4-BE49-F238E27FC236}">
                  <a16:creationId xmlns:a16="http://schemas.microsoft.com/office/drawing/2014/main" id="{186B78A1-BB07-53B2-B504-28FE7F1A30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94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210">
              <a:extLst>
                <a:ext uri="{FF2B5EF4-FFF2-40B4-BE49-F238E27FC236}">
                  <a16:creationId xmlns:a16="http://schemas.microsoft.com/office/drawing/2014/main" id="{9ECA2D4F-CA23-92E0-F007-BFAA1C4034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9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Line 211">
              <a:extLst>
                <a:ext uri="{FF2B5EF4-FFF2-40B4-BE49-F238E27FC236}">
                  <a16:creationId xmlns:a16="http://schemas.microsoft.com/office/drawing/2014/main" id="{69F2580A-FF68-BFBF-5492-BB76880271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75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212">
              <a:extLst>
                <a:ext uri="{FF2B5EF4-FFF2-40B4-BE49-F238E27FC236}">
                  <a16:creationId xmlns:a16="http://schemas.microsoft.com/office/drawing/2014/main" id="{CF2552E2-0FBE-631A-5FD4-CF73B9BC0A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0087" y="66976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Line 213">
              <a:extLst>
                <a:ext uri="{FF2B5EF4-FFF2-40B4-BE49-F238E27FC236}">
                  <a16:creationId xmlns:a16="http://schemas.microsoft.com/office/drawing/2014/main" id="{6A6024DA-9409-21AB-2087-591865AAEF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04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Rectangle 214">
              <a:extLst>
                <a:ext uri="{FF2B5EF4-FFF2-40B4-BE49-F238E27FC236}">
                  <a16:creationId xmlns:a16="http://schemas.microsoft.com/office/drawing/2014/main" id="{BEE79DA1-5E28-CF35-8287-96E5D2BE65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59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Line 215">
              <a:extLst>
                <a:ext uri="{FF2B5EF4-FFF2-40B4-BE49-F238E27FC236}">
                  <a16:creationId xmlns:a16="http://schemas.microsoft.com/office/drawing/2014/main" id="{AE4FB17E-B3CC-D3BF-C6EF-787B747FEA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85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Rectangle 216">
              <a:extLst>
                <a:ext uri="{FF2B5EF4-FFF2-40B4-BE49-F238E27FC236}">
                  <a16:creationId xmlns:a16="http://schemas.microsoft.com/office/drawing/2014/main" id="{8E124DD0-418E-2409-F589-BD082EDEA2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40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Line 217">
              <a:extLst>
                <a:ext uri="{FF2B5EF4-FFF2-40B4-BE49-F238E27FC236}">
                  <a16:creationId xmlns:a16="http://schemas.microsoft.com/office/drawing/2014/main" id="{DB6FCA7D-CE5E-5BC3-C888-8765D0BBEE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14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Rectangle 218">
              <a:extLst>
                <a:ext uri="{FF2B5EF4-FFF2-40B4-BE49-F238E27FC236}">
                  <a16:creationId xmlns:a16="http://schemas.microsoft.com/office/drawing/2014/main" id="{8BF9850F-3E78-8B89-C94F-D93D81E474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69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Line 219">
              <a:extLst>
                <a:ext uri="{FF2B5EF4-FFF2-40B4-BE49-F238E27FC236}">
                  <a16:creationId xmlns:a16="http://schemas.microsoft.com/office/drawing/2014/main" id="{142342AF-37F6-F4AF-AE3F-AFD91585E8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195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220">
              <a:extLst>
                <a:ext uri="{FF2B5EF4-FFF2-40B4-BE49-F238E27FC236}">
                  <a16:creationId xmlns:a16="http://schemas.microsoft.com/office/drawing/2014/main" id="{014372B7-FC71-AAC4-C03F-2B096104FC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50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Line 221">
              <a:extLst>
                <a:ext uri="{FF2B5EF4-FFF2-40B4-BE49-F238E27FC236}">
                  <a16:creationId xmlns:a16="http://schemas.microsoft.com/office/drawing/2014/main" id="{28024EC3-254E-4BC5-8364-E5BE585340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60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222">
              <a:extLst>
                <a:ext uri="{FF2B5EF4-FFF2-40B4-BE49-F238E27FC236}">
                  <a16:creationId xmlns:a16="http://schemas.microsoft.com/office/drawing/2014/main" id="{6EB21825-BA83-F0D7-350A-1AD80836BE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31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Line 223">
              <a:extLst>
                <a:ext uri="{FF2B5EF4-FFF2-40B4-BE49-F238E27FC236}">
                  <a16:creationId xmlns:a16="http://schemas.microsoft.com/office/drawing/2014/main" id="{6E194B60-168B-A677-2009-1EA0436E69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989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Rectangle 224">
              <a:extLst>
                <a:ext uri="{FF2B5EF4-FFF2-40B4-BE49-F238E27FC236}">
                  <a16:creationId xmlns:a16="http://schemas.microsoft.com/office/drawing/2014/main" id="{1B5741F5-FD1F-D8C5-21EF-EEE8C332DE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60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Line 225">
              <a:extLst>
                <a:ext uri="{FF2B5EF4-FFF2-40B4-BE49-F238E27FC236}">
                  <a16:creationId xmlns:a16="http://schemas.microsoft.com/office/drawing/2014/main" id="{2E804421-9205-95E7-1DB4-8E6F887732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370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Rectangle 226">
              <a:extLst>
                <a:ext uri="{FF2B5EF4-FFF2-40B4-BE49-F238E27FC236}">
                  <a16:creationId xmlns:a16="http://schemas.microsoft.com/office/drawing/2014/main" id="{925A1255-938E-7157-2400-CBEE349A94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25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Line 227">
              <a:extLst>
                <a:ext uri="{FF2B5EF4-FFF2-40B4-BE49-F238E27FC236}">
                  <a16:creationId xmlns:a16="http://schemas.microsoft.com/office/drawing/2014/main" id="{6B7A342D-A5DC-4B17-DF56-54BD7DCFB5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751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Rectangle 228">
              <a:extLst>
                <a:ext uri="{FF2B5EF4-FFF2-40B4-BE49-F238E27FC236}">
                  <a16:creationId xmlns:a16="http://schemas.microsoft.com/office/drawing/2014/main" id="{17BFA444-7D13-290D-E3F3-7922E7BFDD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07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Line 229">
              <a:extLst>
                <a:ext uri="{FF2B5EF4-FFF2-40B4-BE49-F238E27FC236}">
                  <a16:creationId xmlns:a16="http://schemas.microsoft.com/office/drawing/2014/main" id="{D0B75B37-F2E7-CB38-CC14-AB984CD961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180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Rectangle 230">
              <a:extLst>
                <a:ext uri="{FF2B5EF4-FFF2-40B4-BE49-F238E27FC236}">
                  <a16:creationId xmlns:a16="http://schemas.microsoft.com/office/drawing/2014/main" id="{3A3F5142-E037-2270-562E-429C051AD7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35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Line 231">
              <a:extLst>
                <a:ext uri="{FF2B5EF4-FFF2-40B4-BE49-F238E27FC236}">
                  <a16:creationId xmlns:a16="http://schemas.microsoft.com/office/drawing/2014/main" id="{96432DAE-BAE9-6669-893C-1061D51CDF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561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Rectangle 232">
              <a:extLst>
                <a:ext uri="{FF2B5EF4-FFF2-40B4-BE49-F238E27FC236}">
                  <a16:creationId xmlns:a16="http://schemas.microsoft.com/office/drawing/2014/main" id="{3C9D0733-793D-5261-4D74-8D5ACF4C15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8675" y="66976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Line 233">
              <a:extLst>
                <a:ext uri="{FF2B5EF4-FFF2-40B4-BE49-F238E27FC236}">
                  <a16:creationId xmlns:a16="http://schemas.microsoft.com/office/drawing/2014/main" id="{3DF1C8C3-12A9-6D1E-C04E-3206CC3B69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990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Rectangle 234">
              <a:extLst>
                <a:ext uri="{FF2B5EF4-FFF2-40B4-BE49-F238E27FC236}">
                  <a16:creationId xmlns:a16="http://schemas.microsoft.com/office/drawing/2014/main" id="{D5DDDFE3-1ED5-959A-D514-A1FD46A145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45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Line 235">
              <a:extLst>
                <a:ext uri="{FF2B5EF4-FFF2-40B4-BE49-F238E27FC236}">
                  <a16:creationId xmlns:a16="http://schemas.microsoft.com/office/drawing/2014/main" id="{5D724939-BF95-3626-D2BC-F94B24CD3D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371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Rectangle 236">
              <a:extLst>
                <a:ext uri="{FF2B5EF4-FFF2-40B4-BE49-F238E27FC236}">
                  <a16:creationId xmlns:a16="http://schemas.microsoft.com/office/drawing/2014/main" id="{0D359C8A-B3AC-60DE-AF31-F968DEB4EA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926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Line 237">
              <a:extLst>
                <a:ext uri="{FF2B5EF4-FFF2-40B4-BE49-F238E27FC236}">
                  <a16:creationId xmlns:a16="http://schemas.microsoft.com/office/drawing/2014/main" id="{5598EC01-877A-692A-333E-3E8EEAEC04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752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Rectangle 238">
              <a:extLst>
                <a:ext uri="{FF2B5EF4-FFF2-40B4-BE49-F238E27FC236}">
                  <a16:creationId xmlns:a16="http://schemas.microsoft.com/office/drawing/2014/main" id="{E9C62DDB-37EC-F66E-900A-9634AE536B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07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Line 239">
              <a:extLst>
                <a:ext uri="{FF2B5EF4-FFF2-40B4-BE49-F238E27FC236}">
                  <a16:creationId xmlns:a16="http://schemas.microsoft.com/office/drawing/2014/main" id="{CA964F4F-1620-701B-A2CE-1C6D0696D2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181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Rectangle 240">
              <a:extLst>
                <a:ext uri="{FF2B5EF4-FFF2-40B4-BE49-F238E27FC236}">
                  <a16:creationId xmlns:a16="http://schemas.microsoft.com/office/drawing/2014/main" id="{AD93EA21-A4EE-940F-5937-A10F669630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36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Line 241">
              <a:extLst>
                <a:ext uri="{FF2B5EF4-FFF2-40B4-BE49-F238E27FC236}">
                  <a16:creationId xmlns:a16="http://schemas.microsoft.com/office/drawing/2014/main" id="{D3B9C35D-D51C-3417-A5AB-BF1F7C0FC4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546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Rectangle 242">
              <a:extLst>
                <a:ext uri="{FF2B5EF4-FFF2-40B4-BE49-F238E27FC236}">
                  <a16:creationId xmlns:a16="http://schemas.microsoft.com/office/drawing/2014/main" id="{F3B12D5C-B33B-D803-EA57-44219792E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17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Line 243">
              <a:extLst>
                <a:ext uri="{FF2B5EF4-FFF2-40B4-BE49-F238E27FC236}">
                  <a16:creationId xmlns:a16="http://schemas.microsoft.com/office/drawing/2014/main" id="{E254FCE9-EE39-FC50-38CB-8570EF8FFF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927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Rectangle 244">
              <a:extLst>
                <a:ext uri="{FF2B5EF4-FFF2-40B4-BE49-F238E27FC236}">
                  <a16:creationId xmlns:a16="http://schemas.microsoft.com/office/drawing/2014/main" id="{7AEA9499-B1D8-7206-CE28-CE04DD2C33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83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Line 245">
              <a:extLst>
                <a:ext uri="{FF2B5EF4-FFF2-40B4-BE49-F238E27FC236}">
                  <a16:creationId xmlns:a16="http://schemas.microsoft.com/office/drawing/2014/main" id="{31EF25AC-1049-710C-6869-62AE5B72A7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56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Rectangle 246">
              <a:extLst>
                <a:ext uri="{FF2B5EF4-FFF2-40B4-BE49-F238E27FC236}">
                  <a16:creationId xmlns:a16="http://schemas.microsoft.com/office/drawing/2014/main" id="{BC234D1F-0434-FB81-919F-A9212A0AFB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27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Line 247">
              <a:extLst>
                <a:ext uri="{FF2B5EF4-FFF2-40B4-BE49-F238E27FC236}">
                  <a16:creationId xmlns:a16="http://schemas.microsoft.com/office/drawing/2014/main" id="{DC4574E3-FF40-A6F3-7834-4B5AA10AAD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737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Rectangle 248">
              <a:extLst>
                <a:ext uri="{FF2B5EF4-FFF2-40B4-BE49-F238E27FC236}">
                  <a16:creationId xmlns:a16="http://schemas.microsoft.com/office/drawing/2014/main" id="{D42367F8-D27D-426C-63DD-176EF16635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292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Line 249">
              <a:extLst>
                <a:ext uri="{FF2B5EF4-FFF2-40B4-BE49-F238E27FC236}">
                  <a16:creationId xmlns:a16="http://schemas.microsoft.com/office/drawing/2014/main" id="{A74ECA99-A82B-D046-F97A-9BA18743CF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118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Rectangle 250">
              <a:extLst>
                <a:ext uri="{FF2B5EF4-FFF2-40B4-BE49-F238E27FC236}">
                  <a16:creationId xmlns:a16="http://schemas.microsoft.com/office/drawing/2014/main" id="{3CCA9E7C-3F61-DB9D-F8EA-8FEFE3A5BC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74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Line 251">
              <a:extLst>
                <a:ext uri="{FF2B5EF4-FFF2-40B4-BE49-F238E27FC236}">
                  <a16:creationId xmlns:a16="http://schemas.microsoft.com/office/drawing/2014/main" id="{5E3026B9-CF3A-F05F-3FC9-572C1BA39B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547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Rectangle 252">
              <a:extLst>
                <a:ext uri="{FF2B5EF4-FFF2-40B4-BE49-F238E27FC236}">
                  <a16:creationId xmlns:a16="http://schemas.microsoft.com/office/drawing/2014/main" id="{4ED06C1E-9584-BC19-812E-7E807AFB21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8850" y="66976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Line 253">
              <a:extLst>
                <a:ext uri="{FF2B5EF4-FFF2-40B4-BE49-F238E27FC236}">
                  <a16:creationId xmlns:a16="http://schemas.microsoft.com/office/drawing/2014/main" id="{49AC3DA1-F8F7-67BB-8E8E-5392792873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928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Rectangle 254">
              <a:extLst>
                <a:ext uri="{FF2B5EF4-FFF2-40B4-BE49-F238E27FC236}">
                  <a16:creationId xmlns:a16="http://schemas.microsoft.com/office/drawing/2014/main" id="{DA67AF45-F67D-D2CC-D564-FB79884A0E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83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Line 255">
              <a:extLst>
                <a:ext uri="{FF2B5EF4-FFF2-40B4-BE49-F238E27FC236}">
                  <a16:creationId xmlns:a16="http://schemas.microsoft.com/office/drawing/2014/main" id="{D84CB3F4-F6FE-44B1-B5F1-D1E0E879F0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57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Rectangle 256">
              <a:extLst>
                <a:ext uri="{FF2B5EF4-FFF2-40B4-BE49-F238E27FC236}">
                  <a16:creationId xmlns:a16="http://schemas.microsoft.com/office/drawing/2014/main" id="{BD254CD5-C868-E14C-F144-2F94B9F477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912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Line 257">
              <a:extLst>
                <a:ext uri="{FF2B5EF4-FFF2-40B4-BE49-F238E27FC236}">
                  <a16:creationId xmlns:a16="http://schemas.microsoft.com/office/drawing/2014/main" id="{63C44265-55C8-78BD-AEAE-EC588BC350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38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Rectangle 258">
              <a:extLst>
                <a:ext uri="{FF2B5EF4-FFF2-40B4-BE49-F238E27FC236}">
                  <a16:creationId xmlns:a16="http://schemas.microsoft.com/office/drawing/2014/main" id="{0B81482E-3FA4-DE11-2465-AA20B80BCE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93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Line 259">
              <a:extLst>
                <a:ext uri="{FF2B5EF4-FFF2-40B4-BE49-F238E27FC236}">
                  <a16:creationId xmlns:a16="http://schemas.microsoft.com/office/drawing/2014/main" id="{9555FE8B-32D3-51FB-3859-A937690630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103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" name="Rectangle 260">
              <a:extLst>
                <a:ext uri="{FF2B5EF4-FFF2-40B4-BE49-F238E27FC236}">
                  <a16:creationId xmlns:a16="http://schemas.microsoft.com/office/drawing/2014/main" id="{E9BD7BC5-5540-B0C1-377E-BA3C2FE047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74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Line 261">
              <a:extLst>
                <a:ext uri="{FF2B5EF4-FFF2-40B4-BE49-F238E27FC236}">
                  <a16:creationId xmlns:a16="http://schemas.microsoft.com/office/drawing/2014/main" id="{3DFE9FDE-DC52-12B3-EE09-C60C402C85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548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Rectangle 262">
              <a:extLst>
                <a:ext uri="{FF2B5EF4-FFF2-40B4-BE49-F238E27FC236}">
                  <a16:creationId xmlns:a16="http://schemas.microsoft.com/office/drawing/2014/main" id="{2C5B40D1-F65A-EF9D-0268-5129C14BF8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103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Line 263">
              <a:extLst>
                <a:ext uri="{FF2B5EF4-FFF2-40B4-BE49-F238E27FC236}">
                  <a16:creationId xmlns:a16="http://schemas.microsoft.com/office/drawing/2014/main" id="{F21F3544-75BC-BE60-ACFE-EBB3A306F5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913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Rectangle 264">
              <a:extLst>
                <a:ext uri="{FF2B5EF4-FFF2-40B4-BE49-F238E27FC236}">
                  <a16:creationId xmlns:a16="http://schemas.microsoft.com/office/drawing/2014/main" id="{9645E106-7C75-4333-A36E-CEDEA106F8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84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Line 265">
              <a:extLst>
                <a:ext uri="{FF2B5EF4-FFF2-40B4-BE49-F238E27FC236}">
                  <a16:creationId xmlns:a16="http://schemas.microsoft.com/office/drawing/2014/main" id="{1011C2DB-D8CB-0630-99AB-B91B80A692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294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Rectangle 266">
              <a:extLst>
                <a:ext uri="{FF2B5EF4-FFF2-40B4-BE49-F238E27FC236}">
                  <a16:creationId xmlns:a16="http://schemas.microsoft.com/office/drawing/2014/main" id="{B297B85B-A855-C4CB-CB97-418472A080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50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Line 267">
              <a:extLst>
                <a:ext uri="{FF2B5EF4-FFF2-40B4-BE49-F238E27FC236}">
                  <a16:creationId xmlns:a16="http://schemas.microsoft.com/office/drawing/2014/main" id="{B533781A-DA7D-EE93-F0A3-4E5B098764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723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" name="Rectangle 268">
              <a:extLst>
                <a:ext uri="{FF2B5EF4-FFF2-40B4-BE49-F238E27FC236}">
                  <a16:creationId xmlns:a16="http://schemas.microsoft.com/office/drawing/2014/main" id="{29063068-CA20-2328-CCF3-ECC073D96B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278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Line 269">
              <a:extLst>
                <a:ext uri="{FF2B5EF4-FFF2-40B4-BE49-F238E27FC236}">
                  <a16:creationId xmlns:a16="http://schemas.microsoft.com/office/drawing/2014/main" id="{3C51EA28-17AF-2798-08E8-B552D14F37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104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Rectangle 270">
              <a:extLst>
                <a:ext uri="{FF2B5EF4-FFF2-40B4-BE49-F238E27FC236}">
                  <a16:creationId xmlns:a16="http://schemas.microsoft.com/office/drawing/2014/main" id="{4FA34243-3A8E-5122-BBB9-021B94E50F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659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Line 271">
              <a:extLst>
                <a:ext uri="{FF2B5EF4-FFF2-40B4-BE49-F238E27FC236}">
                  <a16:creationId xmlns:a16="http://schemas.microsoft.com/office/drawing/2014/main" id="{6E5C2FB5-B2E4-2BA9-F292-2CB0CA8A94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485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Rectangle 272">
              <a:extLst>
                <a:ext uri="{FF2B5EF4-FFF2-40B4-BE49-F238E27FC236}">
                  <a16:creationId xmlns:a16="http://schemas.microsoft.com/office/drawing/2014/main" id="{BF136794-1201-374C-BC11-48AE622BCB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31087" y="66976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Line 273">
              <a:extLst>
                <a:ext uri="{FF2B5EF4-FFF2-40B4-BE49-F238E27FC236}">
                  <a16:creationId xmlns:a16="http://schemas.microsoft.com/office/drawing/2014/main" id="{DC526551-AF98-FF9D-7169-1481597CC9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914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" name="Rectangle 274">
              <a:extLst>
                <a:ext uri="{FF2B5EF4-FFF2-40B4-BE49-F238E27FC236}">
                  <a16:creationId xmlns:a16="http://schemas.microsoft.com/office/drawing/2014/main" id="{DCE2BB26-5DA1-E955-B3F2-42CA0E4093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469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Line 275">
              <a:extLst>
                <a:ext uri="{FF2B5EF4-FFF2-40B4-BE49-F238E27FC236}">
                  <a16:creationId xmlns:a16="http://schemas.microsoft.com/office/drawing/2014/main" id="{2A8D3995-C185-01D5-CA55-C5434D2BFC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295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" name="Rectangle 276">
              <a:extLst>
                <a:ext uri="{FF2B5EF4-FFF2-40B4-BE49-F238E27FC236}">
                  <a16:creationId xmlns:a16="http://schemas.microsoft.com/office/drawing/2014/main" id="{FF9A3A7D-32F4-6C62-E6F1-B9D674DEA4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850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Line 277">
              <a:extLst>
                <a:ext uri="{FF2B5EF4-FFF2-40B4-BE49-F238E27FC236}">
                  <a16:creationId xmlns:a16="http://schemas.microsoft.com/office/drawing/2014/main" id="{0A346DFF-82C0-C317-748D-9867813053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24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Rectangle 278">
              <a:extLst>
                <a:ext uri="{FF2B5EF4-FFF2-40B4-BE49-F238E27FC236}">
                  <a16:creationId xmlns:a16="http://schemas.microsoft.com/office/drawing/2014/main" id="{100B2C1C-A6DD-CE7D-EF5F-FFF5907ED6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279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Line 279">
              <a:extLst>
                <a:ext uri="{FF2B5EF4-FFF2-40B4-BE49-F238E27FC236}">
                  <a16:creationId xmlns:a16="http://schemas.microsoft.com/office/drawing/2014/main" id="{98339F83-F277-BCED-4B9D-EF246BC501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105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Rectangle 280">
              <a:extLst>
                <a:ext uri="{FF2B5EF4-FFF2-40B4-BE49-F238E27FC236}">
                  <a16:creationId xmlns:a16="http://schemas.microsoft.com/office/drawing/2014/main" id="{41DA1675-9C8D-DA3E-8A9E-E1C6DC6DAE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660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Line 281">
              <a:extLst>
                <a:ext uri="{FF2B5EF4-FFF2-40B4-BE49-F238E27FC236}">
                  <a16:creationId xmlns:a16="http://schemas.microsoft.com/office/drawing/2014/main" id="{DCED25DA-BB24-A0C4-65F0-309C7280F7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470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Rectangle 282">
              <a:extLst>
                <a:ext uri="{FF2B5EF4-FFF2-40B4-BE49-F238E27FC236}">
                  <a16:creationId xmlns:a16="http://schemas.microsoft.com/office/drawing/2014/main" id="{90E7F5F0-8BD2-C919-2158-2BD6C16D7B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041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Line 283">
              <a:extLst>
                <a:ext uri="{FF2B5EF4-FFF2-40B4-BE49-F238E27FC236}">
                  <a16:creationId xmlns:a16="http://schemas.microsoft.com/office/drawing/2014/main" id="{2AAF5C29-A6B7-01B3-CE8B-B5EAC05BFC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899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Rectangle 284">
              <a:extLst>
                <a:ext uri="{FF2B5EF4-FFF2-40B4-BE49-F238E27FC236}">
                  <a16:creationId xmlns:a16="http://schemas.microsoft.com/office/drawing/2014/main" id="{412E6765-F67B-ED0C-FC4E-CC57E44102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70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Line 285">
              <a:extLst>
                <a:ext uri="{FF2B5EF4-FFF2-40B4-BE49-F238E27FC236}">
                  <a16:creationId xmlns:a16="http://schemas.microsoft.com/office/drawing/2014/main" id="{E1D60ABC-90EB-3EAD-1F93-52B64ED4F3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280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Rectangle 286">
              <a:extLst>
                <a:ext uri="{FF2B5EF4-FFF2-40B4-BE49-F238E27FC236}">
                  <a16:creationId xmlns:a16="http://schemas.microsoft.com/office/drawing/2014/main" id="{C021BEE5-C96C-AB14-3644-AAA3BC6643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35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Line 287">
              <a:extLst>
                <a:ext uri="{FF2B5EF4-FFF2-40B4-BE49-F238E27FC236}">
                  <a16:creationId xmlns:a16="http://schemas.microsoft.com/office/drawing/2014/main" id="{829FE9F2-1511-31A7-68B5-9D86B20854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661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Rectangle 288">
              <a:extLst>
                <a:ext uri="{FF2B5EF4-FFF2-40B4-BE49-F238E27FC236}">
                  <a16:creationId xmlns:a16="http://schemas.microsoft.com/office/drawing/2014/main" id="{9DC2A8A6-AD3C-D414-8837-A99BDF0D91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17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Line 289">
              <a:extLst>
                <a:ext uri="{FF2B5EF4-FFF2-40B4-BE49-F238E27FC236}">
                  <a16:creationId xmlns:a16="http://schemas.microsoft.com/office/drawing/2014/main" id="{CF06BB28-B917-50FB-A7CB-D7A8F1BBDB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090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Rectangle 290">
              <a:extLst>
                <a:ext uri="{FF2B5EF4-FFF2-40B4-BE49-F238E27FC236}">
                  <a16:creationId xmlns:a16="http://schemas.microsoft.com/office/drawing/2014/main" id="{F7265E99-B274-AA9D-A687-F1AB97C8B9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645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Line 291">
              <a:extLst>
                <a:ext uri="{FF2B5EF4-FFF2-40B4-BE49-F238E27FC236}">
                  <a16:creationId xmlns:a16="http://schemas.microsoft.com/office/drawing/2014/main" id="{8BC4C505-84F4-3FF4-7A76-EA1CC2A195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471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Rectangle 292">
              <a:extLst>
                <a:ext uri="{FF2B5EF4-FFF2-40B4-BE49-F238E27FC236}">
                  <a16:creationId xmlns:a16="http://schemas.microsoft.com/office/drawing/2014/main" id="{76BFA9F8-B547-BDBD-CFDC-65D568E067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29675" y="66976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Line 293">
              <a:extLst>
                <a:ext uri="{FF2B5EF4-FFF2-40B4-BE49-F238E27FC236}">
                  <a16:creationId xmlns:a16="http://schemas.microsoft.com/office/drawing/2014/main" id="{91DA4134-87C2-6FA8-2A9D-E9C68B40AB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900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Rectangle 294">
              <a:extLst>
                <a:ext uri="{FF2B5EF4-FFF2-40B4-BE49-F238E27FC236}">
                  <a16:creationId xmlns:a16="http://schemas.microsoft.com/office/drawing/2014/main" id="{B7F7A5E4-92C9-06DC-3A04-CBA7808683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455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Line 295">
              <a:extLst>
                <a:ext uri="{FF2B5EF4-FFF2-40B4-BE49-F238E27FC236}">
                  <a16:creationId xmlns:a16="http://schemas.microsoft.com/office/drawing/2014/main" id="{47397EA1-CF03-820B-55F4-BC8220079A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281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Rectangle 296">
              <a:extLst>
                <a:ext uri="{FF2B5EF4-FFF2-40B4-BE49-F238E27FC236}">
                  <a16:creationId xmlns:a16="http://schemas.microsoft.com/office/drawing/2014/main" id="{CCC35529-4E8B-EADD-3FE3-D3CA0A75B9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836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Line 297">
              <a:extLst>
                <a:ext uri="{FF2B5EF4-FFF2-40B4-BE49-F238E27FC236}">
                  <a16:creationId xmlns:a16="http://schemas.microsoft.com/office/drawing/2014/main" id="{EBAD79A3-67D0-32FC-728C-21C472C855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2662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Rectangle 298">
              <a:extLst>
                <a:ext uri="{FF2B5EF4-FFF2-40B4-BE49-F238E27FC236}">
                  <a16:creationId xmlns:a16="http://schemas.microsoft.com/office/drawing/2014/main" id="{3F0DA4DC-D6D9-5411-A35C-590206424D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17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Line 299">
              <a:extLst>
                <a:ext uri="{FF2B5EF4-FFF2-40B4-BE49-F238E27FC236}">
                  <a16:creationId xmlns:a16="http://schemas.microsoft.com/office/drawing/2014/main" id="{FA11E52C-DBA5-6BB6-C2FD-4923CAC698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4091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Rectangle 300">
              <a:extLst>
                <a:ext uri="{FF2B5EF4-FFF2-40B4-BE49-F238E27FC236}">
                  <a16:creationId xmlns:a16="http://schemas.microsoft.com/office/drawing/2014/main" id="{BC3B9B6B-E94A-C6DE-7373-6FDBA21210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646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Line 301">
              <a:extLst>
                <a:ext uri="{FF2B5EF4-FFF2-40B4-BE49-F238E27FC236}">
                  <a16:creationId xmlns:a16="http://schemas.microsoft.com/office/drawing/2014/main" id="{BCFAF78B-73F2-C2A2-EE66-692FECD2DA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456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Rectangle 302">
              <a:extLst>
                <a:ext uri="{FF2B5EF4-FFF2-40B4-BE49-F238E27FC236}">
                  <a16:creationId xmlns:a16="http://schemas.microsoft.com/office/drawing/2014/main" id="{D6A7F4BF-5D49-7420-BEAD-4206EB0003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027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Line 303">
              <a:extLst>
                <a:ext uri="{FF2B5EF4-FFF2-40B4-BE49-F238E27FC236}">
                  <a16:creationId xmlns:a16="http://schemas.microsoft.com/office/drawing/2014/main" id="{B4533DD2-C87D-1A8F-F4DA-399ED212ED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837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Rectangle 304">
              <a:extLst>
                <a:ext uri="{FF2B5EF4-FFF2-40B4-BE49-F238E27FC236}">
                  <a16:creationId xmlns:a16="http://schemas.microsoft.com/office/drawing/2014/main" id="{035010EE-0795-0408-D3B5-DABCDD2F34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393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Line 305">
              <a:extLst>
                <a:ext uri="{FF2B5EF4-FFF2-40B4-BE49-F238E27FC236}">
                  <a16:creationId xmlns:a16="http://schemas.microsoft.com/office/drawing/2014/main" id="{BFC45C1A-0A15-DB3E-1901-132BD613E6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266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Rectangle 306">
              <a:extLst>
                <a:ext uri="{FF2B5EF4-FFF2-40B4-BE49-F238E27FC236}">
                  <a16:creationId xmlns:a16="http://schemas.microsoft.com/office/drawing/2014/main" id="{1DB3726B-0689-9347-FFA9-D275030740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837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Line 307">
              <a:extLst>
                <a:ext uri="{FF2B5EF4-FFF2-40B4-BE49-F238E27FC236}">
                  <a16:creationId xmlns:a16="http://schemas.microsoft.com/office/drawing/2014/main" id="{71D2278A-DC08-053E-ED49-7B30F479A3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9647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Rectangle 308">
              <a:extLst>
                <a:ext uri="{FF2B5EF4-FFF2-40B4-BE49-F238E27FC236}">
                  <a16:creationId xmlns:a16="http://schemas.microsoft.com/office/drawing/2014/main" id="{4A0D3FC0-0058-AC8C-B791-DD5D784CC8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202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Line 309">
              <a:extLst>
                <a:ext uri="{FF2B5EF4-FFF2-40B4-BE49-F238E27FC236}">
                  <a16:creationId xmlns:a16="http://schemas.microsoft.com/office/drawing/2014/main" id="{D975AD87-49DE-9ADA-B71D-AB0B8C8B0B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028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Rectangle 310">
              <a:extLst>
                <a:ext uri="{FF2B5EF4-FFF2-40B4-BE49-F238E27FC236}">
                  <a16:creationId xmlns:a16="http://schemas.microsoft.com/office/drawing/2014/main" id="{E077619D-C889-B914-72F9-3C2C0CABE5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584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Line 311">
              <a:extLst>
                <a:ext uri="{FF2B5EF4-FFF2-40B4-BE49-F238E27FC236}">
                  <a16:creationId xmlns:a16="http://schemas.microsoft.com/office/drawing/2014/main" id="{96F063CF-F2C5-F267-8355-ADDB48F5B0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457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Rectangle 312">
              <a:extLst>
                <a:ext uri="{FF2B5EF4-FFF2-40B4-BE49-F238E27FC236}">
                  <a16:creationId xmlns:a16="http://schemas.microsoft.com/office/drawing/2014/main" id="{6F457667-72C2-7CD5-D6C7-666A7D39B0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29850" y="66976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Line 313">
              <a:extLst>
                <a:ext uri="{FF2B5EF4-FFF2-40B4-BE49-F238E27FC236}">
                  <a16:creationId xmlns:a16="http://schemas.microsoft.com/office/drawing/2014/main" id="{903BEED9-DBB6-1077-C1DB-9C33A30230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3838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Rectangle 314">
              <a:extLst>
                <a:ext uri="{FF2B5EF4-FFF2-40B4-BE49-F238E27FC236}">
                  <a16:creationId xmlns:a16="http://schemas.microsoft.com/office/drawing/2014/main" id="{6E2FDC9A-BEF7-959D-EB61-1ED2CB464E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393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Line 315">
              <a:extLst>
                <a:ext uri="{FF2B5EF4-FFF2-40B4-BE49-F238E27FC236}">
                  <a16:creationId xmlns:a16="http://schemas.microsoft.com/office/drawing/2014/main" id="{E3132BFB-884C-837F-2773-4B292DE1E7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267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Rectangle 316">
              <a:extLst>
                <a:ext uri="{FF2B5EF4-FFF2-40B4-BE49-F238E27FC236}">
                  <a16:creationId xmlns:a16="http://schemas.microsoft.com/office/drawing/2014/main" id="{3883B013-3E78-3457-B66D-57E422A1FB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822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Line 317">
              <a:extLst>
                <a:ext uri="{FF2B5EF4-FFF2-40B4-BE49-F238E27FC236}">
                  <a16:creationId xmlns:a16="http://schemas.microsoft.com/office/drawing/2014/main" id="{73A25A40-68FE-8AFD-7813-AF669F2392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648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Rectangle 318">
              <a:extLst>
                <a:ext uri="{FF2B5EF4-FFF2-40B4-BE49-F238E27FC236}">
                  <a16:creationId xmlns:a16="http://schemas.microsoft.com/office/drawing/2014/main" id="{E5C9D5C1-2DE8-D7E6-49C9-56C2347C1E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203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Line 319">
              <a:extLst>
                <a:ext uri="{FF2B5EF4-FFF2-40B4-BE49-F238E27FC236}">
                  <a16:creationId xmlns:a16="http://schemas.microsoft.com/office/drawing/2014/main" id="{0862517E-35F7-F262-369F-4697A475CB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8013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Rectangle 320">
              <a:extLst>
                <a:ext uri="{FF2B5EF4-FFF2-40B4-BE49-F238E27FC236}">
                  <a16:creationId xmlns:a16="http://schemas.microsoft.com/office/drawing/2014/main" id="{0E84DE51-AF9B-F571-3FC8-9185355814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584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Line 321">
              <a:extLst>
                <a:ext uri="{FF2B5EF4-FFF2-40B4-BE49-F238E27FC236}">
                  <a16:creationId xmlns:a16="http://schemas.microsoft.com/office/drawing/2014/main" id="{CB3CE8AC-1826-92D5-BB8C-A029BF673D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45812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Rectangle 322">
              <a:extLst>
                <a:ext uri="{FF2B5EF4-FFF2-40B4-BE49-F238E27FC236}">
                  <a16:creationId xmlns:a16="http://schemas.microsoft.com/office/drawing/2014/main" id="{F469C7BB-2AB1-E0C3-0B4C-1F79C4D1A4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013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Line 323">
              <a:extLst>
                <a:ext uri="{FF2B5EF4-FFF2-40B4-BE49-F238E27FC236}">
                  <a16:creationId xmlns:a16="http://schemas.microsoft.com/office/drawing/2014/main" id="{BBEAF454-4ADF-240D-CFB7-540A99DF74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0823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Rectangle 324">
              <a:extLst>
                <a:ext uri="{FF2B5EF4-FFF2-40B4-BE49-F238E27FC236}">
                  <a16:creationId xmlns:a16="http://schemas.microsoft.com/office/drawing/2014/main" id="{AB14F8D2-FC0C-7600-84E1-9102EC6CB7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394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" name="Line 325">
              <a:extLst>
                <a:ext uri="{FF2B5EF4-FFF2-40B4-BE49-F238E27FC236}">
                  <a16:creationId xmlns:a16="http://schemas.microsoft.com/office/drawing/2014/main" id="{54B8B85D-22E2-55D3-F10B-C31E07C8B9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04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Rectangle 326">
              <a:extLst>
                <a:ext uri="{FF2B5EF4-FFF2-40B4-BE49-F238E27FC236}">
                  <a16:creationId xmlns:a16="http://schemas.microsoft.com/office/drawing/2014/main" id="{4E20280A-1155-F4C2-6255-BEB4C720FF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76000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" name="Line 327">
              <a:extLst>
                <a:ext uri="{FF2B5EF4-FFF2-40B4-BE49-F238E27FC236}">
                  <a16:creationId xmlns:a16="http://schemas.microsoft.com/office/drawing/2014/main" id="{BBBB9882-44F0-2259-E0ED-040C7E2D97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633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9" name="Rectangle 328">
              <a:extLst>
                <a:ext uri="{FF2B5EF4-FFF2-40B4-BE49-F238E27FC236}">
                  <a16:creationId xmlns:a16="http://schemas.microsoft.com/office/drawing/2014/main" id="{617F7BD4-E647-29C4-A0E8-ABD70E685E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20462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" name="Line 329">
              <a:extLst>
                <a:ext uri="{FF2B5EF4-FFF2-40B4-BE49-F238E27FC236}">
                  <a16:creationId xmlns:a16="http://schemas.microsoft.com/office/drawing/2014/main" id="{CFDAF028-7048-C6DD-2D3B-556DF674AD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501437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Rectangle 330">
              <a:extLst>
                <a:ext uri="{FF2B5EF4-FFF2-40B4-BE49-F238E27FC236}">
                  <a16:creationId xmlns:a16="http://schemas.microsoft.com/office/drawing/2014/main" id="{D3DE502A-D911-1883-076A-70D17B692D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56987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Line 331">
              <a:extLst>
                <a:ext uri="{FF2B5EF4-FFF2-40B4-BE49-F238E27FC236}">
                  <a16:creationId xmlns:a16="http://schemas.microsoft.com/office/drawing/2014/main" id="{256BB8E4-6222-82C4-66ED-EA3D1FFAD4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639550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Rectangle 332">
              <a:extLst>
                <a:ext uri="{FF2B5EF4-FFF2-40B4-BE49-F238E27FC236}">
                  <a16:creationId xmlns:a16="http://schemas.microsoft.com/office/drawing/2014/main" id="{F0A8E571-0C03-5D00-D564-1E649EBF8B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622087" y="6697663"/>
              <a:ext cx="66675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Line 333">
              <a:extLst>
                <a:ext uri="{FF2B5EF4-FFF2-40B4-BE49-F238E27FC236}">
                  <a16:creationId xmlns:a16="http://schemas.microsoft.com/office/drawing/2014/main" id="{64B036D7-61E1-A6E4-D11E-0589A89A57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782425" y="6675438"/>
              <a:ext cx="0" cy="22225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" name="Rectangle 334">
              <a:extLst>
                <a:ext uri="{FF2B5EF4-FFF2-40B4-BE49-F238E27FC236}">
                  <a16:creationId xmlns:a16="http://schemas.microsoft.com/office/drawing/2014/main" id="{ABD1BD77-1D1E-4F1A-FD86-5A937D2BC3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37975" y="6697663"/>
              <a:ext cx="120650" cy="936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8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5" name="Rectangle 4">
            <a:extLst>
              <a:ext uri="{FF2B5EF4-FFF2-40B4-BE49-F238E27FC236}">
                <a16:creationId xmlns:a16="http://schemas.microsoft.com/office/drawing/2014/main" id="{892D5D23-3CC7-F6EB-57DF-409B66295065}"/>
              </a:ext>
            </a:extLst>
          </p:cNvPr>
          <p:cNvSpPr/>
          <p:nvPr/>
        </p:nvSpPr>
        <p:spPr>
          <a:xfrm>
            <a:off x="590790" y="26096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" name="Rectangle 38">
            <a:extLst>
              <a:ext uri="{FF2B5EF4-FFF2-40B4-BE49-F238E27FC236}">
                <a16:creationId xmlns:a16="http://schemas.microsoft.com/office/drawing/2014/main" id="{0F2F97BF-1A42-484E-5B44-4D05C483AA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8495" y="27702"/>
            <a:ext cx="189795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.5625 µM standard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2F4B0E3-28BE-4AD9-FD27-0979176AA175}"/>
              </a:ext>
            </a:extLst>
          </p:cNvPr>
          <p:cNvSpPr/>
          <p:nvPr/>
        </p:nvSpPr>
        <p:spPr>
          <a:xfrm>
            <a:off x="554952" y="2238366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id="{CCE8CBF2-8BDC-0B58-6B94-C964EE5EEC83}"/>
              </a:ext>
            </a:extLst>
          </p:cNvPr>
          <p:cNvSpPr/>
          <p:nvPr/>
        </p:nvSpPr>
        <p:spPr>
          <a:xfrm>
            <a:off x="583528" y="4483925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184" name="Rectangle 38">
            <a:extLst>
              <a:ext uri="{FF2B5EF4-FFF2-40B4-BE49-F238E27FC236}">
                <a16:creationId xmlns:a16="http://schemas.microsoft.com/office/drawing/2014/main" id="{55214632-A905-B737-4EA4-16B902A020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6513" y="2254091"/>
            <a:ext cx="132087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VMR-HEM_v1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88" name="Rectangle 38">
            <a:extLst>
              <a:ext uri="{FF2B5EF4-FFF2-40B4-BE49-F238E27FC236}">
                <a16:creationId xmlns:a16="http://schemas.microsoft.com/office/drawing/2014/main" id="{4E6812C6-48E6-C407-A73F-4826B2941A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203" y="4530439"/>
            <a:ext cx="126477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IMPOSSIBLE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90" name="Rectangle 189">
            <a:extLst>
              <a:ext uri="{FF2B5EF4-FFF2-40B4-BE49-F238E27FC236}">
                <a16:creationId xmlns:a16="http://schemas.microsoft.com/office/drawing/2014/main" id="{E13445A4-9B15-F670-E612-10D3D51F1407}"/>
              </a:ext>
            </a:extLst>
          </p:cNvPr>
          <p:cNvSpPr/>
          <p:nvPr/>
        </p:nvSpPr>
        <p:spPr>
          <a:xfrm>
            <a:off x="6470193" y="72768"/>
            <a:ext cx="5490031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191" name="Rectangle 183">
            <a:extLst>
              <a:ext uri="{FF2B5EF4-FFF2-40B4-BE49-F238E27FC236}">
                <a16:creationId xmlns:a16="http://schemas.microsoft.com/office/drawing/2014/main" id="{DCEE8815-E6C0-D15F-C156-98E7A2A16C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61508" y="6852981"/>
            <a:ext cx="24843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Counts vs. Acquisition Time (min)</a:t>
            </a:r>
            <a:endParaRPr kumimoji="0" lang="en-US" altLang="en-US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8E2C6B6D-52FA-3344-E8CD-3DAB23F1900F}"/>
              </a:ext>
            </a:extLst>
          </p:cNvPr>
          <p:cNvSpPr txBox="1"/>
          <p:nvPr/>
        </p:nvSpPr>
        <p:spPr>
          <a:xfrm>
            <a:off x="7599294" y="84868"/>
            <a:ext cx="4289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min extracted ion chromatograms</a:t>
            </a:r>
          </a:p>
          <a:p>
            <a:r>
              <a:rPr lang="en-US" dirty="0"/>
              <a:t>- annotated</a:t>
            </a:r>
          </a:p>
        </p:txBody>
      </p:sp>
    </p:spTree>
    <p:extLst>
      <p:ext uri="{BB962C8B-B14F-4D97-AF65-F5344CB8AC3E}">
        <p14:creationId xmlns:p14="http://schemas.microsoft.com/office/powerpoint/2010/main" val="7239257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DCE7073-E5BA-B91F-645C-238B14C293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6922" y="0"/>
            <a:ext cx="10051676" cy="685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7EFD2D5-C13A-AFB5-53BC-A0EF6E815D4C}"/>
              </a:ext>
            </a:extLst>
          </p:cNvPr>
          <p:cNvSpPr txBox="1"/>
          <p:nvPr/>
        </p:nvSpPr>
        <p:spPr>
          <a:xfrm>
            <a:off x="5040997" y="4513937"/>
            <a:ext cx="18170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[M + H]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, 0.40 pp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ED3C5C-3A75-5B19-D485-3EE7948230D2}"/>
              </a:ext>
            </a:extLst>
          </p:cNvPr>
          <p:cNvSpPr txBox="1"/>
          <p:nvPr/>
        </p:nvSpPr>
        <p:spPr>
          <a:xfrm>
            <a:off x="5040996" y="2300679"/>
            <a:ext cx="18170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[M + H]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, 1.46 pp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6FC9007-C352-50D6-59DD-AF4D91C7F361}"/>
              </a:ext>
            </a:extLst>
          </p:cNvPr>
          <p:cNvSpPr txBox="1"/>
          <p:nvPr/>
        </p:nvSpPr>
        <p:spPr>
          <a:xfrm>
            <a:off x="5040995" y="87421"/>
            <a:ext cx="1817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[M + H]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, 0.70 ppm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ECEDE84-CE11-064C-50EF-0D1952D8D535}"/>
              </a:ext>
            </a:extLst>
          </p:cNvPr>
          <p:cNvSpPr/>
          <p:nvPr/>
        </p:nvSpPr>
        <p:spPr>
          <a:xfrm>
            <a:off x="7473083" y="0"/>
            <a:ext cx="3671995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0689958-0F1F-FED6-F1AC-A30ADC2C4A2C}"/>
              </a:ext>
            </a:extLst>
          </p:cNvPr>
          <p:cNvSpPr/>
          <p:nvPr/>
        </p:nvSpPr>
        <p:spPr>
          <a:xfrm>
            <a:off x="1376285" y="16604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93728BB-B123-1E3F-C043-524CA14E8CAD}"/>
              </a:ext>
            </a:extLst>
          </p:cNvPr>
          <p:cNvSpPr/>
          <p:nvPr/>
        </p:nvSpPr>
        <p:spPr>
          <a:xfrm>
            <a:off x="1382613" y="2244610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B6A77B0-89BA-6219-D414-F827CBD1BE4E}"/>
              </a:ext>
            </a:extLst>
          </p:cNvPr>
          <p:cNvSpPr/>
          <p:nvPr/>
        </p:nvSpPr>
        <p:spPr>
          <a:xfrm>
            <a:off x="1376284" y="4480488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4E8359F4-B783-B214-A324-EA254A89368C}"/>
              </a:ext>
            </a:extLst>
          </p:cNvPr>
          <p:cNvSpPr/>
          <p:nvPr/>
        </p:nvSpPr>
        <p:spPr>
          <a:xfrm>
            <a:off x="5449278" y="6760525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14" name="Rectangle 183">
            <a:extLst>
              <a:ext uri="{FF2B5EF4-FFF2-40B4-BE49-F238E27FC236}">
                <a16:creationId xmlns:a16="http://schemas.microsoft.com/office/drawing/2014/main" id="{25E121F5-2FFA-AD9B-6133-C34DD35DDA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8773" y="6869654"/>
            <a:ext cx="239328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Counts vs. </a:t>
            </a:r>
            <a:r>
              <a:rPr lang="en-US" altLang="en-US" sz="1200" b="1" dirty="0">
                <a:solidFill>
                  <a:srgbClr val="000000"/>
                </a:solidFill>
                <a:latin typeface="Helvetica" pitchFamily="2" charset="0"/>
              </a:rPr>
              <a:t>M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ass-to-Charge (m/z)</a:t>
            </a:r>
            <a:endParaRPr kumimoji="0" lang="en-US" altLang="en-US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5" name="Rectangle 38">
            <a:extLst>
              <a:ext uri="{FF2B5EF4-FFF2-40B4-BE49-F238E27FC236}">
                <a16:creationId xmlns:a16="http://schemas.microsoft.com/office/drawing/2014/main" id="{5B56FF88-0D73-3220-8A1D-BD6DA98368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13070" y="0"/>
            <a:ext cx="189795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.5625 µM standard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6" name="Rectangle 38">
            <a:extLst>
              <a:ext uri="{FF2B5EF4-FFF2-40B4-BE49-F238E27FC236}">
                <a16:creationId xmlns:a16="http://schemas.microsoft.com/office/drawing/2014/main" id="{3B113AC1-CC22-5FBB-4336-0985EA7DD5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1088" y="2226389"/>
            <a:ext cx="132087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VMR-HEM_v1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7" name="Rectangle 38">
            <a:extLst>
              <a:ext uri="{FF2B5EF4-FFF2-40B4-BE49-F238E27FC236}">
                <a16:creationId xmlns:a16="http://schemas.microsoft.com/office/drawing/2014/main" id="{88F8B854-CDC7-AB57-B700-651CBF062F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4778" y="4502737"/>
            <a:ext cx="126477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IMPOSSIBLE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24025A-E2B7-795C-98EE-76CD6E2CA7D5}"/>
              </a:ext>
            </a:extLst>
          </p:cNvPr>
          <p:cNvSpPr txBox="1"/>
          <p:nvPr/>
        </p:nvSpPr>
        <p:spPr>
          <a:xfrm>
            <a:off x="7599294" y="84868"/>
            <a:ext cx="4289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min extracted ion chromatograms</a:t>
            </a:r>
          </a:p>
          <a:p>
            <a:r>
              <a:rPr lang="en-US" dirty="0"/>
              <a:t>- output from software with annotation</a:t>
            </a:r>
          </a:p>
        </p:txBody>
      </p:sp>
    </p:spTree>
    <p:extLst>
      <p:ext uri="{BB962C8B-B14F-4D97-AF65-F5344CB8AC3E}">
        <p14:creationId xmlns:p14="http://schemas.microsoft.com/office/powerpoint/2010/main" val="19044597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24B68094-67A8-3FD4-0A09-81D660CA7C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70553"/>
            <a:ext cx="12192000" cy="511689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F75BE9C-251C-3537-F15A-5203245DEF28}"/>
              </a:ext>
            </a:extLst>
          </p:cNvPr>
          <p:cNvSpPr txBox="1"/>
          <p:nvPr/>
        </p:nvSpPr>
        <p:spPr>
          <a:xfrm>
            <a:off x="1247362" y="4862784"/>
            <a:ext cx="907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614.1814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5FEBECC-FCB1-BB22-60DB-4F7FCB4D5BA5}"/>
              </a:ext>
            </a:extLst>
          </p:cNvPr>
          <p:cNvSpPr txBox="1"/>
          <p:nvPr/>
        </p:nvSpPr>
        <p:spPr>
          <a:xfrm>
            <a:off x="4050197" y="1317827"/>
            <a:ext cx="907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616.1768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B67D9B0-A69D-A020-766F-7513B25DBA43}"/>
              </a:ext>
            </a:extLst>
          </p:cNvPr>
          <p:cNvSpPr txBox="1"/>
          <p:nvPr/>
        </p:nvSpPr>
        <p:spPr>
          <a:xfrm>
            <a:off x="4792819" y="3429000"/>
            <a:ext cx="907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617.1797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854DE36-DFCC-1F36-1175-6E36B9DB72AE}"/>
              </a:ext>
            </a:extLst>
          </p:cNvPr>
          <p:cNvSpPr txBox="1"/>
          <p:nvPr/>
        </p:nvSpPr>
        <p:spPr>
          <a:xfrm>
            <a:off x="5727598" y="4664906"/>
            <a:ext cx="907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618.18235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02ADD3A7-7B7C-43EF-A0B9-3E19C3BCF298}"/>
              </a:ext>
            </a:extLst>
          </p:cNvPr>
          <p:cNvSpPr/>
          <p:nvPr/>
        </p:nvSpPr>
        <p:spPr>
          <a:xfrm>
            <a:off x="4413099" y="5757324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" name="Rectangle 183">
            <a:extLst>
              <a:ext uri="{FF2B5EF4-FFF2-40B4-BE49-F238E27FC236}">
                <a16:creationId xmlns:a16="http://schemas.microsoft.com/office/drawing/2014/main" id="{ECAB0BD0-9346-7A43-BC69-5281F93DC4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2819" y="5755920"/>
            <a:ext cx="239328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Counts vs. </a:t>
            </a:r>
            <a:r>
              <a:rPr lang="en-US" altLang="en-US" sz="1200" b="1" dirty="0">
                <a:solidFill>
                  <a:srgbClr val="000000"/>
                </a:solidFill>
                <a:latin typeface="Helvetica" pitchFamily="2" charset="0"/>
              </a:rPr>
              <a:t>M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ass-to-Charge (m/z)</a:t>
            </a:r>
            <a:endParaRPr kumimoji="0" lang="en-US" altLang="en-US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D2AFC57-DE29-2CB7-25ED-8E40572F1A2A}"/>
              </a:ext>
            </a:extLst>
          </p:cNvPr>
          <p:cNvSpPr/>
          <p:nvPr/>
        </p:nvSpPr>
        <p:spPr>
          <a:xfrm rot="16200000">
            <a:off x="-1483678" y="3277063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7" name="Rectangle 183">
            <a:extLst>
              <a:ext uri="{FF2B5EF4-FFF2-40B4-BE49-F238E27FC236}">
                <a16:creationId xmlns:a16="http://schemas.microsoft.com/office/drawing/2014/main" id="{73ADCD21-538A-087F-8DA7-42939E4467A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664054" y="3255545"/>
            <a:ext cx="168475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Normalized abundance</a:t>
            </a:r>
            <a:endParaRPr kumimoji="0" lang="en-US" altLang="en-US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3C115A5-30BD-2DDE-8338-51E430F6291A}"/>
              </a:ext>
            </a:extLst>
          </p:cNvPr>
          <p:cNvSpPr txBox="1"/>
          <p:nvPr/>
        </p:nvSpPr>
        <p:spPr>
          <a:xfrm>
            <a:off x="7454328" y="1513445"/>
            <a:ext cx="42896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calculated isotope pattern for the heme molecular formula C</a:t>
            </a:r>
            <a:r>
              <a:rPr lang="en-US" sz="1800" baseline="-250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4</a:t>
            </a:r>
            <a:r>
              <a:rPr lang="en-US" sz="18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</a:t>
            </a:r>
            <a:r>
              <a:rPr lang="en-US" sz="1800" baseline="-250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2</a:t>
            </a:r>
            <a:r>
              <a:rPr lang="en-US" sz="18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</a:t>
            </a:r>
            <a:r>
              <a:rPr lang="en-US" sz="1800" baseline="-250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en-US" sz="18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</a:t>
            </a:r>
            <a:r>
              <a:rPr lang="en-US" sz="1800" baseline="-250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en-US" sz="18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e (by the Agilent Technologies Isotope Distribution Calculator software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8162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5</TotalTime>
  <Words>331</Words>
  <Application>Microsoft Macintosh PowerPoint</Application>
  <PresentationFormat>Widescreen</PresentationFormat>
  <Paragraphs>17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Helvetica</vt:lpstr>
      <vt:lpstr>Microsoft Sans Serif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Baidoo</dc:creator>
  <cp:lastModifiedBy>Vayu Maini Rekdal</cp:lastModifiedBy>
  <cp:revision>11</cp:revision>
  <dcterms:created xsi:type="dcterms:W3CDTF">2023-09-05T22:17:42Z</dcterms:created>
  <dcterms:modified xsi:type="dcterms:W3CDTF">2024-02-03T03:06:57Z</dcterms:modified>
</cp:coreProperties>
</file>